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0"/>
  </p:notesMasterIdLst>
  <p:sldIdLst>
    <p:sldId id="259" r:id="rId2"/>
    <p:sldId id="261" r:id="rId3"/>
    <p:sldId id="262" r:id="rId4"/>
    <p:sldId id="263" r:id="rId5"/>
    <p:sldId id="264" r:id="rId6"/>
    <p:sldId id="265" r:id="rId7"/>
    <p:sldId id="266" r:id="rId8"/>
    <p:sldId id="267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AEBC03C-339B-437B-BFAD-AC4CB6ADD593}" v="97" dt="2021-07-01T05:39:21.58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333" autoAdjust="0"/>
    <p:restoredTop sz="86387" autoAdjust="0"/>
  </p:normalViewPr>
  <p:slideViewPr>
    <p:cSldViewPr snapToGrid="0">
      <p:cViewPr varScale="1">
        <p:scale>
          <a:sx n="76" d="100"/>
          <a:sy n="76" d="100"/>
        </p:scale>
        <p:origin x="835" y="48"/>
      </p:cViewPr>
      <p:guideLst/>
    </p:cSldViewPr>
  </p:slideViewPr>
  <p:outlineViewPr>
    <p:cViewPr>
      <p:scale>
        <a:sx n="33" d="100"/>
        <a:sy n="33" d="100"/>
      </p:scale>
      <p:origin x="0" y="0"/>
    </p:cViewPr>
    <p:sldLst>
      <p:sld r:id="rId1" collapse="1"/>
    </p:sldLst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5/10/relationships/revisionInfo" Target="revisionInfo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_rels/viewProps.xml.rels><?xml version="1.0" encoding="UTF-8" standalone="yes"?>
<Relationships xmlns="http://schemas.openxmlformats.org/package/2006/relationships"><Relationship Id="rId1" Type="http://schemas.openxmlformats.org/officeDocument/2006/relationships/slide" Target="slides/slide8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zadeh Dalvand" userId="0e1d96ea38aa11af" providerId="LiveId" clId="{F32794BD-86CD-467F-AE0A-63687E414AD1}"/>
    <pc:docChg chg="undo custSel delSld modSld">
      <pc:chgData name="Azadeh Dalvand" userId="0e1d96ea38aa11af" providerId="LiveId" clId="{F32794BD-86CD-467F-AE0A-63687E414AD1}" dt="2021-03-29T02:06:33.053" v="353" actId="14100"/>
      <pc:docMkLst>
        <pc:docMk/>
      </pc:docMkLst>
      <pc:sldChg chg="addSp delSp modSp mod">
        <pc:chgData name="Azadeh Dalvand" userId="0e1d96ea38aa11af" providerId="LiveId" clId="{F32794BD-86CD-467F-AE0A-63687E414AD1}" dt="2021-03-29T01:29:24.322" v="344" actId="1076"/>
        <pc:sldMkLst>
          <pc:docMk/>
          <pc:sldMk cId="2134516404" sldId="258"/>
        </pc:sldMkLst>
        <pc:spChg chg="del">
          <ac:chgData name="Azadeh Dalvand" userId="0e1d96ea38aa11af" providerId="LiveId" clId="{F32794BD-86CD-467F-AE0A-63687E414AD1}" dt="2021-03-29T00:43:17.913" v="52" actId="478"/>
          <ac:spMkLst>
            <pc:docMk/>
            <pc:sldMk cId="2134516404" sldId="258"/>
            <ac:spMk id="23" creationId="{2C8BC32D-C625-42DB-A5AF-428BDB6058E2}"/>
          </ac:spMkLst>
        </pc:spChg>
        <pc:spChg chg="mod">
          <ac:chgData name="Azadeh Dalvand" userId="0e1d96ea38aa11af" providerId="LiveId" clId="{F32794BD-86CD-467F-AE0A-63687E414AD1}" dt="2021-03-29T01:26:40.872" v="317" actId="14100"/>
          <ac:spMkLst>
            <pc:docMk/>
            <pc:sldMk cId="2134516404" sldId="258"/>
            <ac:spMk id="25" creationId="{54297038-C657-4F82-855A-56AD97DA6691}"/>
          </ac:spMkLst>
        </pc:spChg>
        <pc:spChg chg="del mod">
          <ac:chgData name="Azadeh Dalvand" userId="0e1d96ea38aa11af" providerId="LiveId" clId="{F32794BD-86CD-467F-AE0A-63687E414AD1}" dt="2021-03-29T00:43:06.301" v="48" actId="478"/>
          <ac:spMkLst>
            <pc:docMk/>
            <pc:sldMk cId="2134516404" sldId="258"/>
            <ac:spMk id="27" creationId="{58A4ED93-3CC5-4D67-A027-B0C97632710D}"/>
          </ac:spMkLst>
        </pc:spChg>
        <pc:spChg chg="mod">
          <ac:chgData name="Azadeh Dalvand" userId="0e1d96ea38aa11af" providerId="LiveId" clId="{F32794BD-86CD-467F-AE0A-63687E414AD1}" dt="2021-03-29T01:21:12.578" v="170" actId="20577"/>
          <ac:spMkLst>
            <pc:docMk/>
            <pc:sldMk cId="2134516404" sldId="258"/>
            <ac:spMk id="28" creationId="{03F8B7B1-EF3D-4F7C-A0E5-F6B73A04C41B}"/>
          </ac:spMkLst>
        </pc:spChg>
        <pc:spChg chg="mod">
          <ac:chgData name="Azadeh Dalvand" userId="0e1d96ea38aa11af" providerId="LiveId" clId="{F32794BD-86CD-467F-AE0A-63687E414AD1}" dt="2021-03-29T01:21:29.365" v="199" actId="20577"/>
          <ac:spMkLst>
            <pc:docMk/>
            <pc:sldMk cId="2134516404" sldId="258"/>
            <ac:spMk id="31" creationId="{74270CB3-A49C-41B3-A541-2F658F703FE5}"/>
          </ac:spMkLst>
        </pc:spChg>
        <pc:spChg chg="mod">
          <ac:chgData name="Azadeh Dalvand" userId="0e1d96ea38aa11af" providerId="LiveId" clId="{F32794BD-86CD-467F-AE0A-63687E414AD1}" dt="2021-03-29T00:45:36.741" v="61" actId="14100"/>
          <ac:spMkLst>
            <pc:docMk/>
            <pc:sldMk cId="2134516404" sldId="258"/>
            <ac:spMk id="43" creationId="{38706210-4B3A-4722-81EF-921C65B20EFB}"/>
          </ac:spMkLst>
        </pc:spChg>
        <pc:spChg chg="mod">
          <ac:chgData name="Azadeh Dalvand" userId="0e1d96ea38aa11af" providerId="LiveId" clId="{F32794BD-86CD-467F-AE0A-63687E414AD1}" dt="2021-03-29T00:44:58.489" v="60" actId="14100"/>
          <ac:spMkLst>
            <pc:docMk/>
            <pc:sldMk cId="2134516404" sldId="258"/>
            <ac:spMk id="45" creationId="{CB83F9DE-6299-44B3-AA17-CC0B98870FA9}"/>
          </ac:spMkLst>
        </pc:spChg>
        <pc:spChg chg="add del mod">
          <ac:chgData name="Azadeh Dalvand" userId="0e1d96ea38aa11af" providerId="LiveId" clId="{F32794BD-86CD-467F-AE0A-63687E414AD1}" dt="2021-03-29T01:29:14.151" v="339" actId="478"/>
          <ac:spMkLst>
            <pc:docMk/>
            <pc:sldMk cId="2134516404" sldId="258"/>
            <ac:spMk id="52" creationId="{AE1446A7-5EE4-47C9-88B5-63D0AD9379F6}"/>
          </ac:spMkLst>
        </pc:spChg>
        <pc:spChg chg="mod">
          <ac:chgData name="Azadeh Dalvand" userId="0e1d96ea38aa11af" providerId="LiveId" clId="{F32794BD-86CD-467F-AE0A-63687E414AD1}" dt="2021-03-29T01:22:05.006" v="296" actId="20577"/>
          <ac:spMkLst>
            <pc:docMk/>
            <pc:sldMk cId="2134516404" sldId="258"/>
            <ac:spMk id="54" creationId="{FDE5C7FE-0FD0-4B04-8432-74E650BCD9DF}"/>
          </ac:spMkLst>
        </pc:spChg>
        <pc:spChg chg="mod">
          <ac:chgData name="Azadeh Dalvand" userId="0e1d96ea38aa11af" providerId="LiveId" clId="{F32794BD-86CD-467F-AE0A-63687E414AD1}" dt="2021-03-29T01:21:47.630" v="231" actId="20577"/>
          <ac:spMkLst>
            <pc:docMk/>
            <pc:sldMk cId="2134516404" sldId="258"/>
            <ac:spMk id="55" creationId="{CB1870C8-FEC5-4A8E-A764-40F4E44EDF18}"/>
          </ac:spMkLst>
        </pc:spChg>
        <pc:spChg chg="add del mod">
          <ac:chgData name="Azadeh Dalvand" userId="0e1d96ea38aa11af" providerId="LiveId" clId="{F32794BD-86CD-467F-AE0A-63687E414AD1}" dt="2021-03-29T01:29:21.626" v="343" actId="478"/>
          <ac:spMkLst>
            <pc:docMk/>
            <pc:sldMk cId="2134516404" sldId="258"/>
            <ac:spMk id="62" creationId="{706E8CE7-FCE1-417D-86F6-4F9CCDB86988}"/>
          </ac:spMkLst>
        </pc:spChg>
        <pc:picChg chg="add del mod">
          <ac:chgData name="Azadeh Dalvand" userId="0e1d96ea38aa11af" providerId="LiveId" clId="{F32794BD-86CD-467F-AE0A-63687E414AD1}" dt="2021-03-29T01:29:24.322" v="344" actId="1076"/>
          <ac:picMkLst>
            <pc:docMk/>
            <pc:sldMk cId="2134516404" sldId="258"/>
            <ac:picMk id="4" creationId="{01B45611-CB69-497C-9C9D-5EA37440EB1E}"/>
          </ac:picMkLst>
        </pc:picChg>
        <pc:picChg chg="add del mod">
          <ac:chgData name="Azadeh Dalvand" userId="0e1d96ea38aa11af" providerId="LiveId" clId="{F32794BD-86CD-467F-AE0A-63687E414AD1}" dt="2021-03-29T00:38:16.925" v="12" actId="478"/>
          <ac:picMkLst>
            <pc:docMk/>
            <pc:sldMk cId="2134516404" sldId="258"/>
            <ac:picMk id="4" creationId="{833701C2-732C-4894-952A-56E5AB77CBCF}"/>
          </ac:picMkLst>
        </pc:picChg>
        <pc:picChg chg="add mod">
          <ac:chgData name="Azadeh Dalvand" userId="0e1d96ea38aa11af" providerId="LiveId" clId="{F32794BD-86CD-467F-AE0A-63687E414AD1}" dt="2021-03-29T01:24:30.265" v="305" actId="1076"/>
          <ac:picMkLst>
            <pc:docMk/>
            <pc:sldMk cId="2134516404" sldId="258"/>
            <ac:picMk id="8" creationId="{8D3219DB-DE5C-4870-AB24-4171B4EE78F0}"/>
          </ac:picMkLst>
        </pc:picChg>
        <pc:picChg chg="add del mod">
          <ac:chgData name="Azadeh Dalvand" userId="0e1d96ea38aa11af" providerId="LiveId" clId="{F32794BD-86CD-467F-AE0A-63687E414AD1}" dt="2021-03-29T01:26:27.173" v="313" actId="478"/>
          <ac:picMkLst>
            <pc:docMk/>
            <pc:sldMk cId="2134516404" sldId="258"/>
            <ac:picMk id="9" creationId="{8AA0226A-DEE3-44D2-8539-B1725E9FF5DC}"/>
          </ac:picMkLst>
        </pc:picChg>
        <pc:picChg chg="del mod">
          <ac:chgData name="Azadeh Dalvand" userId="0e1d96ea38aa11af" providerId="LiveId" clId="{F32794BD-86CD-467F-AE0A-63687E414AD1}" dt="2021-03-29T00:38:10.131" v="10" actId="478"/>
          <ac:picMkLst>
            <pc:docMk/>
            <pc:sldMk cId="2134516404" sldId="258"/>
            <ac:picMk id="9" creationId="{A00A46B2-AD25-40FB-9CEB-D1CB6C59CBA1}"/>
          </ac:picMkLst>
        </pc:picChg>
        <pc:picChg chg="add del mod">
          <ac:chgData name="Azadeh Dalvand" userId="0e1d96ea38aa11af" providerId="LiveId" clId="{F32794BD-86CD-467F-AE0A-63687E414AD1}" dt="2021-03-29T01:17:12.576" v="63" actId="478"/>
          <ac:picMkLst>
            <pc:docMk/>
            <pc:sldMk cId="2134516404" sldId="258"/>
            <ac:picMk id="11" creationId="{05D26F82-E9F1-468D-AE34-4868BABF1B8C}"/>
          </ac:picMkLst>
        </pc:picChg>
        <pc:picChg chg="add mod">
          <ac:chgData name="Azadeh Dalvand" userId="0e1d96ea38aa11af" providerId="LiveId" clId="{F32794BD-86CD-467F-AE0A-63687E414AD1}" dt="2021-03-29T01:26:35.226" v="316" actId="14100"/>
          <ac:picMkLst>
            <pc:docMk/>
            <pc:sldMk cId="2134516404" sldId="258"/>
            <ac:picMk id="11" creationId="{BC63C122-839B-4C02-8AC6-F05FDB8D39F7}"/>
          </ac:picMkLst>
        </pc:picChg>
        <pc:picChg chg="add mod">
          <ac:chgData name="Azadeh Dalvand" userId="0e1d96ea38aa11af" providerId="LiveId" clId="{F32794BD-86CD-467F-AE0A-63687E414AD1}" dt="2021-03-29T01:28:43.090" v="330" actId="14100"/>
          <ac:picMkLst>
            <pc:docMk/>
            <pc:sldMk cId="2134516404" sldId="258"/>
            <ac:picMk id="13" creationId="{6D8EAB7E-BDF2-4878-A19D-E37F76FB4E1A}"/>
          </ac:picMkLst>
        </pc:picChg>
        <pc:picChg chg="del mod">
          <ac:chgData name="Azadeh Dalvand" userId="0e1d96ea38aa11af" providerId="LiveId" clId="{F32794BD-86CD-467F-AE0A-63687E414AD1}" dt="2021-03-29T00:39:04.106" v="18" actId="478"/>
          <ac:picMkLst>
            <pc:docMk/>
            <pc:sldMk cId="2134516404" sldId="258"/>
            <ac:picMk id="13" creationId="{BEF079D9-D281-4BF7-8D6F-DC44C19AFFFB}"/>
          </ac:picMkLst>
        </pc:picChg>
        <pc:picChg chg="add del mod">
          <ac:chgData name="Azadeh Dalvand" userId="0e1d96ea38aa11af" providerId="LiveId" clId="{F32794BD-86CD-467F-AE0A-63687E414AD1}" dt="2021-03-29T01:27:51.165" v="319" actId="478"/>
          <ac:picMkLst>
            <pc:docMk/>
            <pc:sldMk cId="2134516404" sldId="258"/>
            <ac:picMk id="14" creationId="{8D9ABC3A-A7F2-4D5A-B2E3-AE2255EA109E}"/>
          </ac:picMkLst>
        </pc:picChg>
        <pc:picChg chg="mod">
          <ac:chgData name="Azadeh Dalvand" userId="0e1d96ea38aa11af" providerId="LiveId" clId="{F32794BD-86CD-467F-AE0A-63687E414AD1}" dt="2021-03-29T00:45:43.985" v="62" actId="1076"/>
          <ac:picMkLst>
            <pc:docMk/>
            <pc:sldMk cId="2134516404" sldId="258"/>
            <ac:picMk id="15" creationId="{43C90B37-1E65-46D4-A7BF-9F4BBABA7722}"/>
          </ac:picMkLst>
        </pc:picChg>
        <pc:picChg chg="add mod">
          <ac:chgData name="Azadeh Dalvand" userId="0e1d96ea38aa11af" providerId="LiveId" clId="{F32794BD-86CD-467F-AE0A-63687E414AD1}" dt="2021-03-29T01:28:59.882" v="334" actId="14100"/>
          <ac:picMkLst>
            <pc:docMk/>
            <pc:sldMk cId="2134516404" sldId="258"/>
            <ac:picMk id="16" creationId="{D16134F5-A6D9-40D8-BA50-C403217EF44A}"/>
          </ac:picMkLst>
        </pc:picChg>
        <pc:picChg chg="add mod">
          <ac:chgData name="Azadeh Dalvand" userId="0e1d96ea38aa11af" providerId="LiveId" clId="{F32794BD-86CD-467F-AE0A-63687E414AD1}" dt="2021-03-29T01:28:37.239" v="329" actId="14100"/>
          <ac:picMkLst>
            <pc:docMk/>
            <pc:sldMk cId="2134516404" sldId="258"/>
            <ac:picMk id="18" creationId="{732AE585-32ED-4766-A6E8-EA10A002C2B1}"/>
          </ac:picMkLst>
        </pc:picChg>
        <pc:picChg chg="add mod">
          <ac:chgData name="Azadeh Dalvand" userId="0e1d96ea38aa11af" providerId="LiveId" clId="{F32794BD-86CD-467F-AE0A-63687E414AD1}" dt="2021-03-29T01:29:10.923" v="338" actId="14100"/>
          <ac:picMkLst>
            <pc:docMk/>
            <pc:sldMk cId="2134516404" sldId="258"/>
            <ac:picMk id="19" creationId="{343B5360-08AD-4126-9BEF-39D02ACD662E}"/>
          </ac:picMkLst>
        </pc:picChg>
        <pc:picChg chg="del mod">
          <ac:chgData name="Azadeh Dalvand" userId="0e1d96ea38aa11af" providerId="LiveId" clId="{F32794BD-86CD-467F-AE0A-63687E414AD1}" dt="2021-03-29T00:39:00.328" v="17" actId="478"/>
          <ac:picMkLst>
            <pc:docMk/>
            <pc:sldMk cId="2134516404" sldId="258"/>
            <ac:picMk id="19" creationId="{9DB8DEDA-6114-40F2-8AD1-C31D9D68A400}"/>
          </ac:picMkLst>
        </pc:picChg>
        <pc:picChg chg="del mod">
          <ac:chgData name="Azadeh Dalvand" userId="0e1d96ea38aa11af" providerId="LiveId" clId="{F32794BD-86CD-467F-AE0A-63687E414AD1}" dt="2021-03-29T00:39:06.326" v="19" actId="478"/>
          <ac:picMkLst>
            <pc:docMk/>
            <pc:sldMk cId="2134516404" sldId="258"/>
            <ac:picMk id="21" creationId="{6C09CC12-BE4E-48E0-AD0D-4662A7DD9FD2}"/>
          </ac:picMkLst>
        </pc:picChg>
        <pc:picChg chg="add del mod">
          <ac:chgData name="Azadeh Dalvand" userId="0e1d96ea38aa11af" providerId="LiveId" clId="{F32794BD-86CD-467F-AE0A-63687E414AD1}" dt="2021-03-29T01:17:14.918" v="64" actId="478"/>
          <ac:picMkLst>
            <pc:docMk/>
            <pc:sldMk cId="2134516404" sldId="258"/>
            <ac:picMk id="29" creationId="{65604383-484F-4DA0-9E0C-072B302DF7A4}"/>
          </ac:picMkLst>
        </pc:picChg>
        <pc:cxnChg chg="del mod">
          <ac:chgData name="Azadeh Dalvand" userId="0e1d96ea38aa11af" providerId="LiveId" clId="{F32794BD-86CD-467F-AE0A-63687E414AD1}" dt="2021-03-29T01:20:51.542" v="117" actId="478"/>
          <ac:cxnSpMkLst>
            <pc:docMk/>
            <pc:sldMk cId="2134516404" sldId="258"/>
            <ac:cxnSpMk id="38" creationId="{2BF94685-E9C1-4D39-B232-2D1972986C06}"/>
          </ac:cxnSpMkLst>
        </pc:cxnChg>
        <pc:cxnChg chg="mod">
          <ac:chgData name="Azadeh Dalvand" userId="0e1d96ea38aa11af" providerId="LiveId" clId="{F32794BD-86CD-467F-AE0A-63687E414AD1}" dt="2021-03-29T01:21:35.697" v="200" actId="1076"/>
          <ac:cxnSpMkLst>
            <pc:docMk/>
            <pc:sldMk cId="2134516404" sldId="258"/>
            <ac:cxnSpMk id="40" creationId="{99703DFE-CB1A-4B7A-8965-7412A95F09ED}"/>
          </ac:cxnSpMkLst>
        </pc:cxnChg>
        <pc:cxnChg chg="add del mod">
          <ac:chgData name="Azadeh Dalvand" userId="0e1d96ea38aa11af" providerId="LiveId" clId="{F32794BD-86CD-467F-AE0A-63687E414AD1}" dt="2021-03-29T01:17:53.299" v="114" actId="478"/>
          <ac:cxnSpMkLst>
            <pc:docMk/>
            <pc:sldMk cId="2134516404" sldId="258"/>
            <ac:cxnSpMk id="60" creationId="{957F6A49-B71F-444E-8957-7B3A04D15ABC}"/>
          </ac:cxnSpMkLst>
        </pc:cxnChg>
        <pc:cxnChg chg="mod">
          <ac:chgData name="Azadeh Dalvand" userId="0e1d96ea38aa11af" providerId="LiveId" clId="{F32794BD-86CD-467F-AE0A-63687E414AD1}" dt="2021-03-29T01:22:14.799" v="299" actId="14100"/>
          <ac:cxnSpMkLst>
            <pc:docMk/>
            <pc:sldMk cId="2134516404" sldId="258"/>
            <ac:cxnSpMk id="61" creationId="{42E66836-4F54-4D00-90FD-578828BB821B}"/>
          </ac:cxnSpMkLst>
        </pc:cxnChg>
      </pc:sldChg>
      <pc:sldChg chg="addSp delSp modSp del mod">
        <pc:chgData name="Azadeh Dalvand" userId="0e1d96ea38aa11af" providerId="LiveId" clId="{F32794BD-86CD-467F-AE0A-63687E414AD1}" dt="2021-03-29T02:06:33.053" v="353" actId="14100"/>
        <pc:sldMkLst>
          <pc:docMk/>
          <pc:sldMk cId="1331139930" sldId="259"/>
        </pc:sldMkLst>
        <pc:graphicFrameChg chg="add del mod">
          <ac:chgData name="Azadeh Dalvand" userId="0e1d96ea38aa11af" providerId="LiveId" clId="{F32794BD-86CD-467F-AE0A-63687E414AD1}" dt="2021-03-29T02:06:24.352" v="350" actId="478"/>
          <ac:graphicFrameMkLst>
            <pc:docMk/>
            <pc:sldMk cId="1331139930" sldId="259"/>
            <ac:graphicFrameMk id="3" creationId="{DD778ED6-C72F-4BE1-876F-9DC35146965C}"/>
          </ac:graphicFrameMkLst>
        </pc:graphicFrameChg>
        <pc:graphicFrameChg chg="add mod">
          <ac:chgData name="Azadeh Dalvand" userId="0e1d96ea38aa11af" providerId="LiveId" clId="{F32794BD-86CD-467F-AE0A-63687E414AD1}" dt="2021-03-29T02:06:33.053" v="353" actId="14100"/>
          <ac:graphicFrameMkLst>
            <pc:docMk/>
            <pc:sldMk cId="1331139930" sldId="259"/>
            <ac:graphicFrameMk id="4" creationId="{4495B591-991B-45FD-88B0-062D439CB0DC}"/>
          </ac:graphicFrameMkLst>
        </pc:graphicFrameChg>
        <pc:picChg chg="del">
          <ac:chgData name="Azadeh Dalvand" userId="0e1d96ea38aa11af" providerId="LiveId" clId="{F32794BD-86CD-467F-AE0A-63687E414AD1}" dt="2021-03-29T02:03:16.660" v="345" actId="478"/>
          <ac:picMkLst>
            <pc:docMk/>
            <pc:sldMk cId="1331139930" sldId="259"/>
            <ac:picMk id="40" creationId="{3321CEA4-FD44-40BF-8CA5-243463DE6AA5}"/>
          </ac:picMkLst>
        </pc:picChg>
      </pc:sldChg>
    </pc:docChg>
  </pc:docChgLst>
  <pc:docChgLst>
    <pc:chgData name="Azadeh Dalvand" userId="0e1d96ea38aa11af" providerId="LiveId" clId="{7AEBC03C-339B-437B-BFAD-AC4CB6ADD593}"/>
    <pc:docChg chg="undo custSel addSld modSld">
      <pc:chgData name="Azadeh Dalvand" userId="0e1d96ea38aa11af" providerId="LiveId" clId="{7AEBC03C-339B-437B-BFAD-AC4CB6ADD593}" dt="2021-07-01T05:41:52.526" v="2571" actId="1076"/>
      <pc:docMkLst>
        <pc:docMk/>
      </pc:docMkLst>
      <pc:sldChg chg="modSp mod">
        <pc:chgData name="Azadeh Dalvand" userId="0e1d96ea38aa11af" providerId="LiveId" clId="{7AEBC03C-339B-437B-BFAD-AC4CB6ADD593}" dt="2021-06-19T02:32:42.906" v="846" actId="1076"/>
        <pc:sldMkLst>
          <pc:docMk/>
          <pc:sldMk cId="2134516404" sldId="258"/>
        </pc:sldMkLst>
        <pc:picChg chg="mod">
          <ac:chgData name="Azadeh Dalvand" userId="0e1d96ea38aa11af" providerId="LiveId" clId="{7AEBC03C-339B-437B-BFAD-AC4CB6ADD593}" dt="2021-06-19T02:32:42.906" v="846" actId="1076"/>
          <ac:picMkLst>
            <pc:docMk/>
            <pc:sldMk cId="2134516404" sldId="258"/>
            <ac:picMk id="15" creationId="{43C90B37-1E65-46D4-A7BF-9F4BBABA7722}"/>
          </ac:picMkLst>
        </pc:picChg>
        <pc:picChg chg="mod">
          <ac:chgData name="Azadeh Dalvand" userId="0e1d96ea38aa11af" providerId="LiveId" clId="{7AEBC03C-339B-437B-BFAD-AC4CB6ADD593}" dt="2021-06-19T02:22:25.161" v="675" actId="1076"/>
          <ac:picMkLst>
            <pc:docMk/>
            <pc:sldMk cId="2134516404" sldId="258"/>
            <ac:picMk id="16" creationId="{D16134F5-A6D9-40D8-BA50-C403217EF44A}"/>
          </ac:picMkLst>
        </pc:picChg>
        <pc:picChg chg="mod">
          <ac:chgData name="Azadeh Dalvand" userId="0e1d96ea38aa11af" providerId="LiveId" clId="{7AEBC03C-339B-437B-BFAD-AC4CB6ADD593}" dt="2021-06-19T02:31:02.157" v="843" actId="1076"/>
          <ac:picMkLst>
            <pc:docMk/>
            <pc:sldMk cId="2134516404" sldId="258"/>
            <ac:picMk id="19" creationId="{343B5360-08AD-4126-9BEF-39D02ACD662E}"/>
          </ac:picMkLst>
        </pc:picChg>
      </pc:sldChg>
      <pc:sldChg chg="addSp delSp modSp new mod">
        <pc:chgData name="Azadeh Dalvand" userId="0e1d96ea38aa11af" providerId="LiveId" clId="{7AEBC03C-339B-437B-BFAD-AC4CB6ADD593}" dt="2021-07-01T05:41:52.526" v="2571" actId="1076"/>
        <pc:sldMkLst>
          <pc:docMk/>
          <pc:sldMk cId="2196489227" sldId="260"/>
        </pc:sldMkLst>
        <pc:spChg chg="add del mod">
          <ac:chgData name="Azadeh Dalvand" userId="0e1d96ea38aa11af" providerId="LiveId" clId="{7AEBC03C-339B-437B-BFAD-AC4CB6ADD593}" dt="2021-06-19T02:21:43.940" v="670" actId="478"/>
          <ac:spMkLst>
            <pc:docMk/>
            <pc:sldMk cId="2196489227" sldId="260"/>
            <ac:spMk id="7" creationId="{D33C7E97-F2A4-4CF5-B479-D15EC452679C}"/>
          </ac:spMkLst>
        </pc:spChg>
        <pc:spChg chg="add del mod">
          <ac:chgData name="Azadeh Dalvand" userId="0e1d96ea38aa11af" providerId="LiveId" clId="{7AEBC03C-339B-437B-BFAD-AC4CB6ADD593}" dt="2021-06-19T02:21:43.940" v="670" actId="478"/>
          <ac:spMkLst>
            <pc:docMk/>
            <pc:sldMk cId="2196489227" sldId="260"/>
            <ac:spMk id="8" creationId="{DF7B47A8-809B-4117-8CF3-FB0D60D1F31C}"/>
          </ac:spMkLst>
        </pc:spChg>
        <pc:spChg chg="add del mod">
          <ac:chgData name="Azadeh Dalvand" userId="0e1d96ea38aa11af" providerId="LiveId" clId="{7AEBC03C-339B-437B-BFAD-AC4CB6ADD593}" dt="2021-06-19T02:21:43.940" v="670" actId="478"/>
          <ac:spMkLst>
            <pc:docMk/>
            <pc:sldMk cId="2196489227" sldId="260"/>
            <ac:spMk id="9" creationId="{C9FBB833-41C3-48F6-9884-3ADCDDF36A90}"/>
          </ac:spMkLst>
        </pc:spChg>
        <pc:spChg chg="add del mod">
          <ac:chgData name="Azadeh Dalvand" userId="0e1d96ea38aa11af" providerId="LiveId" clId="{7AEBC03C-339B-437B-BFAD-AC4CB6ADD593}" dt="2021-06-19T02:21:49.612" v="672" actId="478"/>
          <ac:spMkLst>
            <pc:docMk/>
            <pc:sldMk cId="2196489227" sldId="260"/>
            <ac:spMk id="10" creationId="{6040BF03-A219-4A97-8E32-F3032963C73A}"/>
          </ac:spMkLst>
        </pc:spChg>
        <pc:spChg chg="add del mod">
          <ac:chgData name="Azadeh Dalvand" userId="0e1d96ea38aa11af" providerId="LiveId" clId="{7AEBC03C-339B-437B-BFAD-AC4CB6ADD593}" dt="2021-06-19T02:21:43.940" v="670" actId="478"/>
          <ac:spMkLst>
            <pc:docMk/>
            <pc:sldMk cId="2196489227" sldId="260"/>
            <ac:spMk id="11" creationId="{61F4B0D6-726C-4C54-B1F1-81418AF72750}"/>
          </ac:spMkLst>
        </pc:spChg>
        <pc:spChg chg="add mod">
          <ac:chgData name="Azadeh Dalvand" userId="0e1d96ea38aa11af" providerId="LiveId" clId="{7AEBC03C-339B-437B-BFAD-AC4CB6ADD593}" dt="2021-06-25T05:33:07.603" v="1981" actId="1582"/>
          <ac:spMkLst>
            <pc:docMk/>
            <pc:sldMk cId="2196489227" sldId="260"/>
            <ac:spMk id="14" creationId="{1DA48920-3D2B-4775-B561-1B133DAEEACC}"/>
          </ac:spMkLst>
        </pc:spChg>
        <pc:spChg chg="add del mod">
          <ac:chgData name="Azadeh Dalvand" userId="0e1d96ea38aa11af" providerId="LiveId" clId="{7AEBC03C-339B-437B-BFAD-AC4CB6ADD593}" dt="2021-06-19T02:21:43.940" v="670" actId="478"/>
          <ac:spMkLst>
            <pc:docMk/>
            <pc:sldMk cId="2196489227" sldId="260"/>
            <ac:spMk id="21" creationId="{67932F14-7E54-49AE-ABC8-39DDB841675A}"/>
          </ac:spMkLst>
        </pc:spChg>
        <pc:spChg chg="add del mod">
          <ac:chgData name="Azadeh Dalvand" userId="0e1d96ea38aa11af" providerId="LiveId" clId="{7AEBC03C-339B-437B-BFAD-AC4CB6ADD593}" dt="2021-06-19T02:21:43.940" v="670" actId="478"/>
          <ac:spMkLst>
            <pc:docMk/>
            <pc:sldMk cId="2196489227" sldId="260"/>
            <ac:spMk id="22" creationId="{1D1C42A0-2FB8-42D2-AA31-020C2538E63A}"/>
          </ac:spMkLst>
        </pc:spChg>
        <pc:spChg chg="add del mod">
          <ac:chgData name="Azadeh Dalvand" userId="0e1d96ea38aa11af" providerId="LiveId" clId="{7AEBC03C-339B-437B-BFAD-AC4CB6ADD593}" dt="2021-06-19T02:21:43.940" v="670" actId="478"/>
          <ac:spMkLst>
            <pc:docMk/>
            <pc:sldMk cId="2196489227" sldId="260"/>
            <ac:spMk id="24" creationId="{9A30ADC1-9B9B-4F31-A87F-9EB9DD9EA8FC}"/>
          </ac:spMkLst>
        </pc:spChg>
        <pc:spChg chg="add del mod">
          <ac:chgData name="Azadeh Dalvand" userId="0e1d96ea38aa11af" providerId="LiveId" clId="{7AEBC03C-339B-437B-BFAD-AC4CB6ADD593}" dt="2021-06-25T05:25:43.855" v="1865" actId="478"/>
          <ac:spMkLst>
            <pc:docMk/>
            <pc:sldMk cId="2196489227" sldId="260"/>
            <ac:spMk id="27" creationId="{61976842-F03A-4375-9487-4C74578C359A}"/>
          </ac:spMkLst>
        </pc:spChg>
        <pc:spChg chg="add del mod">
          <ac:chgData name="Azadeh Dalvand" userId="0e1d96ea38aa11af" providerId="LiveId" clId="{7AEBC03C-339B-437B-BFAD-AC4CB6ADD593}" dt="2021-06-25T05:25:43.855" v="1865" actId="478"/>
          <ac:spMkLst>
            <pc:docMk/>
            <pc:sldMk cId="2196489227" sldId="260"/>
            <ac:spMk id="29" creationId="{AFF05189-F743-41CB-BF76-5C978C616CAD}"/>
          </ac:spMkLst>
        </pc:spChg>
        <pc:spChg chg="add del mod">
          <ac:chgData name="Azadeh Dalvand" userId="0e1d96ea38aa11af" providerId="LiveId" clId="{7AEBC03C-339B-437B-BFAD-AC4CB6ADD593}" dt="2021-06-25T05:25:43.855" v="1865" actId="478"/>
          <ac:spMkLst>
            <pc:docMk/>
            <pc:sldMk cId="2196489227" sldId="260"/>
            <ac:spMk id="30" creationId="{5AB6EE9D-9ADC-4719-A4E6-0A6D61FA0CA5}"/>
          </ac:spMkLst>
        </pc:spChg>
        <pc:spChg chg="add mod">
          <ac:chgData name="Azadeh Dalvand" userId="0e1d96ea38aa11af" providerId="LiveId" clId="{7AEBC03C-339B-437B-BFAD-AC4CB6ADD593}" dt="2021-06-23T22:04:14.784" v="1844" actId="1076"/>
          <ac:spMkLst>
            <pc:docMk/>
            <pc:sldMk cId="2196489227" sldId="260"/>
            <ac:spMk id="31" creationId="{02A79DE0-C2AB-45E0-9DDF-19167A510DB5}"/>
          </ac:spMkLst>
        </pc:spChg>
        <pc:spChg chg="add del mod">
          <ac:chgData name="Azadeh Dalvand" userId="0e1d96ea38aa11af" providerId="LiveId" clId="{7AEBC03C-339B-437B-BFAD-AC4CB6ADD593}" dt="2021-06-25T05:25:43.855" v="1865" actId="478"/>
          <ac:spMkLst>
            <pc:docMk/>
            <pc:sldMk cId="2196489227" sldId="260"/>
            <ac:spMk id="32" creationId="{A543C236-31F1-4328-8EB2-66CF3789014C}"/>
          </ac:spMkLst>
        </pc:spChg>
        <pc:spChg chg="add del mod">
          <ac:chgData name="Azadeh Dalvand" userId="0e1d96ea38aa11af" providerId="LiveId" clId="{7AEBC03C-339B-437B-BFAD-AC4CB6ADD593}" dt="2021-06-25T05:25:43.855" v="1865" actId="478"/>
          <ac:spMkLst>
            <pc:docMk/>
            <pc:sldMk cId="2196489227" sldId="260"/>
            <ac:spMk id="33" creationId="{4EEF3DAA-E818-453C-BA1E-A99646F581AC}"/>
          </ac:spMkLst>
        </pc:spChg>
        <pc:spChg chg="add del mod">
          <ac:chgData name="Azadeh Dalvand" userId="0e1d96ea38aa11af" providerId="LiveId" clId="{7AEBC03C-339B-437B-BFAD-AC4CB6ADD593}" dt="2021-06-25T05:25:43.855" v="1865" actId="478"/>
          <ac:spMkLst>
            <pc:docMk/>
            <pc:sldMk cId="2196489227" sldId="260"/>
            <ac:spMk id="34" creationId="{BB398E97-977B-427C-823E-3744DD24AC82}"/>
          </ac:spMkLst>
        </pc:spChg>
        <pc:spChg chg="add del mod">
          <ac:chgData name="Azadeh Dalvand" userId="0e1d96ea38aa11af" providerId="LiveId" clId="{7AEBC03C-339B-437B-BFAD-AC4CB6ADD593}" dt="2021-06-25T05:25:43.855" v="1865" actId="478"/>
          <ac:spMkLst>
            <pc:docMk/>
            <pc:sldMk cId="2196489227" sldId="260"/>
            <ac:spMk id="35" creationId="{EE77796D-56F3-41EA-9FC0-FE61070447DC}"/>
          </ac:spMkLst>
        </pc:spChg>
        <pc:spChg chg="add del mod">
          <ac:chgData name="Azadeh Dalvand" userId="0e1d96ea38aa11af" providerId="LiveId" clId="{7AEBC03C-339B-437B-BFAD-AC4CB6ADD593}" dt="2021-06-25T05:25:43.855" v="1865" actId="478"/>
          <ac:spMkLst>
            <pc:docMk/>
            <pc:sldMk cId="2196489227" sldId="260"/>
            <ac:spMk id="36" creationId="{8709B833-5706-43B7-9AB2-3B933416D511}"/>
          </ac:spMkLst>
        </pc:spChg>
        <pc:spChg chg="add del mod">
          <ac:chgData name="Azadeh Dalvand" userId="0e1d96ea38aa11af" providerId="LiveId" clId="{7AEBC03C-339B-437B-BFAD-AC4CB6ADD593}" dt="2021-06-25T05:25:43.855" v="1865" actId="478"/>
          <ac:spMkLst>
            <pc:docMk/>
            <pc:sldMk cId="2196489227" sldId="260"/>
            <ac:spMk id="37" creationId="{F78D2B6C-C8C2-423D-BCD5-3D6665FDFD33}"/>
          </ac:spMkLst>
        </pc:spChg>
        <pc:spChg chg="add del mod">
          <ac:chgData name="Azadeh Dalvand" userId="0e1d96ea38aa11af" providerId="LiveId" clId="{7AEBC03C-339B-437B-BFAD-AC4CB6ADD593}" dt="2021-06-25T05:25:43.855" v="1865" actId="478"/>
          <ac:spMkLst>
            <pc:docMk/>
            <pc:sldMk cId="2196489227" sldId="260"/>
            <ac:spMk id="38" creationId="{DB78F72C-E17B-4D31-9EB3-3066FA9AD66A}"/>
          </ac:spMkLst>
        </pc:spChg>
        <pc:spChg chg="add del mod">
          <ac:chgData name="Azadeh Dalvand" userId="0e1d96ea38aa11af" providerId="LiveId" clId="{7AEBC03C-339B-437B-BFAD-AC4CB6ADD593}" dt="2021-06-23T22:03:46.720" v="1834" actId="478"/>
          <ac:spMkLst>
            <pc:docMk/>
            <pc:sldMk cId="2196489227" sldId="260"/>
            <ac:spMk id="41" creationId="{2333E2FD-B4F1-49B2-9CE4-288D231CD9C2}"/>
          </ac:spMkLst>
        </pc:spChg>
        <pc:spChg chg="add mod">
          <ac:chgData name="Azadeh Dalvand" userId="0e1d96ea38aa11af" providerId="LiveId" clId="{7AEBC03C-339B-437B-BFAD-AC4CB6ADD593}" dt="2021-06-25T05:37:26.021" v="2196" actId="1076"/>
          <ac:spMkLst>
            <pc:docMk/>
            <pc:sldMk cId="2196489227" sldId="260"/>
            <ac:spMk id="61" creationId="{E6D53151-3278-48A9-A8B0-D3F4CAACAAAD}"/>
          </ac:spMkLst>
        </pc:spChg>
        <pc:spChg chg="add mod">
          <ac:chgData name="Azadeh Dalvand" userId="0e1d96ea38aa11af" providerId="LiveId" clId="{7AEBC03C-339B-437B-BFAD-AC4CB6ADD593}" dt="2021-06-25T05:35:41.564" v="2066" actId="1076"/>
          <ac:spMkLst>
            <pc:docMk/>
            <pc:sldMk cId="2196489227" sldId="260"/>
            <ac:spMk id="64" creationId="{5AB3C9BF-388B-43AE-BA2A-BB355A52024B}"/>
          </ac:spMkLst>
        </pc:spChg>
        <pc:spChg chg="add mod">
          <ac:chgData name="Azadeh Dalvand" userId="0e1d96ea38aa11af" providerId="LiveId" clId="{7AEBC03C-339B-437B-BFAD-AC4CB6ADD593}" dt="2021-06-30T20:36:44.978" v="2372" actId="14100"/>
          <ac:spMkLst>
            <pc:docMk/>
            <pc:sldMk cId="2196489227" sldId="260"/>
            <ac:spMk id="68" creationId="{2FA87025-ED1B-4087-8C88-61C9B53E5300}"/>
          </ac:spMkLst>
        </pc:spChg>
        <pc:spChg chg="add del">
          <ac:chgData name="Azadeh Dalvand" userId="0e1d96ea38aa11af" providerId="LiveId" clId="{7AEBC03C-339B-437B-BFAD-AC4CB6ADD593}" dt="2021-06-19T00:19:17.510" v="506" actId="22"/>
          <ac:spMkLst>
            <pc:docMk/>
            <pc:sldMk cId="2196489227" sldId="260"/>
            <ac:spMk id="81" creationId="{0E49D105-8552-4A0D-984C-530C550CA9BF}"/>
          </ac:spMkLst>
        </pc:spChg>
        <pc:spChg chg="add del mod">
          <ac:chgData name="Azadeh Dalvand" userId="0e1d96ea38aa11af" providerId="LiveId" clId="{7AEBC03C-339B-437B-BFAD-AC4CB6ADD593}" dt="2021-07-01T05:38:56.796" v="2522" actId="478"/>
          <ac:spMkLst>
            <pc:docMk/>
            <pc:sldMk cId="2196489227" sldId="260"/>
            <ac:spMk id="85" creationId="{06B18ED7-820D-4AFA-9FD5-E1F2E96EF165}"/>
          </ac:spMkLst>
        </pc:spChg>
        <pc:spChg chg="add mod">
          <ac:chgData name="Azadeh Dalvand" userId="0e1d96ea38aa11af" providerId="LiveId" clId="{7AEBC03C-339B-437B-BFAD-AC4CB6ADD593}" dt="2021-07-01T05:41:20.032" v="2566" actId="1076"/>
          <ac:spMkLst>
            <pc:docMk/>
            <pc:sldMk cId="2196489227" sldId="260"/>
            <ac:spMk id="86" creationId="{B16FCB16-553F-4522-BF52-FDC9267A5491}"/>
          </ac:spMkLst>
        </pc:spChg>
        <pc:spChg chg="add mod">
          <ac:chgData name="Azadeh Dalvand" userId="0e1d96ea38aa11af" providerId="LiveId" clId="{7AEBC03C-339B-437B-BFAD-AC4CB6ADD593}" dt="2021-06-23T22:04:22.839" v="1845" actId="1076"/>
          <ac:spMkLst>
            <pc:docMk/>
            <pc:sldMk cId="2196489227" sldId="260"/>
            <ac:spMk id="87" creationId="{B4CA0365-97CC-4DB1-AF6E-3E257917716D}"/>
          </ac:spMkLst>
        </pc:spChg>
        <pc:spChg chg="add mod">
          <ac:chgData name="Azadeh Dalvand" userId="0e1d96ea38aa11af" providerId="LiveId" clId="{7AEBC03C-339B-437B-BFAD-AC4CB6ADD593}" dt="2021-07-01T05:41:15.530" v="2565" actId="1076"/>
          <ac:spMkLst>
            <pc:docMk/>
            <pc:sldMk cId="2196489227" sldId="260"/>
            <ac:spMk id="89" creationId="{D9BC3AD4-64EA-4B81-BD22-966B82F4A5D2}"/>
          </ac:spMkLst>
        </pc:spChg>
        <pc:spChg chg="add del mod">
          <ac:chgData name="Azadeh Dalvand" userId="0e1d96ea38aa11af" providerId="LiveId" clId="{7AEBC03C-339B-437B-BFAD-AC4CB6ADD593}" dt="2021-06-19T02:42:53.267" v="977" actId="478"/>
          <ac:spMkLst>
            <pc:docMk/>
            <pc:sldMk cId="2196489227" sldId="260"/>
            <ac:spMk id="90" creationId="{02EA0F34-C205-4A91-97F7-D18AD96CCAF9}"/>
          </ac:spMkLst>
        </pc:spChg>
        <pc:spChg chg="add mod">
          <ac:chgData name="Azadeh Dalvand" userId="0e1d96ea38aa11af" providerId="LiveId" clId="{7AEBC03C-339B-437B-BFAD-AC4CB6ADD593}" dt="2021-07-01T05:41:15.530" v="2565" actId="1076"/>
          <ac:spMkLst>
            <pc:docMk/>
            <pc:sldMk cId="2196489227" sldId="260"/>
            <ac:spMk id="90" creationId="{6CED64C6-FE27-4949-BCF0-05429B13C2BE}"/>
          </ac:spMkLst>
        </pc:spChg>
        <pc:spChg chg="add del mod">
          <ac:chgData name="Azadeh Dalvand" userId="0e1d96ea38aa11af" providerId="LiveId" clId="{7AEBC03C-339B-437B-BFAD-AC4CB6ADD593}" dt="2021-06-19T02:50:20.439" v="1296" actId="478"/>
          <ac:spMkLst>
            <pc:docMk/>
            <pc:sldMk cId="2196489227" sldId="260"/>
            <ac:spMk id="92" creationId="{03A274D7-D6AA-4D7F-A881-928C1D1722EE}"/>
          </ac:spMkLst>
        </pc:spChg>
        <pc:spChg chg="add mod">
          <ac:chgData name="Azadeh Dalvand" userId="0e1d96ea38aa11af" providerId="LiveId" clId="{7AEBC03C-339B-437B-BFAD-AC4CB6ADD593}" dt="2021-06-25T05:33:34.932" v="1987" actId="14100"/>
          <ac:spMkLst>
            <pc:docMk/>
            <pc:sldMk cId="2196489227" sldId="260"/>
            <ac:spMk id="93" creationId="{90C83D75-4A51-4A62-BCB7-97856C6E86DD}"/>
          </ac:spMkLst>
        </pc:spChg>
        <pc:spChg chg="add mod">
          <ac:chgData name="Azadeh Dalvand" userId="0e1d96ea38aa11af" providerId="LiveId" clId="{7AEBC03C-339B-437B-BFAD-AC4CB6ADD593}" dt="2021-06-25T05:34:03.380" v="2011" actId="14100"/>
          <ac:spMkLst>
            <pc:docMk/>
            <pc:sldMk cId="2196489227" sldId="260"/>
            <ac:spMk id="94" creationId="{EE5517D1-100F-43B3-87E0-237CFE3B3FA6}"/>
          </ac:spMkLst>
        </pc:spChg>
        <pc:spChg chg="add mod">
          <ac:chgData name="Azadeh Dalvand" userId="0e1d96ea38aa11af" providerId="LiveId" clId="{7AEBC03C-339B-437B-BFAD-AC4CB6ADD593}" dt="2021-06-23T22:06:12.091" v="1858" actId="1038"/>
          <ac:spMkLst>
            <pc:docMk/>
            <pc:sldMk cId="2196489227" sldId="260"/>
            <ac:spMk id="96" creationId="{D25081A4-CACC-4957-A3CC-6BB5A2BE10BA}"/>
          </ac:spMkLst>
        </pc:spChg>
        <pc:spChg chg="add mod">
          <ac:chgData name="Azadeh Dalvand" userId="0e1d96ea38aa11af" providerId="LiveId" clId="{7AEBC03C-339B-437B-BFAD-AC4CB6ADD593}" dt="2021-07-01T05:41:15.530" v="2565" actId="1076"/>
          <ac:spMkLst>
            <pc:docMk/>
            <pc:sldMk cId="2196489227" sldId="260"/>
            <ac:spMk id="98" creationId="{B33023C2-978D-48BE-8AB9-5D1F7F7CB8AD}"/>
          </ac:spMkLst>
        </pc:spChg>
        <pc:spChg chg="add mod">
          <ac:chgData name="Azadeh Dalvand" userId="0e1d96ea38aa11af" providerId="LiveId" clId="{7AEBC03C-339B-437B-BFAD-AC4CB6ADD593}" dt="2021-06-25T05:37:38.379" v="2200" actId="1076"/>
          <ac:spMkLst>
            <pc:docMk/>
            <pc:sldMk cId="2196489227" sldId="260"/>
            <ac:spMk id="99" creationId="{F395F9C7-8514-41CD-A56F-FA7C2E3FE395}"/>
          </ac:spMkLst>
        </pc:spChg>
        <pc:spChg chg="add mod">
          <ac:chgData name="Azadeh Dalvand" userId="0e1d96ea38aa11af" providerId="LiveId" clId="{7AEBC03C-339B-437B-BFAD-AC4CB6ADD593}" dt="2021-07-01T05:41:15.530" v="2565" actId="1076"/>
          <ac:spMkLst>
            <pc:docMk/>
            <pc:sldMk cId="2196489227" sldId="260"/>
            <ac:spMk id="100" creationId="{8B0C2336-EA28-48D2-BBDE-20E9CB268F37}"/>
          </ac:spMkLst>
        </pc:spChg>
        <pc:spChg chg="add del">
          <ac:chgData name="Azadeh Dalvand" userId="0e1d96ea38aa11af" providerId="LiveId" clId="{7AEBC03C-339B-437B-BFAD-AC4CB6ADD593}" dt="2021-06-19T00:26:49.536" v="607" actId="22"/>
          <ac:spMkLst>
            <pc:docMk/>
            <pc:sldMk cId="2196489227" sldId="260"/>
            <ac:spMk id="101" creationId="{549ED652-49B4-4DAE-B77B-D627ED7896B7}"/>
          </ac:spMkLst>
        </pc:spChg>
        <pc:spChg chg="add mod">
          <ac:chgData name="Azadeh Dalvand" userId="0e1d96ea38aa11af" providerId="LiveId" clId="{7AEBC03C-339B-437B-BFAD-AC4CB6ADD593}" dt="2021-06-25T05:34:19.196" v="2014" actId="14100"/>
          <ac:spMkLst>
            <pc:docMk/>
            <pc:sldMk cId="2196489227" sldId="260"/>
            <ac:spMk id="101" creationId="{ECC30772-A0DD-4D7A-9120-DD8B0A12EA1D}"/>
          </ac:spMkLst>
        </pc:spChg>
        <pc:spChg chg="add mod">
          <ac:chgData name="Azadeh Dalvand" userId="0e1d96ea38aa11af" providerId="LiveId" clId="{7AEBC03C-339B-437B-BFAD-AC4CB6ADD593}" dt="2021-07-01T05:41:24.323" v="2567" actId="1076"/>
          <ac:spMkLst>
            <pc:docMk/>
            <pc:sldMk cId="2196489227" sldId="260"/>
            <ac:spMk id="102" creationId="{8E9F67BC-9021-41F5-AA0B-B0E9C8844DB4}"/>
          </ac:spMkLst>
        </pc:spChg>
        <pc:spChg chg="add mod">
          <ac:chgData name="Azadeh Dalvand" userId="0e1d96ea38aa11af" providerId="LiveId" clId="{7AEBC03C-339B-437B-BFAD-AC4CB6ADD593}" dt="2021-06-30T20:58:24.634" v="2479" actId="14100"/>
          <ac:spMkLst>
            <pc:docMk/>
            <pc:sldMk cId="2196489227" sldId="260"/>
            <ac:spMk id="103" creationId="{0C93CFE9-0372-4378-B040-8B3A4787DE0D}"/>
          </ac:spMkLst>
        </pc:spChg>
        <pc:spChg chg="add mod">
          <ac:chgData name="Azadeh Dalvand" userId="0e1d96ea38aa11af" providerId="LiveId" clId="{7AEBC03C-339B-437B-BFAD-AC4CB6ADD593}" dt="2021-06-23T22:05:05.095" v="1852" actId="1076"/>
          <ac:spMkLst>
            <pc:docMk/>
            <pc:sldMk cId="2196489227" sldId="260"/>
            <ac:spMk id="105" creationId="{5C7E6543-10B4-457F-8F97-42C6D455EF0F}"/>
          </ac:spMkLst>
        </pc:spChg>
        <pc:spChg chg="add mod">
          <ac:chgData name="Azadeh Dalvand" userId="0e1d96ea38aa11af" providerId="LiveId" clId="{7AEBC03C-339B-437B-BFAD-AC4CB6ADD593}" dt="2021-06-25T05:35:01.055" v="2057" actId="1076"/>
          <ac:spMkLst>
            <pc:docMk/>
            <pc:sldMk cId="2196489227" sldId="260"/>
            <ac:spMk id="106" creationId="{2F473DAE-2BC2-4E70-A256-D58EEA200E0B}"/>
          </ac:spMkLst>
        </pc:spChg>
        <pc:spChg chg="add mod">
          <ac:chgData name="Azadeh Dalvand" userId="0e1d96ea38aa11af" providerId="LiveId" clId="{7AEBC03C-339B-437B-BFAD-AC4CB6ADD593}" dt="2021-06-30T20:24:49.896" v="2288" actId="1076"/>
          <ac:spMkLst>
            <pc:docMk/>
            <pc:sldMk cId="2196489227" sldId="260"/>
            <ac:spMk id="107" creationId="{FDC1F4F7-4837-46ED-A3F7-AD1A6DCBE497}"/>
          </ac:spMkLst>
        </pc:spChg>
        <pc:spChg chg="add mod">
          <ac:chgData name="Azadeh Dalvand" userId="0e1d96ea38aa11af" providerId="LiveId" clId="{7AEBC03C-339B-437B-BFAD-AC4CB6ADD593}" dt="2021-06-25T05:35:31.057" v="2065" actId="14100"/>
          <ac:spMkLst>
            <pc:docMk/>
            <pc:sldMk cId="2196489227" sldId="260"/>
            <ac:spMk id="108" creationId="{D97B3AFA-C0E8-4D82-834D-818B281E4999}"/>
          </ac:spMkLst>
        </pc:spChg>
        <pc:spChg chg="add mod">
          <ac:chgData name="Azadeh Dalvand" userId="0e1d96ea38aa11af" providerId="LiveId" clId="{7AEBC03C-339B-437B-BFAD-AC4CB6ADD593}" dt="2021-06-30T20:24:45.603" v="2287" actId="1076"/>
          <ac:spMkLst>
            <pc:docMk/>
            <pc:sldMk cId="2196489227" sldId="260"/>
            <ac:spMk id="109" creationId="{64219B35-307C-402F-B413-8700C6561402}"/>
          </ac:spMkLst>
        </pc:spChg>
        <pc:spChg chg="add mod">
          <ac:chgData name="Azadeh Dalvand" userId="0e1d96ea38aa11af" providerId="LiveId" clId="{7AEBC03C-339B-437B-BFAD-AC4CB6ADD593}" dt="2021-06-25T05:36:21.512" v="2184" actId="1076"/>
          <ac:spMkLst>
            <pc:docMk/>
            <pc:sldMk cId="2196489227" sldId="260"/>
            <ac:spMk id="110" creationId="{0FC9D901-791A-49ED-8818-6DC23A1DDC94}"/>
          </ac:spMkLst>
        </pc:spChg>
        <pc:spChg chg="add mod">
          <ac:chgData name="Azadeh Dalvand" userId="0e1d96ea38aa11af" providerId="LiveId" clId="{7AEBC03C-339B-437B-BFAD-AC4CB6ADD593}" dt="2021-06-30T20:24:35.813" v="2284" actId="1076"/>
          <ac:spMkLst>
            <pc:docMk/>
            <pc:sldMk cId="2196489227" sldId="260"/>
            <ac:spMk id="111" creationId="{B7DF5819-C264-40F6-ADF0-4FF0F959BF22}"/>
          </ac:spMkLst>
        </pc:spChg>
        <pc:spChg chg="add mod">
          <ac:chgData name="Azadeh Dalvand" userId="0e1d96ea38aa11af" providerId="LiveId" clId="{7AEBC03C-339B-437B-BFAD-AC4CB6ADD593}" dt="2021-07-01T05:41:32.737" v="2568" actId="1076"/>
          <ac:spMkLst>
            <pc:docMk/>
            <pc:sldMk cId="2196489227" sldId="260"/>
            <ac:spMk id="112" creationId="{86DF70BE-3242-4C16-8B21-DA68EBDAAB7E}"/>
          </ac:spMkLst>
        </pc:spChg>
        <pc:spChg chg="add mod">
          <ac:chgData name="Azadeh Dalvand" userId="0e1d96ea38aa11af" providerId="LiveId" clId="{7AEBC03C-339B-437B-BFAD-AC4CB6ADD593}" dt="2021-06-30T20:24:13.589" v="2280" actId="1076"/>
          <ac:spMkLst>
            <pc:docMk/>
            <pc:sldMk cId="2196489227" sldId="260"/>
            <ac:spMk id="113" creationId="{AF5FEE97-731E-4FF6-8DB3-4CC6DDA28395}"/>
          </ac:spMkLst>
        </pc:spChg>
        <pc:spChg chg="add mod">
          <ac:chgData name="Azadeh Dalvand" userId="0e1d96ea38aa11af" providerId="LiveId" clId="{7AEBC03C-339B-437B-BFAD-AC4CB6ADD593}" dt="2021-06-30T20:24:17.406" v="2281" actId="1076"/>
          <ac:spMkLst>
            <pc:docMk/>
            <pc:sldMk cId="2196489227" sldId="260"/>
            <ac:spMk id="115" creationId="{4646349B-CC76-4849-8E4B-52998F204FE5}"/>
          </ac:spMkLst>
        </pc:spChg>
        <pc:spChg chg="add mod">
          <ac:chgData name="Azadeh Dalvand" userId="0e1d96ea38aa11af" providerId="LiveId" clId="{7AEBC03C-339B-437B-BFAD-AC4CB6ADD593}" dt="2021-06-25T05:37:49.453" v="2202" actId="1076"/>
          <ac:spMkLst>
            <pc:docMk/>
            <pc:sldMk cId="2196489227" sldId="260"/>
            <ac:spMk id="116" creationId="{47B92C7A-EBAE-4D56-AEDD-B70DC77EBBFF}"/>
          </ac:spMkLst>
        </pc:spChg>
        <pc:spChg chg="add mod">
          <ac:chgData name="Azadeh Dalvand" userId="0e1d96ea38aa11af" providerId="LiveId" clId="{7AEBC03C-339B-437B-BFAD-AC4CB6ADD593}" dt="2021-06-30T20:36:35.831" v="2370" actId="1036"/>
          <ac:spMkLst>
            <pc:docMk/>
            <pc:sldMk cId="2196489227" sldId="260"/>
            <ac:spMk id="118" creationId="{C872C467-E6A1-4701-B178-E0A4D055397A}"/>
          </ac:spMkLst>
        </pc:spChg>
        <pc:spChg chg="add mod">
          <ac:chgData name="Azadeh Dalvand" userId="0e1d96ea38aa11af" providerId="LiveId" clId="{7AEBC03C-339B-437B-BFAD-AC4CB6ADD593}" dt="2021-06-30T20:37:01.075" v="2377" actId="14100"/>
          <ac:spMkLst>
            <pc:docMk/>
            <pc:sldMk cId="2196489227" sldId="260"/>
            <ac:spMk id="119" creationId="{1E6A9C40-3E29-418E-9859-B0E5ABE1EC02}"/>
          </ac:spMkLst>
        </pc:spChg>
        <pc:spChg chg="add mod">
          <ac:chgData name="Azadeh Dalvand" userId="0e1d96ea38aa11af" providerId="LiveId" clId="{7AEBC03C-339B-437B-BFAD-AC4CB6ADD593}" dt="2021-06-30T20:37:26.426" v="2381" actId="1038"/>
          <ac:spMkLst>
            <pc:docMk/>
            <pc:sldMk cId="2196489227" sldId="260"/>
            <ac:spMk id="120" creationId="{D519CC3F-9678-4128-ADA3-DC007B583663}"/>
          </ac:spMkLst>
        </pc:spChg>
        <pc:spChg chg="add mod">
          <ac:chgData name="Azadeh Dalvand" userId="0e1d96ea38aa11af" providerId="LiveId" clId="{7AEBC03C-339B-437B-BFAD-AC4CB6ADD593}" dt="2021-06-30T21:00:53.048" v="2481" actId="14100"/>
          <ac:spMkLst>
            <pc:docMk/>
            <pc:sldMk cId="2196489227" sldId="260"/>
            <ac:spMk id="121" creationId="{07070B4F-586C-463F-8631-CFC09539B810}"/>
          </ac:spMkLst>
        </pc:spChg>
        <pc:spChg chg="add mod">
          <ac:chgData name="Azadeh Dalvand" userId="0e1d96ea38aa11af" providerId="LiveId" clId="{7AEBC03C-339B-437B-BFAD-AC4CB6ADD593}" dt="2021-06-25T05:37:00.588" v="2190" actId="1076"/>
          <ac:spMkLst>
            <pc:docMk/>
            <pc:sldMk cId="2196489227" sldId="260"/>
            <ac:spMk id="122" creationId="{4BF7CE87-B155-40B6-9FAB-5837F4BB9C02}"/>
          </ac:spMkLst>
        </pc:spChg>
        <pc:spChg chg="add mod">
          <ac:chgData name="Azadeh Dalvand" userId="0e1d96ea38aa11af" providerId="LiveId" clId="{7AEBC03C-339B-437B-BFAD-AC4CB6ADD593}" dt="2021-06-25T05:36:38.019" v="2188" actId="1076"/>
          <ac:spMkLst>
            <pc:docMk/>
            <pc:sldMk cId="2196489227" sldId="260"/>
            <ac:spMk id="123" creationId="{7BF2DC82-FFCC-49D3-A758-67C430228404}"/>
          </ac:spMkLst>
        </pc:spChg>
        <pc:spChg chg="add mod">
          <ac:chgData name="Azadeh Dalvand" userId="0e1d96ea38aa11af" providerId="LiveId" clId="{7AEBC03C-339B-437B-BFAD-AC4CB6ADD593}" dt="2021-06-25T05:36:30.185" v="2186" actId="1076"/>
          <ac:spMkLst>
            <pc:docMk/>
            <pc:sldMk cId="2196489227" sldId="260"/>
            <ac:spMk id="124" creationId="{636137DA-5099-4009-A066-1171E427DA89}"/>
          </ac:spMkLst>
        </pc:spChg>
        <pc:spChg chg="add mod">
          <ac:chgData name="Azadeh Dalvand" userId="0e1d96ea38aa11af" providerId="LiveId" clId="{7AEBC03C-339B-437B-BFAD-AC4CB6ADD593}" dt="2021-06-25T05:35:53.765" v="2069" actId="1076"/>
          <ac:spMkLst>
            <pc:docMk/>
            <pc:sldMk cId="2196489227" sldId="260"/>
            <ac:spMk id="125" creationId="{45AAD66E-7301-4A85-85A2-AB2C912646D1}"/>
          </ac:spMkLst>
        </pc:spChg>
        <pc:spChg chg="add mod">
          <ac:chgData name="Azadeh Dalvand" userId="0e1d96ea38aa11af" providerId="LiveId" clId="{7AEBC03C-339B-437B-BFAD-AC4CB6ADD593}" dt="2021-06-30T21:00:59.137" v="2482" actId="14100"/>
          <ac:spMkLst>
            <pc:docMk/>
            <pc:sldMk cId="2196489227" sldId="260"/>
            <ac:spMk id="126" creationId="{FC413803-4993-4935-B83C-2E95C2CF649A}"/>
          </ac:spMkLst>
        </pc:spChg>
        <pc:spChg chg="add mod">
          <ac:chgData name="Azadeh Dalvand" userId="0e1d96ea38aa11af" providerId="LiveId" clId="{7AEBC03C-339B-437B-BFAD-AC4CB6ADD593}" dt="2021-06-30T21:01:04.444" v="2483" actId="14100"/>
          <ac:spMkLst>
            <pc:docMk/>
            <pc:sldMk cId="2196489227" sldId="260"/>
            <ac:spMk id="127" creationId="{F3E61F08-6943-4FC1-9F22-251DAA8CC3C8}"/>
          </ac:spMkLst>
        </pc:spChg>
        <pc:spChg chg="add del mod">
          <ac:chgData name="Azadeh Dalvand" userId="0e1d96ea38aa11af" providerId="LiveId" clId="{7AEBC03C-339B-437B-BFAD-AC4CB6ADD593}" dt="2021-06-30T20:38:24.779" v="2395" actId="478"/>
          <ac:spMkLst>
            <pc:docMk/>
            <pc:sldMk cId="2196489227" sldId="260"/>
            <ac:spMk id="128" creationId="{9FE7A998-230C-4BE4-948B-7B707D345D65}"/>
          </ac:spMkLst>
        </pc:spChg>
        <pc:spChg chg="add mod">
          <ac:chgData name="Azadeh Dalvand" userId="0e1d96ea38aa11af" providerId="LiveId" clId="{7AEBC03C-339B-437B-BFAD-AC4CB6ADD593}" dt="2021-06-30T20:38:51.083" v="2439" actId="14100"/>
          <ac:spMkLst>
            <pc:docMk/>
            <pc:sldMk cId="2196489227" sldId="260"/>
            <ac:spMk id="129" creationId="{BD213C5E-6654-4B7A-81A7-584E43DEB286}"/>
          </ac:spMkLst>
        </pc:spChg>
        <pc:spChg chg="add mod">
          <ac:chgData name="Azadeh Dalvand" userId="0e1d96ea38aa11af" providerId="LiveId" clId="{7AEBC03C-339B-437B-BFAD-AC4CB6ADD593}" dt="2021-07-01T05:41:40.534" v="2569" actId="1076"/>
          <ac:spMkLst>
            <pc:docMk/>
            <pc:sldMk cId="2196489227" sldId="260"/>
            <ac:spMk id="130" creationId="{748B251D-6169-4B62-82C6-FE1E76781C49}"/>
          </ac:spMkLst>
        </pc:spChg>
        <pc:picChg chg="add del">
          <ac:chgData name="Azadeh Dalvand" userId="0e1d96ea38aa11af" providerId="LiveId" clId="{7AEBC03C-339B-437B-BFAD-AC4CB6ADD593}" dt="2021-06-18T23:49:53.713" v="2"/>
          <ac:picMkLst>
            <pc:docMk/>
            <pc:sldMk cId="2196489227" sldId="260"/>
            <ac:picMk id="2" creationId="{CBB17C05-2EEA-4D62-B731-6FA4EFDF9085}"/>
          </ac:picMkLst>
        </pc:picChg>
        <pc:picChg chg="add del mod">
          <ac:chgData name="Azadeh Dalvand" userId="0e1d96ea38aa11af" providerId="LiveId" clId="{7AEBC03C-339B-437B-BFAD-AC4CB6ADD593}" dt="2021-06-19T02:24:06.072" v="686" actId="478"/>
          <ac:picMkLst>
            <pc:docMk/>
            <pc:sldMk cId="2196489227" sldId="260"/>
            <ac:picMk id="3" creationId="{20F6546B-1119-40E8-8A01-3480F63F60DB}"/>
          </ac:picMkLst>
        </pc:picChg>
        <pc:picChg chg="add mod">
          <ac:chgData name="Azadeh Dalvand" userId="0e1d96ea38aa11af" providerId="LiveId" clId="{7AEBC03C-339B-437B-BFAD-AC4CB6ADD593}" dt="2021-06-25T05:30:48.488" v="1897" actId="1076"/>
          <ac:picMkLst>
            <pc:docMk/>
            <pc:sldMk cId="2196489227" sldId="260"/>
            <ac:picMk id="3" creationId="{450B8DD6-8EB7-47AE-B02D-4B918A634F9C}"/>
          </ac:picMkLst>
        </pc:picChg>
        <pc:picChg chg="add del">
          <ac:chgData name="Azadeh Dalvand" userId="0e1d96ea38aa11af" providerId="LiveId" clId="{7AEBC03C-339B-437B-BFAD-AC4CB6ADD593}" dt="2021-06-18T23:50:14.168" v="4"/>
          <ac:picMkLst>
            <pc:docMk/>
            <pc:sldMk cId="2196489227" sldId="260"/>
            <ac:picMk id="3" creationId="{C2938FEF-B9EB-4779-949E-02E33ED9F1CA}"/>
          </ac:picMkLst>
        </pc:picChg>
        <pc:picChg chg="add del mod">
          <ac:chgData name="Azadeh Dalvand" userId="0e1d96ea38aa11af" providerId="LiveId" clId="{7AEBC03C-339B-437B-BFAD-AC4CB6ADD593}" dt="2021-06-18T23:50:20.340" v="8"/>
          <ac:picMkLst>
            <pc:docMk/>
            <pc:sldMk cId="2196489227" sldId="260"/>
            <ac:picMk id="4" creationId="{5358E780-8672-4C97-AEB4-89357DBE1550}"/>
          </ac:picMkLst>
        </pc:picChg>
        <pc:picChg chg="add del mod">
          <ac:chgData name="Azadeh Dalvand" userId="0e1d96ea38aa11af" providerId="LiveId" clId="{7AEBC03C-339B-437B-BFAD-AC4CB6ADD593}" dt="2021-07-01T05:39:34.272" v="2530" actId="478"/>
          <ac:picMkLst>
            <pc:docMk/>
            <pc:sldMk cId="2196489227" sldId="260"/>
            <ac:picMk id="4" creationId="{C43BE017-FF04-4EEB-8855-57B4FA1ED262}"/>
          </ac:picMkLst>
        </pc:picChg>
        <pc:picChg chg="add del mod">
          <ac:chgData name="Azadeh Dalvand" userId="0e1d96ea38aa11af" providerId="LiveId" clId="{7AEBC03C-339B-437B-BFAD-AC4CB6ADD593}" dt="2021-06-30T20:33:34.424" v="2338" actId="478"/>
          <ac:picMkLst>
            <pc:docMk/>
            <pc:sldMk cId="2196489227" sldId="260"/>
            <ac:picMk id="4" creationId="{EFEA7777-D135-4858-996E-50E97FB4E31F}"/>
          </ac:picMkLst>
        </pc:picChg>
        <pc:picChg chg="add mod">
          <ac:chgData name="Azadeh Dalvand" userId="0e1d96ea38aa11af" providerId="LiveId" clId="{7AEBC03C-339B-437B-BFAD-AC4CB6ADD593}" dt="2021-06-25T05:30:41.416" v="1896" actId="1038"/>
          <ac:picMkLst>
            <pc:docMk/>
            <pc:sldMk cId="2196489227" sldId="260"/>
            <ac:picMk id="5" creationId="{0917BE7B-162D-4EF8-AA54-FF84F4EF9A24}"/>
          </ac:picMkLst>
        </pc:picChg>
        <pc:picChg chg="add del mod">
          <ac:chgData name="Azadeh Dalvand" userId="0e1d96ea38aa11af" providerId="LiveId" clId="{7AEBC03C-339B-437B-BFAD-AC4CB6ADD593}" dt="2021-06-19T02:21:43.940" v="670" actId="478"/>
          <ac:picMkLst>
            <pc:docMk/>
            <pc:sldMk cId="2196489227" sldId="260"/>
            <ac:picMk id="5" creationId="{D0D378AD-A188-469C-89E8-031ADE2BF244}"/>
          </ac:picMkLst>
        </pc:picChg>
        <pc:picChg chg="add del mod">
          <ac:chgData name="Azadeh Dalvand" userId="0e1d96ea38aa11af" providerId="LiveId" clId="{7AEBC03C-339B-437B-BFAD-AC4CB6ADD593}" dt="2021-06-30T19:52:51.487" v="2217" actId="478"/>
          <ac:picMkLst>
            <pc:docMk/>
            <pc:sldMk cId="2196489227" sldId="260"/>
            <ac:picMk id="6" creationId="{185E4B7C-DA5D-435B-AD3D-33A0601FFD54}"/>
          </ac:picMkLst>
        </pc:picChg>
        <pc:picChg chg="add del mod">
          <ac:chgData name="Azadeh Dalvand" userId="0e1d96ea38aa11af" providerId="LiveId" clId="{7AEBC03C-339B-437B-BFAD-AC4CB6ADD593}" dt="2021-06-19T02:21:43.940" v="670" actId="478"/>
          <ac:picMkLst>
            <pc:docMk/>
            <pc:sldMk cId="2196489227" sldId="260"/>
            <ac:picMk id="6" creationId="{FA209B3F-2816-4F32-AD14-BC181D8E1499}"/>
          </ac:picMkLst>
        </pc:picChg>
        <pc:picChg chg="add mod">
          <ac:chgData name="Azadeh Dalvand" userId="0e1d96ea38aa11af" providerId="LiveId" clId="{7AEBC03C-339B-437B-BFAD-AC4CB6ADD593}" dt="2021-06-25T05:33:22.064" v="1985" actId="1036"/>
          <ac:picMkLst>
            <pc:docMk/>
            <pc:sldMk cId="2196489227" sldId="260"/>
            <ac:picMk id="7" creationId="{E9D28643-3DD7-491B-8F5C-D258187B2D1B}"/>
          </ac:picMkLst>
        </pc:picChg>
        <pc:picChg chg="add mod">
          <ac:chgData name="Azadeh Dalvand" userId="0e1d96ea38aa11af" providerId="LiveId" clId="{7AEBC03C-339B-437B-BFAD-AC4CB6ADD593}" dt="2021-06-25T05:34:52.049" v="2056" actId="1036"/>
          <ac:picMkLst>
            <pc:docMk/>
            <pc:sldMk cId="2196489227" sldId="260"/>
            <ac:picMk id="9" creationId="{CF4E2001-D5CB-4EE4-8381-CCE4C505C070}"/>
          </ac:picMkLst>
        </pc:picChg>
        <pc:picChg chg="add del mod">
          <ac:chgData name="Azadeh Dalvand" userId="0e1d96ea38aa11af" providerId="LiveId" clId="{7AEBC03C-339B-437B-BFAD-AC4CB6ADD593}" dt="2021-06-30T20:29:20.174" v="2314" actId="478"/>
          <ac:picMkLst>
            <pc:docMk/>
            <pc:sldMk cId="2196489227" sldId="260"/>
            <ac:picMk id="10" creationId="{89379ECB-82D8-4AD4-9E41-466EADA841A3}"/>
          </ac:picMkLst>
        </pc:picChg>
        <pc:picChg chg="add mod">
          <ac:chgData name="Azadeh Dalvand" userId="0e1d96ea38aa11af" providerId="LiveId" clId="{7AEBC03C-339B-437B-BFAD-AC4CB6ADD593}" dt="2021-06-25T05:33:47.331" v="2009" actId="1036"/>
          <ac:picMkLst>
            <pc:docMk/>
            <pc:sldMk cId="2196489227" sldId="260"/>
            <ac:picMk id="11" creationId="{BFA3FF7B-1BE3-452A-8827-71D059B29F28}"/>
          </ac:picMkLst>
        </pc:picChg>
        <pc:picChg chg="add mod">
          <ac:chgData name="Azadeh Dalvand" userId="0e1d96ea38aa11af" providerId="LiveId" clId="{7AEBC03C-339B-437B-BFAD-AC4CB6ADD593}" dt="2021-07-01T05:41:15.530" v="2565" actId="1076"/>
          <ac:picMkLst>
            <pc:docMk/>
            <pc:sldMk cId="2196489227" sldId="260"/>
            <ac:picMk id="12" creationId="{692BBC90-228F-4BBE-B34A-DEEFD4F9E474}"/>
          </ac:picMkLst>
        </pc:picChg>
        <pc:picChg chg="add mod">
          <ac:chgData name="Azadeh Dalvand" userId="0e1d96ea38aa11af" providerId="LiveId" clId="{7AEBC03C-339B-437B-BFAD-AC4CB6ADD593}" dt="2021-06-25T05:35:20.433" v="2064" actId="1037"/>
          <ac:picMkLst>
            <pc:docMk/>
            <pc:sldMk cId="2196489227" sldId="260"/>
            <ac:picMk id="13" creationId="{C48BF83F-5A51-424C-BD26-B2936B7B2421}"/>
          </ac:picMkLst>
        </pc:picChg>
        <pc:picChg chg="add del mod">
          <ac:chgData name="Azadeh Dalvand" userId="0e1d96ea38aa11af" providerId="LiveId" clId="{7AEBC03C-339B-437B-BFAD-AC4CB6ADD593}" dt="2021-06-30T20:39:31.533" v="2448" actId="478"/>
          <ac:picMkLst>
            <pc:docMk/>
            <pc:sldMk cId="2196489227" sldId="260"/>
            <ac:picMk id="15" creationId="{434276D6-8996-4815-8649-FB50F57B1C15}"/>
          </ac:picMkLst>
        </pc:picChg>
        <pc:picChg chg="add mod">
          <ac:chgData name="Azadeh Dalvand" userId="0e1d96ea38aa11af" providerId="LiveId" clId="{7AEBC03C-339B-437B-BFAD-AC4CB6ADD593}" dt="2021-07-01T05:41:15.530" v="2565" actId="1076"/>
          <ac:picMkLst>
            <pc:docMk/>
            <pc:sldMk cId="2196489227" sldId="260"/>
            <ac:picMk id="16" creationId="{95A70E00-0221-4D96-8BE7-2E1130C6F8C5}"/>
          </ac:picMkLst>
        </pc:picChg>
        <pc:picChg chg="add del mod">
          <ac:chgData name="Azadeh Dalvand" userId="0e1d96ea38aa11af" providerId="LiveId" clId="{7AEBC03C-339B-437B-BFAD-AC4CB6ADD593}" dt="2021-06-30T20:39:31.533" v="2448" actId="478"/>
          <ac:picMkLst>
            <pc:docMk/>
            <pc:sldMk cId="2196489227" sldId="260"/>
            <ac:picMk id="17" creationId="{E44CB248-3BF1-4140-9E0C-3CD540C0E320}"/>
          </ac:picMkLst>
        </pc:picChg>
        <pc:picChg chg="add del mod">
          <ac:chgData name="Azadeh Dalvand" userId="0e1d96ea38aa11af" providerId="LiveId" clId="{7AEBC03C-339B-437B-BFAD-AC4CB6ADD593}" dt="2021-06-30T20:33:36.374" v="2339" actId="478"/>
          <ac:picMkLst>
            <pc:docMk/>
            <pc:sldMk cId="2196489227" sldId="260"/>
            <ac:picMk id="19" creationId="{3CC8E446-1150-487A-B9C0-37BAA7D84B9F}"/>
          </ac:picMkLst>
        </pc:picChg>
        <pc:picChg chg="add del mod">
          <ac:chgData name="Azadeh Dalvand" userId="0e1d96ea38aa11af" providerId="LiveId" clId="{7AEBC03C-339B-437B-BFAD-AC4CB6ADD593}" dt="2021-06-19T02:21:43.940" v="670" actId="478"/>
          <ac:picMkLst>
            <pc:docMk/>
            <pc:sldMk cId="2196489227" sldId="260"/>
            <ac:picMk id="20" creationId="{7C4DA2EF-1CFD-4A59-830B-E83B98F292C7}"/>
          </ac:picMkLst>
        </pc:picChg>
        <pc:picChg chg="add del mod">
          <ac:chgData name="Azadeh Dalvand" userId="0e1d96ea38aa11af" providerId="LiveId" clId="{7AEBC03C-339B-437B-BFAD-AC4CB6ADD593}" dt="2021-06-30T20:33:32.578" v="2337" actId="478"/>
          <ac:picMkLst>
            <pc:docMk/>
            <pc:sldMk cId="2196489227" sldId="260"/>
            <ac:picMk id="21" creationId="{76D18D17-99E4-4FAA-AAE0-DCCB12E137D8}"/>
          </ac:picMkLst>
        </pc:picChg>
        <pc:picChg chg="add del mod">
          <ac:chgData name="Azadeh Dalvand" userId="0e1d96ea38aa11af" providerId="LiveId" clId="{7AEBC03C-339B-437B-BFAD-AC4CB6ADD593}" dt="2021-06-19T02:21:43.940" v="670" actId="478"/>
          <ac:picMkLst>
            <pc:docMk/>
            <pc:sldMk cId="2196489227" sldId="260"/>
            <ac:picMk id="23" creationId="{3FF9CD0E-C011-4A14-A6A3-470E31C41857}"/>
          </ac:picMkLst>
        </pc:picChg>
        <pc:picChg chg="add del mod">
          <ac:chgData name="Azadeh Dalvand" userId="0e1d96ea38aa11af" providerId="LiveId" clId="{7AEBC03C-339B-437B-BFAD-AC4CB6ADD593}" dt="2021-06-30T20:24:59.972" v="2291" actId="478"/>
          <ac:picMkLst>
            <pc:docMk/>
            <pc:sldMk cId="2196489227" sldId="260"/>
            <ac:picMk id="23" creationId="{F9861376-0150-47CF-AE92-FB0E10EE3F05}"/>
          </ac:picMkLst>
        </pc:picChg>
        <pc:picChg chg="add del mod">
          <ac:chgData name="Azadeh Dalvand" userId="0e1d96ea38aa11af" providerId="LiveId" clId="{7AEBC03C-339B-437B-BFAD-AC4CB6ADD593}" dt="2021-06-18T23:51:16.495" v="13" actId="478"/>
          <ac:picMkLst>
            <pc:docMk/>
            <pc:sldMk cId="2196489227" sldId="260"/>
            <ac:picMk id="25" creationId="{785685F7-928E-423E-AC1A-BC77A2E5F5A4}"/>
          </ac:picMkLst>
        </pc:picChg>
        <pc:picChg chg="add del mod">
          <ac:chgData name="Azadeh Dalvand" userId="0e1d96ea38aa11af" providerId="LiveId" clId="{7AEBC03C-339B-437B-BFAD-AC4CB6ADD593}" dt="2021-06-25T05:39:12.817" v="2203" actId="478"/>
          <ac:picMkLst>
            <pc:docMk/>
            <pc:sldMk cId="2196489227" sldId="260"/>
            <ac:picMk id="25" creationId="{7B787453-CC80-4025-BFCD-EF7A5D461870}"/>
          </ac:picMkLst>
        </pc:picChg>
        <pc:picChg chg="add del mod">
          <ac:chgData name="Azadeh Dalvand" userId="0e1d96ea38aa11af" providerId="LiveId" clId="{7AEBC03C-339B-437B-BFAD-AC4CB6ADD593}" dt="2021-06-30T20:24:59.192" v="2290" actId="478"/>
          <ac:picMkLst>
            <pc:docMk/>
            <pc:sldMk cId="2196489227" sldId="260"/>
            <ac:picMk id="25" creationId="{8D9266C6-7FDE-48FF-BFB1-0E0C99021B90}"/>
          </ac:picMkLst>
        </pc:picChg>
        <pc:picChg chg="add del mod">
          <ac:chgData name="Azadeh Dalvand" userId="0e1d96ea38aa11af" providerId="LiveId" clId="{7AEBC03C-339B-437B-BFAD-AC4CB6ADD593}" dt="2021-06-25T05:25:43.855" v="1865" actId="478"/>
          <ac:picMkLst>
            <pc:docMk/>
            <pc:sldMk cId="2196489227" sldId="260"/>
            <ac:picMk id="26" creationId="{B17FFB3D-E73B-42EE-B34A-C8441E935A8B}"/>
          </ac:picMkLst>
        </pc:picChg>
        <pc:picChg chg="add del mod">
          <ac:chgData name="Azadeh Dalvand" userId="0e1d96ea38aa11af" providerId="LiveId" clId="{7AEBC03C-339B-437B-BFAD-AC4CB6ADD593}" dt="2021-06-30T20:20:17.932" v="2259" actId="478"/>
          <ac:picMkLst>
            <pc:docMk/>
            <pc:sldMk cId="2196489227" sldId="260"/>
            <ac:picMk id="27" creationId="{92C8F17E-86FA-41AF-9948-FD1C5A8B2BEF}"/>
          </ac:picMkLst>
        </pc:picChg>
        <pc:picChg chg="add del mod">
          <ac:chgData name="Azadeh Dalvand" userId="0e1d96ea38aa11af" providerId="LiveId" clId="{7AEBC03C-339B-437B-BFAD-AC4CB6ADD593}" dt="2021-06-25T05:25:43.855" v="1865" actId="478"/>
          <ac:picMkLst>
            <pc:docMk/>
            <pc:sldMk cId="2196489227" sldId="260"/>
            <ac:picMk id="28" creationId="{9F7EAE3E-DA33-43BF-9763-9D1B837555FA}"/>
          </ac:picMkLst>
        </pc:picChg>
        <pc:picChg chg="add del mod">
          <ac:chgData name="Azadeh Dalvand" userId="0e1d96ea38aa11af" providerId="LiveId" clId="{7AEBC03C-339B-437B-BFAD-AC4CB6ADD593}" dt="2021-06-30T20:20:57.791" v="2264" actId="478"/>
          <ac:picMkLst>
            <pc:docMk/>
            <pc:sldMk cId="2196489227" sldId="260"/>
            <ac:picMk id="29" creationId="{98953366-0972-41AA-8270-A649C1962FDA}"/>
          </ac:picMkLst>
        </pc:picChg>
        <pc:picChg chg="add mod">
          <ac:chgData name="Azadeh Dalvand" userId="0e1d96ea38aa11af" providerId="LiveId" clId="{7AEBC03C-339B-437B-BFAD-AC4CB6ADD593}" dt="2021-06-30T20:22:21.266" v="2270" actId="1076"/>
          <ac:picMkLst>
            <pc:docMk/>
            <pc:sldMk cId="2196489227" sldId="260"/>
            <ac:picMk id="32" creationId="{922725AB-2CF1-4F3C-BB14-87A7ED956A43}"/>
          </ac:picMkLst>
        </pc:picChg>
        <pc:picChg chg="add mod">
          <ac:chgData name="Azadeh Dalvand" userId="0e1d96ea38aa11af" providerId="LiveId" clId="{7AEBC03C-339B-437B-BFAD-AC4CB6ADD593}" dt="2021-06-30T20:22:24.501" v="2271" actId="1076"/>
          <ac:picMkLst>
            <pc:docMk/>
            <pc:sldMk cId="2196489227" sldId="260"/>
            <ac:picMk id="34" creationId="{5211A926-A147-49B6-904B-7CE2A613D013}"/>
          </ac:picMkLst>
        </pc:picChg>
        <pc:picChg chg="add mod">
          <ac:chgData name="Azadeh Dalvand" userId="0e1d96ea38aa11af" providerId="LiveId" clId="{7AEBC03C-339B-437B-BFAD-AC4CB6ADD593}" dt="2021-06-30T20:39:04.135" v="2443" actId="1036"/>
          <ac:picMkLst>
            <pc:docMk/>
            <pc:sldMk cId="2196489227" sldId="260"/>
            <ac:picMk id="36" creationId="{0165E5E4-AAD2-42AD-B9A2-DDDCEE050535}"/>
          </ac:picMkLst>
        </pc:picChg>
        <pc:picChg chg="add mod">
          <ac:chgData name="Azadeh Dalvand" userId="0e1d96ea38aa11af" providerId="LiveId" clId="{7AEBC03C-339B-437B-BFAD-AC4CB6ADD593}" dt="2021-06-30T20:23:33.293" v="2275" actId="1076"/>
          <ac:picMkLst>
            <pc:docMk/>
            <pc:sldMk cId="2196489227" sldId="260"/>
            <ac:picMk id="38" creationId="{20B2C88E-C0FA-47C0-A2F2-641C7B600E94}"/>
          </ac:picMkLst>
        </pc:picChg>
        <pc:picChg chg="add mod">
          <ac:chgData name="Azadeh Dalvand" userId="0e1d96ea38aa11af" providerId="LiveId" clId="{7AEBC03C-339B-437B-BFAD-AC4CB6ADD593}" dt="2021-06-23T22:00:25.444" v="1679" actId="1037"/>
          <ac:picMkLst>
            <pc:docMk/>
            <pc:sldMk cId="2196489227" sldId="260"/>
            <ac:picMk id="40" creationId="{DB2951EF-A5D9-46B7-BC52-5223F088E748}"/>
          </ac:picMkLst>
        </pc:picChg>
        <pc:picChg chg="add del mod">
          <ac:chgData name="Azadeh Dalvand" userId="0e1d96ea38aa11af" providerId="LiveId" clId="{7AEBC03C-339B-437B-BFAD-AC4CB6ADD593}" dt="2021-06-30T20:29:23.037" v="2315" actId="478"/>
          <ac:picMkLst>
            <pc:docMk/>
            <pc:sldMk cId="2196489227" sldId="260"/>
            <ac:picMk id="41" creationId="{EFF6ECF0-1C41-46B8-81DA-F24EB206A53E}"/>
          </ac:picMkLst>
        </pc:picChg>
        <pc:picChg chg="add del mod">
          <ac:chgData name="Azadeh Dalvand" userId="0e1d96ea38aa11af" providerId="LiveId" clId="{7AEBC03C-339B-437B-BFAD-AC4CB6ADD593}" dt="2021-06-19T02:36:16.897" v="878" actId="478"/>
          <ac:picMkLst>
            <pc:docMk/>
            <pc:sldMk cId="2196489227" sldId="260"/>
            <ac:picMk id="42" creationId="{E5B92D09-EDBF-4BFD-90CF-3DCA61F031F7}"/>
          </ac:picMkLst>
        </pc:picChg>
        <pc:picChg chg="add del mod">
          <ac:chgData name="Azadeh Dalvand" userId="0e1d96ea38aa11af" providerId="LiveId" clId="{7AEBC03C-339B-437B-BFAD-AC4CB6ADD593}" dt="2021-06-18T23:58:53.982" v="56" actId="478"/>
          <ac:picMkLst>
            <pc:docMk/>
            <pc:sldMk cId="2196489227" sldId="260"/>
            <ac:picMk id="43" creationId="{3164C6EF-E5AC-4698-96C9-E8436E45F71F}"/>
          </ac:picMkLst>
        </pc:picChg>
        <pc:picChg chg="add del mod">
          <ac:chgData name="Azadeh Dalvand" userId="0e1d96ea38aa11af" providerId="LiveId" clId="{7AEBC03C-339B-437B-BFAD-AC4CB6ADD593}" dt="2021-06-30T20:29:23.037" v="2315" actId="478"/>
          <ac:picMkLst>
            <pc:docMk/>
            <pc:sldMk cId="2196489227" sldId="260"/>
            <ac:picMk id="43" creationId="{B2E37871-7986-4853-9658-CD554386FE91}"/>
          </ac:picMkLst>
        </pc:picChg>
        <pc:picChg chg="add del mod">
          <ac:chgData name="Azadeh Dalvand" userId="0e1d96ea38aa11af" providerId="LiveId" clId="{7AEBC03C-339B-437B-BFAD-AC4CB6ADD593}" dt="2021-06-19T00:03:10.275" v="132" actId="478"/>
          <ac:picMkLst>
            <pc:docMk/>
            <pc:sldMk cId="2196489227" sldId="260"/>
            <ac:picMk id="44" creationId="{CFD456B5-3C6F-4B50-89F8-C32AA26154E0}"/>
          </ac:picMkLst>
        </pc:picChg>
        <pc:picChg chg="add del mod">
          <ac:chgData name="Azadeh Dalvand" userId="0e1d96ea38aa11af" providerId="LiveId" clId="{7AEBC03C-339B-437B-BFAD-AC4CB6ADD593}" dt="2021-06-19T02:36:16.080" v="877" actId="478"/>
          <ac:picMkLst>
            <pc:docMk/>
            <pc:sldMk cId="2196489227" sldId="260"/>
            <ac:picMk id="44" creationId="{D8A2A573-9CEA-4A9B-AB7D-01F8E37BA122}"/>
          </ac:picMkLst>
        </pc:picChg>
        <pc:picChg chg="add mod">
          <ac:chgData name="Azadeh Dalvand" userId="0e1d96ea38aa11af" providerId="LiveId" clId="{7AEBC03C-339B-437B-BFAD-AC4CB6ADD593}" dt="2021-06-30T20:37:26.426" v="2381" actId="1038"/>
          <ac:picMkLst>
            <pc:docMk/>
            <pc:sldMk cId="2196489227" sldId="260"/>
            <ac:picMk id="45" creationId="{BB8A706A-B804-4E13-9737-AC18B3E415EB}"/>
          </ac:picMkLst>
        </pc:picChg>
        <pc:picChg chg="add mod">
          <ac:chgData name="Azadeh Dalvand" userId="0e1d96ea38aa11af" providerId="LiveId" clId="{7AEBC03C-339B-437B-BFAD-AC4CB6ADD593}" dt="2021-06-23T22:00:47.651" v="1686" actId="14100"/>
          <ac:picMkLst>
            <pc:docMk/>
            <pc:sldMk cId="2196489227" sldId="260"/>
            <ac:picMk id="46" creationId="{B10A5C11-AE7C-49C5-A1ED-FA242A8B18E2}"/>
          </ac:picMkLst>
        </pc:picChg>
        <pc:picChg chg="add del mod">
          <ac:chgData name="Azadeh Dalvand" userId="0e1d96ea38aa11af" providerId="LiveId" clId="{7AEBC03C-339B-437B-BFAD-AC4CB6ADD593}" dt="2021-06-19T00:03:07.762" v="131" actId="478"/>
          <ac:picMkLst>
            <pc:docMk/>
            <pc:sldMk cId="2196489227" sldId="260"/>
            <ac:picMk id="47" creationId="{3ED4DECB-CA39-4471-975C-8405602DD10B}"/>
          </ac:picMkLst>
        </pc:picChg>
        <pc:picChg chg="add del mod">
          <ac:chgData name="Azadeh Dalvand" userId="0e1d96ea38aa11af" providerId="LiveId" clId="{7AEBC03C-339B-437B-BFAD-AC4CB6ADD593}" dt="2021-06-25T05:39:12.817" v="2203" actId="478"/>
          <ac:picMkLst>
            <pc:docMk/>
            <pc:sldMk cId="2196489227" sldId="260"/>
            <ac:picMk id="47" creationId="{ED656D60-79A7-4CFE-80B4-0958D734C8CB}"/>
          </ac:picMkLst>
        </pc:picChg>
        <pc:picChg chg="add mod">
          <ac:chgData name="Azadeh Dalvand" userId="0e1d96ea38aa11af" providerId="LiveId" clId="{7AEBC03C-339B-437B-BFAD-AC4CB6ADD593}" dt="2021-06-30T20:31:43.372" v="2325" actId="14100"/>
          <ac:picMkLst>
            <pc:docMk/>
            <pc:sldMk cId="2196489227" sldId="260"/>
            <ac:picMk id="48" creationId="{A522780A-1CC3-4954-9935-B05B30ED422A}"/>
          </ac:picMkLst>
        </pc:picChg>
        <pc:picChg chg="add del mod">
          <ac:chgData name="Azadeh Dalvand" userId="0e1d96ea38aa11af" providerId="LiveId" clId="{7AEBC03C-339B-437B-BFAD-AC4CB6ADD593}" dt="2021-06-19T02:33:43.203" v="852" actId="478"/>
          <ac:picMkLst>
            <pc:docMk/>
            <pc:sldMk cId="2196489227" sldId="260"/>
            <ac:picMk id="48" creationId="{EC7DEF61-8979-490C-9FCF-79EBB88B80FE}"/>
          </ac:picMkLst>
        </pc:picChg>
        <pc:picChg chg="add mod">
          <ac:chgData name="Azadeh Dalvand" userId="0e1d96ea38aa11af" providerId="LiveId" clId="{7AEBC03C-339B-437B-BFAD-AC4CB6ADD593}" dt="2021-06-23T22:00:37.134" v="1685" actId="1037"/>
          <ac:picMkLst>
            <pc:docMk/>
            <pc:sldMk cId="2196489227" sldId="260"/>
            <ac:picMk id="49" creationId="{2846A2B0-D23D-4D71-B140-99BC823CBD9B}"/>
          </ac:picMkLst>
        </pc:picChg>
        <pc:picChg chg="add del mod">
          <ac:chgData name="Azadeh Dalvand" userId="0e1d96ea38aa11af" providerId="LiveId" clId="{7AEBC03C-339B-437B-BFAD-AC4CB6ADD593}" dt="2021-06-19T00:03:06.074" v="130" actId="478"/>
          <ac:picMkLst>
            <pc:docMk/>
            <pc:sldMk cId="2196489227" sldId="260"/>
            <ac:picMk id="50" creationId="{B41359E1-476E-4492-9B54-6A53B3D44E85}"/>
          </ac:picMkLst>
        </pc:picChg>
        <pc:picChg chg="add del mod">
          <ac:chgData name="Azadeh Dalvand" userId="0e1d96ea38aa11af" providerId="LiveId" clId="{7AEBC03C-339B-437B-BFAD-AC4CB6ADD593}" dt="2021-06-25T05:39:12.817" v="2203" actId="478"/>
          <ac:picMkLst>
            <pc:docMk/>
            <pc:sldMk cId="2196489227" sldId="260"/>
            <ac:picMk id="50" creationId="{C9D7CCD9-507B-48CE-98C9-3602C5F511E0}"/>
          </ac:picMkLst>
        </pc:picChg>
        <pc:picChg chg="add del mod">
          <ac:chgData name="Azadeh Dalvand" userId="0e1d96ea38aa11af" providerId="LiveId" clId="{7AEBC03C-339B-437B-BFAD-AC4CB6ADD593}" dt="2021-06-23T22:03:46.720" v="1834" actId="478"/>
          <ac:picMkLst>
            <pc:docMk/>
            <pc:sldMk cId="2196489227" sldId="260"/>
            <ac:picMk id="51" creationId="{07BA0F59-43C5-4868-B1D0-829A81AE8364}"/>
          </ac:picMkLst>
        </pc:picChg>
        <pc:picChg chg="add mod">
          <ac:chgData name="Azadeh Dalvand" userId="0e1d96ea38aa11af" providerId="LiveId" clId="{7AEBC03C-339B-437B-BFAD-AC4CB6ADD593}" dt="2021-06-30T20:32:35.259" v="2331" actId="1076"/>
          <ac:picMkLst>
            <pc:docMk/>
            <pc:sldMk cId="2196489227" sldId="260"/>
            <ac:picMk id="51" creationId="{AB7DEB98-E514-4D67-A812-959CB533255D}"/>
          </ac:picMkLst>
        </pc:picChg>
        <pc:picChg chg="add del mod">
          <ac:chgData name="Azadeh Dalvand" userId="0e1d96ea38aa11af" providerId="LiveId" clId="{7AEBC03C-339B-437B-BFAD-AC4CB6ADD593}" dt="2021-06-23T22:03:46.720" v="1834" actId="478"/>
          <ac:picMkLst>
            <pc:docMk/>
            <pc:sldMk cId="2196489227" sldId="260"/>
            <ac:picMk id="52" creationId="{C39B263B-74A3-4248-8711-D17F4623A54D}"/>
          </ac:picMkLst>
        </pc:picChg>
        <pc:picChg chg="add del mod">
          <ac:chgData name="Azadeh Dalvand" userId="0e1d96ea38aa11af" providerId="LiveId" clId="{7AEBC03C-339B-437B-BFAD-AC4CB6ADD593}" dt="2021-06-19T02:36:15.402" v="876" actId="478"/>
          <ac:picMkLst>
            <pc:docMk/>
            <pc:sldMk cId="2196489227" sldId="260"/>
            <ac:picMk id="53" creationId="{0AAE8C51-70AB-41FC-AC51-D8E983B611DB}"/>
          </ac:picMkLst>
        </pc:picChg>
        <pc:picChg chg="add mod">
          <ac:chgData name="Azadeh Dalvand" userId="0e1d96ea38aa11af" providerId="LiveId" clId="{7AEBC03C-339B-437B-BFAD-AC4CB6ADD593}" dt="2021-06-30T20:33:23.725" v="2336" actId="14100"/>
          <ac:picMkLst>
            <pc:docMk/>
            <pc:sldMk cId="2196489227" sldId="260"/>
            <ac:picMk id="53" creationId="{D6E11716-B6C1-4398-B9BB-83F82662BD41}"/>
          </ac:picMkLst>
        </pc:picChg>
        <pc:picChg chg="add mod">
          <ac:chgData name="Azadeh Dalvand" userId="0e1d96ea38aa11af" providerId="LiveId" clId="{7AEBC03C-339B-437B-BFAD-AC4CB6ADD593}" dt="2021-06-23T22:00:18.197" v="1677" actId="1076"/>
          <ac:picMkLst>
            <pc:docMk/>
            <pc:sldMk cId="2196489227" sldId="260"/>
            <ac:picMk id="54" creationId="{49C1E910-6525-48B3-8EFB-8C847278CC41}"/>
          </ac:picMkLst>
        </pc:picChg>
        <pc:picChg chg="add del mod">
          <ac:chgData name="Azadeh Dalvand" userId="0e1d96ea38aa11af" providerId="LiveId" clId="{7AEBC03C-339B-437B-BFAD-AC4CB6ADD593}" dt="2021-06-23T22:03:46.720" v="1834" actId="478"/>
          <ac:picMkLst>
            <pc:docMk/>
            <pc:sldMk cId="2196489227" sldId="260"/>
            <ac:picMk id="55" creationId="{86FCF470-33DD-43CF-BECB-DD44F153AAE8}"/>
          </ac:picMkLst>
        </pc:picChg>
        <pc:picChg chg="add mod">
          <ac:chgData name="Azadeh Dalvand" userId="0e1d96ea38aa11af" providerId="LiveId" clId="{7AEBC03C-339B-437B-BFAD-AC4CB6ADD593}" dt="2021-07-01T05:41:47.100" v="2570" actId="1076"/>
          <ac:picMkLst>
            <pc:docMk/>
            <pc:sldMk cId="2196489227" sldId="260"/>
            <ac:picMk id="56" creationId="{94AD617D-ADA9-417E-97E2-0C445717F2BF}"/>
          </ac:picMkLst>
        </pc:picChg>
        <pc:picChg chg="add del mod">
          <ac:chgData name="Azadeh Dalvand" userId="0e1d96ea38aa11af" providerId="LiveId" clId="{7AEBC03C-339B-437B-BFAD-AC4CB6ADD593}" dt="2021-06-19T02:36:27.165" v="881" actId="478"/>
          <ac:picMkLst>
            <pc:docMk/>
            <pc:sldMk cId="2196489227" sldId="260"/>
            <ac:picMk id="56" creationId="{A02FE768-CCF9-44DB-AB33-25D68A354B19}"/>
          </ac:picMkLst>
        </pc:picChg>
        <pc:picChg chg="add del mod">
          <ac:chgData name="Azadeh Dalvand" userId="0e1d96ea38aa11af" providerId="LiveId" clId="{7AEBC03C-339B-437B-BFAD-AC4CB6ADD593}" dt="2021-06-19T00:08:28.253" v="181" actId="478"/>
          <ac:picMkLst>
            <pc:docMk/>
            <pc:sldMk cId="2196489227" sldId="260"/>
            <ac:picMk id="57" creationId="{0A2B8C61-06B2-4299-AC80-14A7C1E4E46C}"/>
          </ac:picMkLst>
        </pc:picChg>
        <pc:picChg chg="add del mod">
          <ac:chgData name="Azadeh Dalvand" userId="0e1d96ea38aa11af" providerId="LiveId" clId="{7AEBC03C-339B-437B-BFAD-AC4CB6ADD593}" dt="2021-06-25T05:37:34.698" v="2199" actId="478"/>
          <ac:picMkLst>
            <pc:docMk/>
            <pc:sldMk cId="2196489227" sldId="260"/>
            <ac:picMk id="57" creationId="{C7C7B613-EF01-4530-AE2D-DB864B67542F}"/>
          </ac:picMkLst>
        </pc:picChg>
        <pc:picChg chg="add mod">
          <ac:chgData name="Azadeh Dalvand" userId="0e1d96ea38aa11af" providerId="LiveId" clId="{7AEBC03C-339B-437B-BFAD-AC4CB6ADD593}" dt="2021-07-01T05:41:52.526" v="2571" actId="1076"/>
          <ac:picMkLst>
            <pc:docMk/>
            <pc:sldMk cId="2196489227" sldId="260"/>
            <ac:picMk id="57" creationId="{D9B85C7A-25C6-4CBF-924A-701A88D2DD4A}"/>
          </ac:picMkLst>
        </pc:picChg>
        <pc:picChg chg="add mod">
          <ac:chgData name="Azadeh Dalvand" userId="0e1d96ea38aa11af" providerId="LiveId" clId="{7AEBC03C-339B-437B-BFAD-AC4CB6ADD593}" dt="2021-06-25T05:37:30.588" v="2197" actId="1076"/>
          <ac:picMkLst>
            <pc:docMk/>
            <pc:sldMk cId="2196489227" sldId="260"/>
            <ac:picMk id="58" creationId="{068ACBE7-C24B-4FAB-8726-E6A0E07342B2}"/>
          </ac:picMkLst>
        </pc:picChg>
        <pc:picChg chg="add mod">
          <ac:chgData name="Azadeh Dalvand" userId="0e1d96ea38aa11af" providerId="LiveId" clId="{7AEBC03C-339B-437B-BFAD-AC4CB6ADD593}" dt="2021-06-25T05:35:46.083" v="2067" actId="1076"/>
          <ac:picMkLst>
            <pc:docMk/>
            <pc:sldMk cId="2196489227" sldId="260"/>
            <ac:picMk id="59" creationId="{0A63BAA0-27B7-4885-B6B2-B70AF200057F}"/>
          </ac:picMkLst>
        </pc:picChg>
        <pc:picChg chg="add del mod">
          <ac:chgData name="Azadeh Dalvand" userId="0e1d96ea38aa11af" providerId="LiveId" clId="{7AEBC03C-339B-437B-BFAD-AC4CB6ADD593}" dt="2021-06-19T00:10:54.846" v="206" actId="478"/>
          <ac:picMkLst>
            <pc:docMk/>
            <pc:sldMk cId="2196489227" sldId="260"/>
            <ac:picMk id="59" creationId="{BAA11292-DB44-4600-874B-5657EDA69575}"/>
          </ac:picMkLst>
        </pc:picChg>
        <pc:picChg chg="add mod">
          <ac:chgData name="Azadeh Dalvand" userId="0e1d96ea38aa11af" providerId="LiveId" clId="{7AEBC03C-339B-437B-BFAD-AC4CB6ADD593}" dt="2021-06-25T05:37:08.745" v="2193" actId="1076"/>
          <ac:picMkLst>
            <pc:docMk/>
            <pc:sldMk cId="2196489227" sldId="260"/>
            <ac:picMk id="60" creationId="{7574DAE1-9BD1-4121-A169-8FD390115696}"/>
          </ac:picMkLst>
        </pc:picChg>
        <pc:picChg chg="add del mod">
          <ac:chgData name="Azadeh Dalvand" userId="0e1d96ea38aa11af" providerId="LiveId" clId="{7AEBC03C-339B-437B-BFAD-AC4CB6ADD593}" dt="2021-06-19T00:10:54.846" v="206" actId="478"/>
          <ac:picMkLst>
            <pc:docMk/>
            <pc:sldMk cId="2196489227" sldId="260"/>
            <ac:picMk id="60" creationId="{75F61F87-FFDF-4BE8-B8D3-D567CCC8968B}"/>
          </ac:picMkLst>
        </pc:picChg>
        <pc:picChg chg="add mod">
          <ac:chgData name="Azadeh Dalvand" userId="0e1d96ea38aa11af" providerId="LiveId" clId="{7AEBC03C-339B-437B-BFAD-AC4CB6ADD593}" dt="2021-06-23T21:58:58.810" v="1665" actId="1076"/>
          <ac:picMkLst>
            <pc:docMk/>
            <pc:sldMk cId="2196489227" sldId="260"/>
            <ac:picMk id="62" creationId="{49DB22AD-8F39-4C5D-A57A-4FD298FB5329}"/>
          </ac:picMkLst>
        </pc:picChg>
        <pc:picChg chg="add mod">
          <ac:chgData name="Azadeh Dalvand" userId="0e1d96ea38aa11af" providerId="LiveId" clId="{7AEBC03C-339B-437B-BFAD-AC4CB6ADD593}" dt="2021-06-23T22:02:13.743" v="1691" actId="14100"/>
          <ac:picMkLst>
            <pc:docMk/>
            <pc:sldMk cId="2196489227" sldId="260"/>
            <ac:picMk id="63" creationId="{2F7C0DCC-149E-4627-8F69-E23ABC5111FE}"/>
          </ac:picMkLst>
        </pc:picChg>
        <pc:picChg chg="add mod">
          <ac:chgData name="Azadeh Dalvand" userId="0e1d96ea38aa11af" providerId="LiveId" clId="{7AEBC03C-339B-437B-BFAD-AC4CB6ADD593}" dt="2021-06-23T22:06:12.091" v="1858" actId="1038"/>
          <ac:picMkLst>
            <pc:docMk/>
            <pc:sldMk cId="2196489227" sldId="260"/>
            <ac:picMk id="65" creationId="{0C01B5FB-0D05-4414-91ED-87BA9618F6DD}"/>
          </ac:picMkLst>
        </pc:picChg>
        <pc:picChg chg="add del">
          <ac:chgData name="Azadeh Dalvand" userId="0e1d96ea38aa11af" providerId="LiveId" clId="{7AEBC03C-339B-437B-BFAD-AC4CB6ADD593}" dt="2021-06-19T02:29:37.763" v="744"/>
          <ac:picMkLst>
            <pc:docMk/>
            <pc:sldMk cId="2196489227" sldId="260"/>
            <ac:picMk id="66" creationId="{8FC4AC73-EDF5-4332-A3AF-933AC4DC5273}"/>
          </ac:picMkLst>
        </pc:picChg>
        <pc:picChg chg="add mod">
          <ac:chgData name="Azadeh Dalvand" userId="0e1d96ea38aa11af" providerId="LiveId" clId="{7AEBC03C-339B-437B-BFAD-AC4CB6ADD593}" dt="2021-06-23T22:08:43.536" v="1864" actId="1036"/>
          <ac:picMkLst>
            <pc:docMk/>
            <pc:sldMk cId="2196489227" sldId="260"/>
            <ac:picMk id="67" creationId="{7378187C-471C-4274-A96C-9E13C9109240}"/>
          </ac:picMkLst>
        </pc:picChg>
        <pc:picChg chg="add mod">
          <ac:chgData name="Azadeh Dalvand" userId="0e1d96ea38aa11af" providerId="LiveId" clId="{7AEBC03C-339B-437B-BFAD-AC4CB6ADD593}" dt="2021-06-23T22:06:12.091" v="1858" actId="1038"/>
          <ac:picMkLst>
            <pc:docMk/>
            <pc:sldMk cId="2196489227" sldId="260"/>
            <ac:picMk id="69" creationId="{030E0A26-58F4-456D-937B-FC915EFA1CDA}"/>
          </ac:picMkLst>
        </pc:picChg>
        <pc:picChg chg="add del mod">
          <ac:chgData name="Azadeh Dalvand" userId="0e1d96ea38aa11af" providerId="LiveId" clId="{7AEBC03C-339B-437B-BFAD-AC4CB6ADD593}" dt="2021-06-19T02:33:14.693" v="847" actId="478"/>
          <ac:picMkLst>
            <pc:docMk/>
            <pc:sldMk cId="2196489227" sldId="260"/>
            <ac:picMk id="70" creationId="{DCEF6F7C-55AF-48E8-B855-72170F84BA57}"/>
          </ac:picMkLst>
        </pc:picChg>
        <pc:picChg chg="add mod">
          <ac:chgData name="Azadeh Dalvand" userId="0e1d96ea38aa11af" providerId="LiveId" clId="{7AEBC03C-339B-437B-BFAD-AC4CB6ADD593}" dt="2021-06-23T22:06:12.091" v="1858" actId="1038"/>
          <ac:picMkLst>
            <pc:docMk/>
            <pc:sldMk cId="2196489227" sldId="260"/>
            <ac:picMk id="71" creationId="{3C075DF9-C14D-41E1-A4A4-DA0ABD09DC0E}"/>
          </ac:picMkLst>
        </pc:picChg>
        <pc:picChg chg="add mod">
          <ac:chgData name="Azadeh Dalvand" userId="0e1d96ea38aa11af" providerId="LiveId" clId="{7AEBC03C-339B-437B-BFAD-AC4CB6ADD593}" dt="2021-06-23T22:08:31.315" v="1862" actId="1036"/>
          <ac:picMkLst>
            <pc:docMk/>
            <pc:sldMk cId="2196489227" sldId="260"/>
            <ac:picMk id="72" creationId="{314A1978-2C5E-4327-B243-799817117D17}"/>
          </ac:picMkLst>
        </pc:picChg>
        <pc:picChg chg="add mod">
          <ac:chgData name="Azadeh Dalvand" userId="0e1d96ea38aa11af" providerId="LiveId" clId="{7AEBC03C-339B-437B-BFAD-AC4CB6ADD593}" dt="2021-06-23T22:06:12.091" v="1858" actId="1038"/>
          <ac:picMkLst>
            <pc:docMk/>
            <pc:sldMk cId="2196489227" sldId="260"/>
            <ac:picMk id="73" creationId="{419CC8C2-496A-496A-9E08-01B37DAAE352}"/>
          </ac:picMkLst>
        </pc:picChg>
        <pc:picChg chg="add del">
          <ac:chgData name="Azadeh Dalvand" userId="0e1d96ea38aa11af" providerId="LiveId" clId="{7AEBC03C-339B-437B-BFAD-AC4CB6ADD593}" dt="2021-06-19T00:17:11.573" v="393" actId="478"/>
          <ac:picMkLst>
            <pc:docMk/>
            <pc:sldMk cId="2196489227" sldId="260"/>
            <ac:picMk id="74" creationId="{05B3EFCA-7C9C-4615-90DD-DFF8EB6ABFFB}"/>
          </ac:picMkLst>
        </pc:picChg>
        <pc:picChg chg="add mod">
          <ac:chgData name="Azadeh Dalvand" userId="0e1d96ea38aa11af" providerId="LiveId" clId="{7AEBC03C-339B-437B-BFAD-AC4CB6ADD593}" dt="2021-06-23T22:06:12.091" v="1858" actId="1038"/>
          <ac:picMkLst>
            <pc:docMk/>
            <pc:sldMk cId="2196489227" sldId="260"/>
            <ac:picMk id="74" creationId="{68716407-8D98-4929-BC07-DD40F5049E92}"/>
          </ac:picMkLst>
        </pc:picChg>
        <pc:picChg chg="add del mod">
          <ac:chgData name="Azadeh Dalvand" userId="0e1d96ea38aa11af" providerId="LiveId" clId="{7AEBC03C-339B-437B-BFAD-AC4CB6ADD593}" dt="2021-06-19T02:49:09.951" v="1133" actId="478"/>
          <ac:picMkLst>
            <pc:docMk/>
            <pc:sldMk cId="2196489227" sldId="260"/>
            <ac:picMk id="74" creationId="{A856B861-305F-4749-B867-1CD0DFF3A697}"/>
          </ac:picMkLst>
        </pc:picChg>
        <pc:picChg chg="add mod">
          <ac:chgData name="Azadeh Dalvand" userId="0e1d96ea38aa11af" providerId="LiveId" clId="{7AEBC03C-339B-437B-BFAD-AC4CB6ADD593}" dt="2021-06-23T22:06:12.091" v="1858" actId="1038"/>
          <ac:picMkLst>
            <pc:docMk/>
            <pc:sldMk cId="2196489227" sldId="260"/>
            <ac:picMk id="75" creationId="{3141CEBC-B2D5-4613-ABE9-0EF0DEF6E465}"/>
          </ac:picMkLst>
        </pc:picChg>
        <pc:picChg chg="add del mod">
          <ac:chgData name="Azadeh Dalvand" userId="0e1d96ea38aa11af" providerId="LiveId" clId="{7AEBC03C-339B-437B-BFAD-AC4CB6ADD593}" dt="2021-06-23T21:58:15.136" v="1653" actId="478"/>
          <ac:picMkLst>
            <pc:docMk/>
            <pc:sldMk cId="2196489227" sldId="260"/>
            <ac:picMk id="76" creationId="{C3D502CD-8F28-4292-B991-02943D8A28BF}"/>
          </ac:picMkLst>
        </pc:picChg>
        <pc:picChg chg="add del mod">
          <ac:chgData name="Azadeh Dalvand" userId="0e1d96ea38aa11af" providerId="LiveId" clId="{7AEBC03C-339B-437B-BFAD-AC4CB6ADD593}" dt="2021-06-30T20:48:59.151" v="2467" actId="478"/>
          <ac:picMkLst>
            <pc:docMk/>
            <pc:sldMk cId="2196489227" sldId="260"/>
            <ac:picMk id="76" creationId="{D55CD869-D853-4403-8299-363192D9AC09}"/>
          </ac:picMkLst>
        </pc:picChg>
        <pc:picChg chg="add del mod">
          <ac:chgData name="Azadeh Dalvand" userId="0e1d96ea38aa11af" providerId="LiveId" clId="{7AEBC03C-339B-437B-BFAD-AC4CB6ADD593}" dt="2021-06-23T21:58:15.136" v="1653" actId="478"/>
          <ac:picMkLst>
            <pc:docMk/>
            <pc:sldMk cId="2196489227" sldId="260"/>
            <ac:picMk id="77" creationId="{66AB8722-8F27-4F27-8507-3076CBF93083}"/>
          </ac:picMkLst>
        </pc:picChg>
        <pc:picChg chg="add del mod">
          <ac:chgData name="Azadeh Dalvand" userId="0e1d96ea38aa11af" providerId="LiveId" clId="{7AEBC03C-339B-437B-BFAD-AC4CB6ADD593}" dt="2021-06-23T21:58:15.136" v="1653" actId="478"/>
          <ac:picMkLst>
            <pc:docMk/>
            <pc:sldMk cId="2196489227" sldId="260"/>
            <ac:picMk id="78" creationId="{98C680DE-FA8D-4F5E-B6F6-74FB177C768F}"/>
          </ac:picMkLst>
        </pc:picChg>
        <pc:picChg chg="add del mod">
          <ac:chgData name="Azadeh Dalvand" userId="0e1d96ea38aa11af" providerId="LiveId" clId="{7AEBC03C-339B-437B-BFAD-AC4CB6ADD593}" dt="2021-06-23T21:58:15.136" v="1653" actId="478"/>
          <ac:picMkLst>
            <pc:docMk/>
            <pc:sldMk cId="2196489227" sldId="260"/>
            <ac:picMk id="79" creationId="{3E5C9318-00A5-4D73-9373-A221B0B958FD}"/>
          </ac:picMkLst>
        </pc:picChg>
        <pc:picChg chg="add mod">
          <ac:chgData name="Azadeh Dalvand" userId="0e1d96ea38aa11af" providerId="LiveId" clId="{7AEBC03C-339B-437B-BFAD-AC4CB6ADD593}" dt="2021-06-23T22:07:53.372" v="1861" actId="1038"/>
          <ac:picMkLst>
            <pc:docMk/>
            <pc:sldMk cId="2196489227" sldId="260"/>
            <ac:picMk id="80" creationId="{4FBAB942-21DD-49E7-AC8D-8ABF8609C0AA}"/>
          </ac:picMkLst>
        </pc:picChg>
        <pc:picChg chg="add del mod">
          <ac:chgData name="Azadeh Dalvand" userId="0e1d96ea38aa11af" providerId="LiveId" clId="{7AEBC03C-339B-437B-BFAD-AC4CB6ADD593}" dt="2021-06-19T02:34:06.513" v="859" actId="478"/>
          <ac:picMkLst>
            <pc:docMk/>
            <pc:sldMk cId="2196489227" sldId="260"/>
            <ac:picMk id="80" creationId="{CEAA1386-B691-4CC1-AC60-46BB7CA42AAD}"/>
          </ac:picMkLst>
        </pc:picChg>
        <pc:picChg chg="add mod">
          <ac:chgData name="Azadeh Dalvand" userId="0e1d96ea38aa11af" providerId="LiveId" clId="{7AEBC03C-339B-437B-BFAD-AC4CB6ADD593}" dt="2021-06-23T22:07:17.018" v="1860" actId="1037"/>
          <ac:picMkLst>
            <pc:docMk/>
            <pc:sldMk cId="2196489227" sldId="260"/>
            <ac:picMk id="81" creationId="{14C7D11F-88EA-4979-AFC0-26172EABD8FE}"/>
          </ac:picMkLst>
        </pc:picChg>
        <pc:picChg chg="add mod">
          <ac:chgData name="Azadeh Dalvand" userId="0e1d96ea38aa11af" providerId="LiveId" clId="{7AEBC03C-339B-437B-BFAD-AC4CB6ADD593}" dt="2021-06-23T22:03:01.474" v="1798" actId="1036"/>
          <ac:picMkLst>
            <pc:docMk/>
            <pc:sldMk cId="2196489227" sldId="260"/>
            <ac:picMk id="82" creationId="{DCF478EC-FB7A-4F22-8EE2-A35C21036084}"/>
          </ac:picMkLst>
        </pc:picChg>
        <pc:picChg chg="add del mod">
          <ac:chgData name="Azadeh Dalvand" userId="0e1d96ea38aa11af" providerId="LiveId" clId="{7AEBC03C-339B-437B-BFAD-AC4CB6ADD593}" dt="2021-06-19T02:42:37.573" v="975" actId="478"/>
          <ac:picMkLst>
            <pc:docMk/>
            <pc:sldMk cId="2196489227" sldId="260"/>
            <ac:picMk id="82" creationId="{F9DF7A77-2A24-45A0-835E-EBB30D3E65FC}"/>
          </ac:picMkLst>
        </pc:picChg>
        <pc:picChg chg="add mod">
          <ac:chgData name="Azadeh Dalvand" userId="0e1d96ea38aa11af" providerId="LiveId" clId="{7AEBC03C-339B-437B-BFAD-AC4CB6ADD593}" dt="2021-06-23T22:02:44.532" v="1760" actId="14100"/>
          <ac:picMkLst>
            <pc:docMk/>
            <pc:sldMk cId="2196489227" sldId="260"/>
            <ac:picMk id="83" creationId="{D38C5ECD-7C47-4786-B414-9FEA1EA2D555}"/>
          </ac:picMkLst>
        </pc:picChg>
        <pc:picChg chg="add del mod">
          <ac:chgData name="Azadeh Dalvand" userId="0e1d96ea38aa11af" providerId="LiveId" clId="{7AEBC03C-339B-437B-BFAD-AC4CB6ADD593}" dt="2021-06-19T00:20:33.962" v="520" actId="478"/>
          <ac:picMkLst>
            <pc:docMk/>
            <pc:sldMk cId="2196489227" sldId="260"/>
            <ac:picMk id="83" creationId="{E0A4C8F1-7F56-4874-94B1-9BD146326F0A}"/>
          </ac:picMkLst>
        </pc:picChg>
        <pc:picChg chg="add del mod">
          <ac:chgData name="Azadeh Dalvand" userId="0e1d96ea38aa11af" providerId="LiveId" clId="{7AEBC03C-339B-437B-BFAD-AC4CB6ADD593}" dt="2021-06-19T02:49:09.951" v="1133" actId="478"/>
          <ac:picMkLst>
            <pc:docMk/>
            <pc:sldMk cId="2196489227" sldId="260"/>
            <ac:picMk id="83" creationId="{E70D2749-0149-4985-ADDF-C92E7703083E}"/>
          </ac:picMkLst>
        </pc:picChg>
        <pc:picChg chg="add mod">
          <ac:chgData name="Azadeh Dalvand" userId="0e1d96ea38aa11af" providerId="LiveId" clId="{7AEBC03C-339B-437B-BFAD-AC4CB6ADD593}" dt="2021-06-23T22:03:30.053" v="1831" actId="1036"/>
          <ac:picMkLst>
            <pc:docMk/>
            <pc:sldMk cId="2196489227" sldId="260"/>
            <ac:picMk id="84" creationId="{4B39B86D-52EE-4AE8-9D94-E1D1CC976156}"/>
          </ac:picMkLst>
        </pc:picChg>
        <pc:picChg chg="add del mod">
          <ac:chgData name="Azadeh Dalvand" userId="0e1d96ea38aa11af" providerId="LiveId" clId="{7AEBC03C-339B-437B-BFAD-AC4CB6ADD593}" dt="2021-06-19T02:42:35.882" v="974" actId="478"/>
          <ac:picMkLst>
            <pc:docMk/>
            <pc:sldMk cId="2196489227" sldId="260"/>
            <ac:picMk id="84" creationId="{D795375C-E717-4E48-B690-B95B89D2439D}"/>
          </ac:picMkLst>
        </pc:picChg>
        <pc:picChg chg="add del mod">
          <ac:chgData name="Azadeh Dalvand" userId="0e1d96ea38aa11af" providerId="LiveId" clId="{7AEBC03C-339B-437B-BFAD-AC4CB6ADD593}" dt="2021-06-25T05:39:12.817" v="2203" actId="478"/>
          <ac:picMkLst>
            <pc:docMk/>
            <pc:sldMk cId="2196489227" sldId="260"/>
            <ac:picMk id="85" creationId="{4CA511B4-C721-45F2-8EC3-5EE5EF899152}"/>
          </ac:picMkLst>
        </pc:picChg>
        <pc:picChg chg="add del mod">
          <ac:chgData name="Azadeh Dalvand" userId="0e1d96ea38aa11af" providerId="LiveId" clId="{7AEBC03C-339B-437B-BFAD-AC4CB6ADD593}" dt="2021-06-19T00:20:35.742" v="521" actId="478"/>
          <ac:picMkLst>
            <pc:docMk/>
            <pc:sldMk cId="2196489227" sldId="260"/>
            <ac:picMk id="85" creationId="{9DC32F3B-A44A-4B13-938B-3C6C552C9FFD}"/>
          </ac:picMkLst>
        </pc:picChg>
        <pc:picChg chg="add mod">
          <ac:chgData name="Azadeh Dalvand" userId="0e1d96ea38aa11af" providerId="LiveId" clId="{7AEBC03C-339B-437B-BFAD-AC4CB6ADD593}" dt="2021-06-23T22:03:37.562" v="1833" actId="1037"/>
          <ac:picMkLst>
            <pc:docMk/>
            <pc:sldMk cId="2196489227" sldId="260"/>
            <ac:picMk id="88" creationId="{EB937E4A-97A1-4AD2-B245-E6C9E0A009C7}"/>
          </ac:picMkLst>
        </pc:picChg>
        <pc:picChg chg="add del mod">
          <ac:chgData name="Azadeh Dalvand" userId="0e1d96ea38aa11af" providerId="LiveId" clId="{7AEBC03C-339B-437B-BFAD-AC4CB6ADD593}" dt="2021-06-19T02:39:22.586" v="912" actId="478"/>
          <ac:picMkLst>
            <pc:docMk/>
            <pc:sldMk cId="2196489227" sldId="260"/>
            <ac:picMk id="89" creationId="{67DDFC5B-A2AE-49E1-97C4-80ED6BF0E12A}"/>
          </ac:picMkLst>
        </pc:picChg>
        <pc:picChg chg="add del mod">
          <ac:chgData name="Azadeh Dalvand" userId="0e1d96ea38aa11af" providerId="LiveId" clId="{7AEBC03C-339B-437B-BFAD-AC4CB6ADD593}" dt="2021-06-25T05:37:20.214" v="2195" actId="478"/>
          <ac:picMkLst>
            <pc:docMk/>
            <pc:sldMk cId="2196489227" sldId="260"/>
            <ac:picMk id="89" creationId="{D39D1321-13CE-4075-8B7D-29D890CECCBF}"/>
          </ac:picMkLst>
        </pc:picChg>
        <pc:picChg chg="add del mod">
          <ac:chgData name="Azadeh Dalvand" userId="0e1d96ea38aa11af" providerId="LiveId" clId="{7AEBC03C-339B-437B-BFAD-AC4CB6ADD593}" dt="2021-06-25T05:31:53.027" v="1957"/>
          <ac:picMkLst>
            <pc:docMk/>
            <pc:sldMk cId="2196489227" sldId="260"/>
            <ac:picMk id="90" creationId="{859CC92E-2C49-4B12-9B6A-20A5B26E994A}"/>
          </ac:picMkLst>
        </pc:picChg>
        <pc:picChg chg="add del mod">
          <ac:chgData name="Azadeh Dalvand" userId="0e1d96ea38aa11af" providerId="LiveId" clId="{7AEBC03C-339B-437B-BFAD-AC4CB6ADD593}" dt="2021-06-19T00:23:02.956" v="577" actId="478"/>
          <ac:picMkLst>
            <pc:docMk/>
            <pc:sldMk cId="2196489227" sldId="260"/>
            <ac:picMk id="92" creationId="{1B6DF7EB-75D4-40E8-A7F8-2881D729538C}"/>
          </ac:picMkLst>
        </pc:picChg>
        <pc:picChg chg="add del mod">
          <ac:chgData name="Azadeh Dalvand" userId="0e1d96ea38aa11af" providerId="LiveId" clId="{7AEBC03C-339B-437B-BFAD-AC4CB6ADD593}" dt="2021-07-01T05:36:26.116" v="2507" actId="478"/>
          <ac:picMkLst>
            <pc:docMk/>
            <pc:sldMk cId="2196489227" sldId="260"/>
            <ac:picMk id="92" creationId="{492E5D75-2746-4B22-8D61-DF474BAB641F}"/>
          </ac:picMkLst>
        </pc:picChg>
        <pc:picChg chg="add del mod">
          <ac:chgData name="Azadeh Dalvand" userId="0e1d96ea38aa11af" providerId="LiveId" clId="{7AEBC03C-339B-437B-BFAD-AC4CB6ADD593}" dt="2021-06-25T05:37:18.358" v="2194" actId="478"/>
          <ac:picMkLst>
            <pc:docMk/>
            <pc:sldMk cId="2196489227" sldId="260"/>
            <ac:picMk id="92" creationId="{F8DF5534-16B1-42DE-8630-9B0894891943}"/>
          </ac:picMkLst>
        </pc:picChg>
        <pc:picChg chg="add del mod">
          <ac:chgData name="Azadeh Dalvand" userId="0e1d96ea38aa11af" providerId="LiveId" clId="{7AEBC03C-339B-437B-BFAD-AC4CB6ADD593}" dt="2021-06-19T02:39:35.081" v="916" actId="478"/>
          <ac:picMkLst>
            <pc:docMk/>
            <pc:sldMk cId="2196489227" sldId="260"/>
            <ac:picMk id="93" creationId="{F4ECEAA5-FE4B-476E-8EBE-632253CCD437}"/>
          </ac:picMkLst>
        </pc:picChg>
        <pc:picChg chg="add mod">
          <ac:chgData name="Azadeh Dalvand" userId="0e1d96ea38aa11af" providerId="LiveId" clId="{7AEBC03C-339B-437B-BFAD-AC4CB6ADD593}" dt="2021-06-23T22:04:05.652" v="1843" actId="1038"/>
          <ac:picMkLst>
            <pc:docMk/>
            <pc:sldMk cId="2196489227" sldId="260"/>
            <ac:picMk id="95" creationId="{F278BFC9-51BD-4A01-88CC-B085DD2A0ACF}"/>
          </ac:picMkLst>
        </pc:picChg>
        <pc:picChg chg="add mod">
          <ac:chgData name="Azadeh Dalvand" userId="0e1d96ea38aa11af" providerId="LiveId" clId="{7AEBC03C-339B-437B-BFAD-AC4CB6ADD593}" dt="2021-06-23T22:06:12.091" v="1858" actId="1038"/>
          <ac:picMkLst>
            <pc:docMk/>
            <pc:sldMk cId="2196489227" sldId="260"/>
            <ac:picMk id="97" creationId="{FD27C4AD-8491-43F7-A155-339D52F24907}"/>
          </ac:picMkLst>
        </pc:picChg>
        <pc:picChg chg="add del mod">
          <ac:chgData name="Azadeh Dalvand" userId="0e1d96ea38aa11af" providerId="LiveId" clId="{7AEBC03C-339B-437B-BFAD-AC4CB6ADD593}" dt="2021-06-25T05:39:12.817" v="2203" actId="478"/>
          <ac:picMkLst>
            <pc:docMk/>
            <pc:sldMk cId="2196489227" sldId="260"/>
            <ac:picMk id="98" creationId="{E396F3E6-0BDF-485A-96F6-FBC1B28F80C6}"/>
          </ac:picMkLst>
        </pc:picChg>
        <pc:picChg chg="add del mod">
          <ac:chgData name="Azadeh Dalvand" userId="0e1d96ea38aa11af" providerId="LiveId" clId="{7AEBC03C-339B-437B-BFAD-AC4CB6ADD593}" dt="2021-06-25T05:39:12.817" v="2203" actId="478"/>
          <ac:picMkLst>
            <pc:docMk/>
            <pc:sldMk cId="2196489227" sldId="260"/>
            <ac:picMk id="100" creationId="{9B97086C-972B-4E12-A3AC-7CF502E7E12B}"/>
          </ac:picMkLst>
        </pc:picChg>
        <pc:picChg chg="add del mod">
          <ac:chgData name="Azadeh Dalvand" userId="0e1d96ea38aa11af" providerId="LiveId" clId="{7AEBC03C-339B-437B-BFAD-AC4CB6ADD593}" dt="2021-06-25T05:39:12.817" v="2203" actId="478"/>
          <ac:picMkLst>
            <pc:docMk/>
            <pc:sldMk cId="2196489227" sldId="260"/>
            <ac:picMk id="102" creationId="{2FEC04E3-CB45-4DD3-8992-C8274A2A5B25}"/>
          </ac:picMkLst>
        </pc:picChg>
        <pc:picChg chg="add del mod">
          <ac:chgData name="Azadeh Dalvand" userId="0e1d96ea38aa11af" providerId="LiveId" clId="{7AEBC03C-339B-437B-BFAD-AC4CB6ADD593}" dt="2021-06-25T05:39:12.817" v="2203" actId="478"/>
          <ac:picMkLst>
            <pc:docMk/>
            <pc:sldMk cId="2196489227" sldId="260"/>
            <ac:picMk id="104" creationId="{2BDCB89F-A912-4849-A82E-4DCA2802A311}"/>
          </ac:picMkLst>
        </pc:picChg>
        <pc:picChg chg="add del mod">
          <ac:chgData name="Azadeh Dalvand" userId="0e1d96ea38aa11af" providerId="LiveId" clId="{7AEBC03C-339B-437B-BFAD-AC4CB6ADD593}" dt="2021-06-19T02:44:40.257" v="1089" actId="478"/>
          <ac:picMkLst>
            <pc:docMk/>
            <pc:sldMk cId="2196489227" sldId="260"/>
            <ac:picMk id="108" creationId="{38E72D70-9A31-4C53-BA52-1F8C8E6642CE}"/>
          </ac:picMkLst>
        </pc:picChg>
        <pc:picChg chg="add del mod">
          <ac:chgData name="Azadeh Dalvand" userId="0e1d96ea38aa11af" providerId="LiveId" clId="{7AEBC03C-339B-437B-BFAD-AC4CB6ADD593}" dt="2021-06-25T05:39:12.817" v="2203" actId="478"/>
          <ac:picMkLst>
            <pc:docMk/>
            <pc:sldMk cId="2196489227" sldId="260"/>
            <ac:picMk id="112" creationId="{74626BC4-ACE6-464D-ABCE-8C8C35565697}"/>
          </ac:picMkLst>
        </pc:picChg>
        <pc:picChg chg="add del mod">
          <ac:chgData name="Azadeh Dalvand" userId="0e1d96ea38aa11af" providerId="LiveId" clId="{7AEBC03C-339B-437B-BFAD-AC4CB6ADD593}" dt="2021-06-30T20:35:41.537" v="2357" actId="478"/>
          <ac:picMkLst>
            <pc:docMk/>
            <pc:sldMk cId="2196489227" sldId="260"/>
            <ac:picMk id="114" creationId="{2D4370FD-B031-457C-9BC0-9D0D7D3B00E3}"/>
          </ac:picMkLst>
        </pc:picChg>
        <pc:picChg chg="add del mod">
          <ac:chgData name="Azadeh Dalvand" userId="0e1d96ea38aa11af" providerId="LiveId" clId="{7AEBC03C-339B-437B-BFAD-AC4CB6ADD593}" dt="2021-06-25T05:39:12.817" v="2203" actId="478"/>
          <ac:picMkLst>
            <pc:docMk/>
            <pc:sldMk cId="2196489227" sldId="260"/>
            <ac:picMk id="114" creationId="{67AAB96A-61D8-4409-9F14-62D1E08FDE3F}"/>
          </ac:picMkLst>
        </pc:picChg>
        <pc:picChg chg="add del mod">
          <ac:chgData name="Azadeh Dalvand" userId="0e1d96ea38aa11af" providerId="LiveId" clId="{7AEBC03C-339B-437B-BFAD-AC4CB6ADD593}" dt="2021-06-19T02:48:57.878" v="1130" actId="478"/>
          <ac:picMkLst>
            <pc:docMk/>
            <pc:sldMk cId="2196489227" sldId="260"/>
            <ac:picMk id="117" creationId="{CC1586F2-45D8-43C2-93EC-097DC72033E1}"/>
          </ac:picMkLst>
        </pc:picChg>
        <pc:picChg chg="add del mod">
          <ac:chgData name="Azadeh Dalvand" userId="0e1d96ea38aa11af" providerId="LiveId" clId="{7AEBC03C-339B-437B-BFAD-AC4CB6ADD593}" dt="2021-06-30T20:35:53.916" v="2361" actId="478"/>
          <ac:picMkLst>
            <pc:docMk/>
            <pc:sldMk cId="2196489227" sldId="260"/>
            <ac:picMk id="117" creationId="{DBF050B4-A921-4962-9352-2A963C3AFF2B}"/>
          </ac:picMkLst>
        </pc:picChg>
        <pc:picChg chg="add del mod">
          <ac:chgData name="Azadeh Dalvand" userId="0e1d96ea38aa11af" providerId="LiveId" clId="{7AEBC03C-339B-437B-BFAD-AC4CB6ADD593}" dt="2021-06-19T02:48:09.181" v="1119" actId="478"/>
          <ac:picMkLst>
            <pc:docMk/>
            <pc:sldMk cId="2196489227" sldId="260"/>
            <ac:picMk id="118" creationId="{FCD4F372-3CB7-4932-A95D-86D33885F34F}"/>
          </ac:picMkLst>
        </pc:picChg>
        <pc:picChg chg="add del mod">
          <ac:chgData name="Azadeh Dalvand" userId="0e1d96ea38aa11af" providerId="LiveId" clId="{7AEBC03C-339B-437B-BFAD-AC4CB6ADD593}" dt="2021-06-25T05:39:12.817" v="2203" actId="478"/>
          <ac:picMkLst>
            <pc:docMk/>
            <pc:sldMk cId="2196489227" sldId="260"/>
            <ac:picMk id="120" creationId="{5EF80F5F-47E1-420F-A3FD-2C5FD9E414B0}"/>
          </ac:picMkLst>
        </pc:picChg>
        <pc:picChg chg="add del mod">
          <ac:chgData name="Azadeh Dalvand" userId="0e1d96ea38aa11af" providerId="LiveId" clId="{7AEBC03C-339B-437B-BFAD-AC4CB6ADD593}" dt="2021-06-25T05:39:12.817" v="2203" actId="478"/>
          <ac:picMkLst>
            <pc:docMk/>
            <pc:sldMk cId="2196489227" sldId="260"/>
            <ac:picMk id="121" creationId="{64C14501-07BE-4375-861C-69A185469836}"/>
          </ac:picMkLst>
        </pc:picChg>
        <pc:picChg chg="add del mod">
          <ac:chgData name="Azadeh Dalvand" userId="0e1d96ea38aa11af" providerId="LiveId" clId="{7AEBC03C-339B-437B-BFAD-AC4CB6ADD593}" dt="2021-06-25T05:35:58.394" v="2071" actId="478"/>
          <ac:picMkLst>
            <pc:docMk/>
            <pc:sldMk cId="2196489227" sldId="260"/>
            <ac:picMk id="126" creationId="{8763F3DC-EF2A-4CB3-8089-CF2C17C565B1}"/>
          </ac:picMkLst>
        </pc:picChg>
        <pc:cxnChg chg="add del mod">
          <ac:chgData name="Azadeh Dalvand" userId="0e1d96ea38aa11af" providerId="LiveId" clId="{7AEBC03C-339B-437B-BFAD-AC4CB6ADD593}" dt="2021-06-19T02:21:43.940" v="670" actId="478"/>
          <ac:cxnSpMkLst>
            <pc:docMk/>
            <pc:sldMk cId="2196489227" sldId="260"/>
            <ac:cxnSpMk id="12" creationId="{D425BB2E-875B-469B-B319-26B69CD34A49}"/>
          </ac:cxnSpMkLst>
        </pc:cxnChg>
        <pc:cxnChg chg="add del mod">
          <ac:chgData name="Azadeh Dalvand" userId="0e1d96ea38aa11af" providerId="LiveId" clId="{7AEBC03C-339B-437B-BFAD-AC4CB6ADD593}" dt="2021-06-19T02:21:43.940" v="670" actId="478"/>
          <ac:cxnSpMkLst>
            <pc:docMk/>
            <pc:sldMk cId="2196489227" sldId="260"/>
            <ac:cxnSpMk id="13" creationId="{0CA82654-B6F8-4C9B-A55E-BBA7D208733A}"/>
          </ac:cxnSpMkLst>
        </pc:cxnChg>
        <pc:cxnChg chg="add del mod">
          <ac:chgData name="Azadeh Dalvand" userId="0e1d96ea38aa11af" providerId="LiveId" clId="{7AEBC03C-339B-437B-BFAD-AC4CB6ADD593}" dt="2021-06-19T02:21:43.940" v="670" actId="478"/>
          <ac:cxnSpMkLst>
            <pc:docMk/>
            <pc:sldMk cId="2196489227" sldId="260"/>
            <ac:cxnSpMk id="14" creationId="{126EA070-B2DC-4E5E-87FC-21C86A2C5336}"/>
          </ac:cxnSpMkLst>
        </pc:cxnChg>
        <pc:cxnChg chg="add del mod">
          <ac:chgData name="Azadeh Dalvand" userId="0e1d96ea38aa11af" providerId="LiveId" clId="{7AEBC03C-339B-437B-BFAD-AC4CB6ADD593}" dt="2021-06-19T02:21:43.940" v="670" actId="478"/>
          <ac:cxnSpMkLst>
            <pc:docMk/>
            <pc:sldMk cId="2196489227" sldId="260"/>
            <ac:cxnSpMk id="15" creationId="{ABEE4098-D8D5-4ECE-9060-28B2C8D1E3FD}"/>
          </ac:cxnSpMkLst>
        </pc:cxnChg>
        <pc:cxnChg chg="add del mod">
          <ac:chgData name="Azadeh Dalvand" userId="0e1d96ea38aa11af" providerId="LiveId" clId="{7AEBC03C-339B-437B-BFAD-AC4CB6ADD593}" dt="2021-06-19T02:21:43.940" v="670" actId="478"/>
          <ac:cxnSpMkLst>
            <pc:docMk/>
            <pc:sldMk cId="2196489227" sldId="260"/>
            <ac:cxnSpMk id="16" creationId="{9EDC7862-2A50-49E7-85CD-F707FC91DA8D}"/>
          </ac:cxnSpMkLst>
        </pc:cxnChg>
        <pc:cxnChg chg="add del mod">
          <ac:chgData name="Azadeh Dalvand" userId="0e1d96ea38aa11af" providerId="LiveId" clId="{7AEBC03C-339B-437B-BFAD-AC4CB6ADD593}" dt="2021-06-19T02:21:43.940" v="670" actId="478"/>
          <ac:cxnSpMkLst>
            <pc:docMk/>
            <pc:sldMk cId="2196489227" sldId="260"/>
            <ac:cxnSpMk id="17" creationId="{85D044EE-3F6B-4C14-8237-43B6CB09CFF6}"/>
          </ac:cxnSpMkLst>
        </pc:cxnChg>
        <pc:cxnChg chg="add del mod">
          <ac:chgData name="Azadeh Dalvand" userId="0e1d96ea38aa11af" providerId="LiveId" clId="{7AEBC03C-339B-437B-BFAD-AC4CB6ADD593}" dt="2021-06-19T02:21:43.940" v="670" actId="478"/>
          <ac:cxnSpMkLst>
            <pc:docMk/>
            <pc:sldMk cId="2196489227" sldId="260"/>
            <ac:cxnSpMk id="18" creationId="{E37D6EDD-8822-4204-ADA3-CA9342D44CC2}"/>
          </ac:cxnSpMkLst>
        </pc:cxnChg>
        <pc:cxnChg chg="add del mod">
          <ac:chgData name="Azadeh Dalvand" userId="0e1d96ea38aa11af" providerId="LiveId" clId="{7AEBC03C-339B-437B-BFAD-AC4CB6ADD593}" dt="2021-06-19T02:21:43.940" v="670" actId="478"/>
          <ac:cxnSpMkLst>
            <pc:docMk/>
            <pc:sldMk cId="2196489227" sldId="260"/>
            <ac:cxnSpMk id="19" creationId="{94D78933-6E36-4005-A888-635964646DD5}"/>
          </ac:cxnSpMkLst>
        </pc:cxnChg>
        <pc:cxnChg chg="add del mod">
          <ac:chgData name="Azadeh Dalvand" userId="0e1d96ea38aa11af" providerId="LiveId" clId="{7AEBC03C-339B-437B-BFAD-AC4CB6ADD593}" dt="2021-06-19T00:21:27.019" v="539" actId="478"/>
          <ac:cxnSpMkLst>
            <pc:docMk/>
            <pc:sldMk cId="2196489227" sldId="260"/>
            <ac:cxnSpMk id="89" creationId="{F75D9D56-48FF-44E5-9FBD-B975B0D3FA27}"/>
          </ac:cxnSpMkLst>
        </pc:cxnChg>
        <pc:cxnChg chg="add mod">
          <ac:chgData name="Azadeh Dalvand" userId="0e1d96ea38aa11af" providerId="LiveId" clId="{7AEBC03C-339B-437B-BFAD-AC4CB6ADD593}" dt="2021-06-23T22:04:02.919" v="1842" actId="1038"/>
          <ac:cxnSpMkLst>
            <pc:docMk/>
            <pc:sldMk cId="2196489227" sldId="260"/>
            <ac:cxnSpMk id="91" creationId="{5F1BE5C8-00AE-4292-AB65-C952A8FC6C73}"/>
          </ac:cxnSpMkLst>
        </pc:cxnChg>
        <pc:cxnChg chg="add del mod">
          <ac:chgData name="Azadeh Dalvand" userId="0e1d96ea38aa11af" providerId="LiveId" clId="{7AEBC03C-339B-437B-BFAD-AC4CB6ADD593}" dt="2021-06-19T00:23:39.564" v="580" actId="478"/>
          <ac:cxnSpMkLst>
            <pc:docMk/>
            <pc:sldMk cId="2196489227" sldId="260"/>
            <ac:cxnSpMk id="94" creationId="{5A81F3BC-C485-4DE5-A0BF-0F1878E7AFF4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4441D6-BF17-4582-8662-4856D21F5810}" type="datetimeFigureOut">
              <a:rPr lang="en-CA" smtClean="0"/>
              <a:t>2022-08-23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B52AF4-8E51-4A22-814E-E1C30B4B4FA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809410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B52AF4-8E51-4A22-814E-E1C30B4B4FAE}" type="slidenum">
              <a:rPr lang="en-CA" smtClean="0"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999390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C1F6F-3004-40DD-8E6C-ABB6061D30B4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359D1-876D-491C-B3F3-1F5C54B4F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90895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C1F6F-3004-40DD-8E6C-ABB6061D30B4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359D1-876D-491C-B3F3-1F5C54B4F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6642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C1F6F-3004-40DD-8E6C-ABB6061D30B4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359D1-876D-491C-B3F3-1F5C54B4F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18748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C1F6F-3004-40DD-8E6C-ABB6061D30B4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359D1-876D-491C-B3F3-1F5C54B4F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61256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C1F6F-3004-40DD-8E6C-ABB6061D30B4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359D1-876D-491C-B3F3-1F5C54B4F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92729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C1F6F-3004-40DD-8E6C-ABB6061D30B4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359D1-876D-491C-B3F3-1F5C54B4F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7473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C1F6F-3004-40DD-8E6C-ABB6061D30B4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359D1-876D-491C-B3F3-1F5C54B4F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35245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C1F6F-3004-40DD-8E6C-ABB6061D30B4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359D1-876D-491C-B3F3-1F5C54B4F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45425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C1F6F-3004-40DD-8E6C-ABB6061D30B4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359D1-876D-491C-B3F3-1F5C54B4F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9494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C1F6F-3004-40DD-8E6C-ABB6061D30B4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359D1-876D-491C-B3F3-1F5C54B4F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26920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BC1F6F-3004-40DD-8E6C-ABB6061D30B4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359D1-876D-491C-B3F3-1F5C54B4F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27039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BC1F6F-3004-40DD-8E6C-ABB6061D30B4}" type="datetimeFigureOut">
              <a:rPr lang="en-US" smtClean="0"/>
              <a:t>8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7359D1-876D-491C-B3F3-1F5C54B4F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1807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3" Type="http://schemas.openxmlformats.org/officeDocument/2006/relationships/image" Target="../media/image14.png"/><Relationship Id="rId7" Type="http://schemas.openxmlformats.org/officeDocument/2006/relationships/image" Target="../media/image17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11" Type="http://schemas.microsoft.com/office/2007/relationships/hdphoto" Target="../media/hdphoto2.wdp"/><Relationship Id="rId5" Type="http://schemas.openxmlformats.org/officeDocument/2006/relationships/image" Target="../media/image16.png"/><Relationship Id="rId10" Type="http://schemas.openxmlformats.org/officeDocument/2006/relationships/image" Target="../media/image20.png"/><Relationship Id="rId4" Type="http://schemas.openxmlformats.org/officeDocument/2006/relationships/image" Target="../media/image15.png"/><Relationship Id="rId9" Type="http://schemas.openxmlformats.org/officeDocument/2006/relationships/image" Target="../media/image19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3" Type="http://schemas.microsoft.com/office/2007/relationships/hdphoto" Target="../media/hdphoto3.wdp"/><Relationship Id="rId7" Type="http://schemas.openxmlformats.org/officeDocument/2006/relationships/image" Target="../media/image25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png"/><Relationship Id="rId5" Type="http://schemas.openxmlformats.org/officeDocument/2006/relationships/image" Target="../media/image23.png"/><Relationship Id="rId10" Type="http://schemas.openxmlformats.org/officeDocument/2006/relationships/image" Target="../media/image28.png"/><Relationship Id="rId4" Type="http://schemas.openxmlformats.org/officeDocument/2006/relationships/image" Target="../media/image22.png"/><Relationship Id="rId9" Type="http://schemas.openxmlformats.org/officeDocument/2006/relationships/image" Target="../media/image27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png"/><Relationship Id="rId3" Type="http://schemas.openxmlformats.org/officeDocument/2006/relationships/image" Target="../media/image30.png"/><Relationship Id="rId7" Type="http://schemas.openxmlformats.org/officeDocument/2006/relationships/image" Target="../media/image34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3.png"/><Relationship Id="rId5" Type="http://schemas.openxmlformats.org/officeDocument/2006/relationships/image" Target="../media/image32.png"/><Relationship Id="rId4" Type="http://schemas.openxmlformats.org/officeDocument/2006/relationships/image" Target="../media/image31.png"/><Relationship Id="rId9" Type="http://schemas.openxmlformats.org/officeDocument/2006/relationships/image" Target="../media/image36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png"/><Relationship Id="rId3" Type="http://schemas.openxmlformats.org/officeDocument/2006/relationships/image" Target="../media/image38.png"/><Relationship Id="rId7" Type="http://schemas.openxmlformats.org/officeDocument/2006/relationships/image" Target="../media/image36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3.png"/><Relationship Id="rId5" Type="http://schemas.openxmlformats.org/officeDocument/2006/relationships/image" Target="../media/image40.png"/><Relationship Id="rId4" Type="http://schemas.openxmlformats.org/officeDocument/2006/relationships/image" Target="../media/image39.png"/><Relationship Id="rId9" Type="http://schemas.openxmlformats.org/officeDocument/2006/relationships/image" Target="../media/image35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png"/><Relationship Id="rId3" Type="http://schemas.openxmlformats.org/officeDocument/2006/relationships/image" Target="../media/image42.png"/><Relationship Id="rId7" Type="http://schemas.openxmlformats.org/officeDocument/2006/relationships/image" Target="../media/image46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5.png"/><Relationship Id="rId5" Type="http://schemas.openxmlformats.org/officeDocument/2006/relationships/image" Target="../media/image44.png"/><Relationship Id="rId4" Type="http://schemas.openxmlformats.org/officeDocument/2006/relationships/image" Target="../media/image43.png"/><Relationship Id="rId9" Type="http://schemas.openxmlformats.org/officeDocument/2006/relationships/image" Target="../media/image48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png"/><Relationship Id="rId3" Type="http://schemas.openxmlformats.org/officeDocument/2006/relationships/image" Target="../media/image50.png"/><Relationship Id="rId7" Type="http://schemas.openxmlformats.org/officeDocument/2006/relationships/image" Target="../media/image54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3.png"/><Relationship Id="rId5" Type="http://schemas.openxmlformats.org/officeDocument/2006/relationships/image" Target="../media/image52.png"/><Relationship Id="rId10" Type="http://schemas.openxmlformats.org/officeDocument/2006/relationships/image" Target="../media/image57.png"/><Relationship Id="rId4" Type="http://schemas.openxmlformats.org/officeDocument/2006/relationships/image" Target="../media/image51.png"/><Relationship Id="rId9" Type="http://schemas.openxmlformats.org/officeDocument/2006/relationships/image" Target="../media/image5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101158-608E-4634-8166-DECB61F163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28797" y="0"/>
            <a:ext cx="6008274" cy="902741"/>
          </a:xfrm>
        </p:spPr>
        <p:txBody>
          <a:bodyPr/>
          <a:lstStyle/>
          <a:p>
            <a:r>
              <a:rPr lang="en-US" sz="28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mad</a:t>
            </a:r>
            <a:r>
              <a:rPr lang="en-US" sz="2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2/3 </a:t>
            </a:r>
            <a:r>
              <a:rPr kumimoji="0" lang="en-US" sz="2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 E9-E13    1 to 1000   7sec </a:t>
            </a:r>
            <a:endParaRPr lang="en-CA" dirty="0"/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50695052-91E8-4646-AC41-D1BF7D27047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1488133" y="5163877"/>
            <a:ext cx="3895956" cy="644380"/>
          </a:xfr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D42C71C-6D86-4A92-B9C0-579B24E319F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88131" y="1261047"/>
            <a:ext cx="3895956" cy="2175824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DD048576-0559-482C-B1B2-396EE3D6A3A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527530" y="5154920"/>
            <a:ext cx="1930400" cy="63542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C4921E04-C8EA-4F0F-A36E-3871CF4C786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527530" y="1253177"/>
            <a:ext cx="2010814" cy="2175824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1A7FDD41-5AD8-432A-80B5-2E1DE161D9E8}"/>
              </a:ext>
            </a:extLst>
          </p:cNvPr>
          <p:cNvSpPr/>
          <p:nvPr/>
        </p:nvSpPr>
        <p:spPr>
          <a:xfrm>
            <a:off x="1488131" y="1253176"/>
            <a:ext cx="3895956" cy="2175824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CA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B8272534-EAE2-4083-9DE8-A4ECB6BC7A15}"/>
              </a:ext>
            </a:extLst>
          </p:cNvPr>
          <p:cNvSpPr/>
          <p:nvPr/>
        </p:nvSpPr>
        <p:spPr>
          <a:xfrm>
            <a:off x="5527530" y="1253589"/>
            <a:ext cx="2010814" cy="2175824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CA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2E036298-33EF-4F8F-A579-0C47AFABD29B}"/>
              </a:ext>
            </a:extLst>
          </p:cNvPr>
          <p:cNvSpPr/>
          <p:nvPr/>
        </p:nvSpPr>
        <p:spPr>
          <a:xfrm>
            <a:off x="1488132" y="5154920"/>
            <a:ext cx="3895956" cy="653338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CA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D51675A5-6720-4D1F-9C9B-F0A20EFC81B0}"/>
              </a:ext>
            </a:extLst>
          </p:cNvPr>
          <p:cNvSpPr/>
          <p:nvPr/>
        </p:nvSpPr>
        <p:spPr>
          <a:xfrm>
            <a:off x="5509952" y="5137005"/>
            <a:ext cx="1947978" cy="653338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CA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BC6B9CC-8CF5-4880-ABA7-97347B588088}"/>
              </a:ext>
            </a:extLst>
          </p:cNvPr>
          <p:cNvSpPr txBox="1"/>
          <p:nvPr/>
        </p:nvSpPr>
        <p:spPr>
          <a:xfrm>
            <a:off x="-86442" y="5090901"/>
            <a:ext cx="1669356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Smad2     60 </a:t>
            </a:r>
            <a:r>
              <a:rPr kumimoji="0" lang="en-US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KDa</a:t>
            </a:r>
            <a:endParaRPr kumimoji="0" 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Smad3     52 </a:t>
            </a:r>
            <a:r>
              <a:rPr kumimoji="0" lang="en-US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KDa</a:t>
            </a:r>
            <a:endParaRPr kumimoji="0" lang="en-CA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8B7CB03-B8CF-4F7A-9609-09B5F237924D}"/>
              </a:ext>
            </a:extLst>
          </p:cNvPr>
          <p:cNvSpPr txBox="1"/>
          <p:nvPr/>
        </p:nvSpPr>
        <p:spPr>
          <a:xfrm>
            <a:off x="1043664" y="1253176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250</a:t>
            </a:r>
            <a:endParaRPr kumimoji="0" lang="en-CA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9D7AF4D-7265-4EF4-8660-1A7BDEBCD5F4}"/>
              </a:ext>
            </a:extLst>
          </p:cNvPr>
          <p:cNvSpPr txBox="1"/>
          <p:nvPr/>
        </p:nvSpPr>
        <p:spPr>
          <a:xfrm>
            <a:off x="1043664" y="1653056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00</a:t>
            </a:r>
            <a:endParaRPr kumimoji="0" lang="en-CA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01969E8-0868-4C62-9813-771E2E23592D}"/>
              </a:ext>
            </a:extLst>
          </p:cNvPr>
          <p:cNvSpPr txBox="1"/>
          <p:nvPr/>
        </p:nvSpPr>
        <p:spPr>
          <a:xfrm>
            <a:off x="1071039" y="2012165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75</a:t>
            </a:r>
            <a:endParaRPr kumimoji="0" lang="en-CA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A6BF002-B519-4C6A-A3BF-DDF5701745B2}"/>
              </a:ext>
            </a:extLst>
          </p:cNvPr>
          <p:cNvSpPr txBox="1"/>
          <p:nvPr/>
        </p:nvSpPr>
        <p:spPr>
          <a:xfrm>
            <a:off x="1077856" y="2691466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50</a:t>
            </a:r>
            <a:endParaRPr kumimoji="0" lang="en-CA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97A8977-E2AF-4CD5-91BE-3CD0693E49A3}"/>
              </a:ext>
            </a:extLst>
          </p:cNvPr>
          <p:cNvSpPr txBox="1"/>
          <p:nvPr/>
        </p:nvSpPr>
        <p:spPr>
          <a:xfrm>
            <a:off x="1008835" y="1376287"/>
            <a:ext cx="46296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50</a:t>
            </a:r>
            <a:endParaRPr kumimoji="0" lang="en-CA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5253F7C-2696-4034-93FE-D9364CC79026}"/>
              </a:ext>
            </a:extLst>
          </p:cNvPr>
          <p:cNvSpPr txBox="1"/>
          <p:nvPr/>
        </p:nvSpPr>
        <p:spPr>
          <a:xfrm>
            <a:off x="1534371" y="1023909"/>
            <a:ext cx="79169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L       N1   N2   N3    N1  N2  N3    N1  N2  N3  N1  N2  N3    C  TGF. C       L    N1    </a:t>
            </a:r>
            <a:r>
              <a:rPr kumimoji="0" lang="en-US" sz="10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N1</a:t>
            </a: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 N2   N3   N4    C  TGF.C      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6772F0B-811E-4D14-8743-9E77E5D50D24}"/>
              </a:ext>
            </a:extLst>
          </p:cNvPr>
          <p:cNvSpPr txBox="1"/>
          <p:nvPr/>
        </p:nvSpPr>
        <p:spPr>
          <a:xfrm>
            <a:off x="1884648" y="629365"/>
            <a:ext cx="709478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  </a:t>
            </a:r>
            <a:r>
              <a: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E9       E10       E11        E12          C           E12       E13          C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9736C383-7CCF-4F98-BBEB-93934B3B6F94}"/>
              </a:ext>
            </a:extLst>
          </p:cNvPr>
          <p:cNvCxnSpPr>
            <a:cxnSpLocks/>
          </p:cNvCxnSpPr>
          <p:nvPr/>
        </p:nvCxnSpPr>
        <p:spPr>
          <a:xfrm>
            <a:off x="1949822" y="1003670"/>
            <a:ext cx="716537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4F92B867-7061-4CCD-AE79-C607E3D30289}"/>
              </a:ext>
            </a:extLst>
          </p:cNvPr>
          <p:cNvCxnSpPr>
            <a:cxnSpLocks/>
          </p:cNvCxnSpPr>
          <p:nvPr/>
        </p:nvCxnSpPr>
        <p:spPr>
          <a:xfrm>
            <a:off x="2721405" y="998697"/>
            <a:ext cx="536627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FA46113D-700B-4E63-8018-4B7A7FD035A6}"/>
              </a:ext>
            </a:extLst>
          </p:cNvPr>
          <p:cNvCxnSpPr>
            <a:cxnSpLocks/>
          </p:cNvCxnSpPr>
          <p:nvPr/>
        </p:nvCxnSpPr>
        <p:spPr>
          <a:xfrm>
            <a:off x="3388636" y="998697"/>
            <a:ext cx="614747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46D04D20-B719-410B-93C5-29EE6FC757F8}"/>
              </a:ext>
            </a:extLst>
          </p:cNvPr>
          <p:cNvCxnSpPr>
            <a:cxnSpLocks/>
          </p:cNvCxnSpPr>
          <p:nvPr/>
        </p:nvCxnSpPr>
        <p:spPr>
          <a:xfrm>
            <a:off x="4071235" y="998697"/>
            <a:ext cx="6083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62071802-D1D3-4CCB-BB23-24A53108A76E}"/>
              </a:ext>
            </a:extLst>
          </p:cNvPr>
          <p:cNvCxnSpPr>
            <a:cxnSpLocks/>
          </p:cNvCxnSpPr>
          <p:nvPr/>
        </p:nvCxnSpPr>
        <p:spPr>
          <a:xfrm>
            <a:off x="4785852" y="998697"/>
            <a:ext cx="59823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E5E288C2-BE9E-4E41-935C-6FD5527A88B3}"/>
              </a:ext>
            </a:extLst>
          </p:cNvPr>
          <p:cNvCxnSpPr>
            <a:cxnSpLocks/>
          </p:cNvCxnSpPr>
          <p:nvPr/>
        </p:nvCxnSpPr>
        <p:spPr>
          <a:xfrm>
            <a:off x="6069391" y="1039050"/>
            <a:ext cx="94613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8EC2BE84-66B0-4D78-ADB1-528CA33D3F36}"/>
              </a:ext>
            </a:extLst>
          </p:cNvPr>
          <p:cNvCxnSpPr>
            <a:cxnSpLocks/>
          </p:cNvCxnSpPr>
          <p:nvPr/>
        </p:nvCxnSpPr>
        <p:spPr>
          <a:xfrm>
            <a:off x="5786079" y="1039050"/>
            <a:ext cx="21715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84D4B6C1-1819-469B-8D6E-666F6074BBA0}"/>
              </a:ext>
            </a:extLst>
          </p:cNvPr>
          <p:cNvCxnSpPr>
            <a:cxnSpLocks/>
          </p:cNvCxnSpPr>
          <p:nvPr/>
        </p:nvCxnSpPr>
        <p:spPr>
          <a:xfrm>
            <a:off x="7074719" y="1037542"/>
            <a:ext cx="570896" cy="1508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36D27AA-1C84-4E04-A76D-AD61E5D9462D}"/>
              </a:ext>
            </a:extLst>
          </p:cNvPr>
          <p:cNvSpPr txBox="1"/>
          <p:nvPr/>
        </p:nvSpPr>
        <p:spPr>
          <a:xfrm>
            <a:off x="1534371" y="4868963"/>
            <a:ext cx="1083706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N1  N2  N3  N1 N2 N3    N1  N2  N3  N1  N2  N3  C  TGF. C     N1   </a:t>
            </a:r>
            <a:r>
              <a:rPr kumimoji="0" lang="en-US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N1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 N2  N3  N4  C  TGF.C      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BCCB2466-8C6D-4F84-9242-69AF04916B21}"/>
              </a:ext>
            </a:extLst>
          </p:cNvPr>
          <p:cNvSpPr txBox="1"/>
          <p:nvPr/>
        </p:nvSpPr>
        <p:spPr>
          <a:xfrm>
            <a:off x="1749524" y="4492616"/>
            <a:ext cx="638159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E9        E10         E11         E12         C         E12      E13               C</a:t>
            </a:r>
            <a:endParaRPr kumimoji="0" lang="en-CA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2148FF72-09BE-46B8-A27C-1B22F171842B}"/>
              </a:ext>
            </a:extLst>
          </p:cNvPr>
          <p:cNvCxnSpPr>
            <a:cxnSpLocks/>
          </p:cNvCxnSpPr>
          <p:nvPr/>
        </p:nvCxnSpPr>
        <p:spPr>
          <a:xfrm>
            <a:off x="1629794" y="4831170"/>
            <a:ext cx="716537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57727088-1A67-4B09-B065-C6A7F8D4C232}"/>
              </a:ext>
            </a:extLst>
          </p:cNvPr>
          <p:cNvCxnSpPr>
            <a:cxnSpLocks/>
          </p:cNvCxnSpPr>
          <p:nvPr/>
        </p:nvCxnSpPr>
        <p:spPr>
          <a:xfrm>
            <a:off x="2367436" y="4831170"/>
            <a:ext cx="716537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9DD05A4C-905C-4568-B5B9-72CBA009880F}"/>
              </a:ext>
            </a:extLst>
          </p:cNvPr>
          <p:cNvCxnSpPr>
            <a:cxnSpLocks/>
          </p:cNvCxnSpPr>
          <p:nvPr/>
        </p:nvCxnSpPr>
        <p:spPr>
          <a:xfrm>
            <a:off x="3180688" y="4831170"/>
            <a:ext cx="716537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D3CD59E2-4A4B-4673-A307-CAA5470EF467}"/>
              </a:ext>
            </a:extLst>
          </p:cNvPr>
          <p:cNvCxnSpPr>
            <a:cxnSpLocks/>
          </p:cNvCxnSpPr>
          <p:nvPr/>
        </p:nvCxnSpPr>
        <p:spPr>
          <a:xfrm>
            <a:off x="3963041" y="4831170"/>
            <a:ext cx="716537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A7DF2DE2-627A-4B98-BF97-AE40839CF1C4}"/>
              </a:ext>
            </a:extLst>
          </p:cNvPr>
          <p:cNvCxnSpPr>
            <a:cxnSpLocks/>
          </p:cNvCxnSpPr>
          <p:nvPr/>
        </p:nvCxnSpPr>
        <p:spPr>
          <a:xfrm>
            <a:off x="4715504" y="4827804"/>
            <a:ext cx="716537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C74A2510-7071-487F-B079-5FB24AD002A2}"/>
              </a:ext>
            </a:extLst>
          </p:cNvPr>
          <p:cNvCxnSpPr>
            <a:cxnSpLocks/>
          </p:cNvCxnSpPr>
          <p:nvPr/>
        </p:nvCxnSpPr>
        <p:spPr>
          <a:xfrm>
            <a:off x="5492865" y="4827804"/>
            <a:ext cx="401791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4D3CD68A-C9B3-4248-A258-25CEB73152B0}"/>
              </a:ext>
            </a:extLst>
          </p:cNvPr>
          <p:cNvCxnSpPr>
            <a:cxnSpLocks/>
          </p:cNvCxnSpPr>
          <p:nvPr/>
        </p:nvCxnSpPr>
        <p:spPr>
          <a:xfrm>
            <a:off x="5946660" y="4827804"/>
            <a:ext cx="930552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9DB60CDF-11FC-4081-8EDD-F16076AC91EA}"/>
              </a:ext>
            </a:extLst>
          </p:cNvPr>
          <p:cNvCxnSpPr>
            <a:cxnSpLocks/>
          </p:cNvCxnSpPr>
          <p:nvPr/>
        </p:nvCxnSpPr>
        <p:spPr>
          <a:xfrm>
            <a:off x="6946170" y="4824438"/>
            <a:ext cx="716537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8" name="Picture 7">
            <a:extLst>
              <a:ext uri="{FF2B5EF4-FFF2-40B4-BE49-F238E27FC236}">
                <a16:creationId xmlns:a16="http://schemas.microsoft.com/office/drawing/2014/main" id="{E32DD423-8126-4CB1-AE52-69435F070E9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488131" y="3525098"/>
            <a:ext cx="3895956" cy="845886"/>
          </a:xfrm>
          <a:prstGeom prst="rect">
            <a:avLst/>
          </a:prstGeom>
        </p:spPr>
      </p:pic>
      <p:sp>
        <p:nvSpPr>
          <p:cNvPr id="42" name="Rectangle 41">
            <a:extLst>
              <a:ext uri="{FF2B5EF4-FFF2-40B4-BE49-F238E27FC236}">
                <a16:creationId xmlns:a16="http://schemas.microsoft.com/office/drawing/2014/main" id="{3DE36102-9F8B-48A2-A467-3B501E8321C3}"/>
              </a:ext>
            </a:extLst>
          </p:cNvPr>
          <p:cNvSpPr/>
          <p:nvPr/>
        </p:nvSpPr>
        <p:spPr>
          <a:xfrm>
            <a:off x="1492749" y="3542880"/>
            <a:ext cx="3891338" cy="845883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CA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854D3DF1-9BFA-40F5-AC7E-D6A51A117E93}"/>
              </a:ext>
            </a:extLst>
          </p:cNvPr>
          <p:cNvSpPr txBox="1"/>
          <p:nvPr/>
        </p:nvSpPr>
        <p:spPr>
          <a:xfrm>
            <a:off x="1130514" y="3484238"/>
            <a:ext cx="638159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50</a:t>
            </a:r>
            <a:endParaRPr kumimoji="0" lang="en-CA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E58B0442-19AC-42EA-BDBF-B3C054F3866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488132" y="5971249"/>
            <a:ext cx="3895956" cy="483317"/>
          </a:xfrm>
          <a:prstGeom prst="rect">
            <a:avLst/>
          </a:prstGeom>
        </p:spPr>
      </p:pic>
      <p:sp>
        <p:nvSpPr>
          <p:cNvPr id="46" name="Rectangle 45">
            <a:extLst>
              <a:ext uri="{FF2B5EF4-FFF2-40B4-BE49-F238E27FC236}">
                <a16:creationId xmlns:a16="http://schemas.microsoft.com/office/drawing/2014/main" id="{3796ACF3-027B-43A3-B89F-95BD0D1D731A}"/>
              </a:ext>
            </a:extLst>
          </p:cNvPr>
          <p:cNvSpPr/>
          <p:nvPr/>
        </p:nvSpPr>
        <p:spPr>
          <a:xfrm>
            <a:off x="1471798" y="5936508"/>
            <a:ext cx="3895956" cy="508340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CA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D2529873-6481-4C40-A910-C8DF9676590F}"/>
              </a:ext>
            </a:extLst>
          </p:cNvPr>
          <p:cNvSpPr txBox="1"/>
          <p:nvPr/>
        </p:nvSpPr>
        <p:spPr>
          <a:xfrm>
            <a:off x="-10107" y="5905130"/>
            <a:ext cx="638159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actin</a:t>
            </a: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42 </a:t>
            </a:r>
            <a:r>
              <a:rPr kumimoji="0" lang="en-US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KDa</a:t>
            </a:r>
            <a:endParaRPr kumimoji="0" lang="en-CA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C17C8D97-37CC-4956-9481-0E3589D71E5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505718" y="5946195"/>
            <a:ext cx="2040672" cy="483317"/>
          </a:xfrm>
          <a:prstGeom prst="rect">
            <a:avLst/>
          </a:prstGeom>
        </p:spPr>
      </p:pic>
      <p:sp>
        <p:nvSpPr>
          <p:cNvPr id="58" name="Rectangle 57">
            <a:extLst>
              <a:ext uri="{FF2B5EF4-FFF2-40B4-BE49-F238E27FC236}">
                <a16:creationId xmlns:a16="http://schemas.microsoft.com/office/drawing/2014/main" id="{8B621376-5ED6-4667-B0B7-76E7FB293EE4}"/>
              </a:ext>
            </a:extLst>
          </p:cNvPr>
          <p:cNvSpPr/>
          <p:nvPr/>
        </p:nvSpPr>
        <p:spPr>
          <a:xfrm>
            <a:off x="5518740" y="5946195"/>
            <a:ext cx="1993363" cy="483317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CA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1919CBFD-EB2B-43BA-A017-7CA7F86F615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527530" y="3541085"/>
            <a:ext cx="2025753" cy="766704"/>
          </a:xfrm>
          <a:prstGeom prst="rect">
            <a:avLst/>
          </a:prstGeom>
        </p:spPr>
      </p:pic>
      <p:sp>
        <p:nvSpPr>
          <p:cNvPr id="60" name="Rectangle 59">
            <a:extLst>
              <a:ext uri="{FF2B5EF4-FFF2-40B4-BE49-F238E27FC236}">
                <a16:creationId xmlns:a16="http://schemas.microsoft.com/office/drawing/2014/main" id="{A64A9346-9895-42E8-BA34-EC66C8FA1A37}"/>
              </a:ext>
            </a:extLst>
          </p:cNvPr>
          <p:cNvSpPr/>
          <p:nvPr/>
        </p:nvSpPr>
        <p:spPr>
          <a:xfrm>
            <a:off x="5505367" y="3529944"/>
            <a:ext cx="2047915" cy="777844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CA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3311399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800" dirty="0" smtClean="0"/>
              <a:t>P-Smad2 &amp; P-Smad3/ Only E12-E13</a:t>
            </a:r>
            <a:endParaRPr lang="en-US" sz="2800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26280" y="2887579"/>
            <a:ext cx="781472" cy="2614924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93741" y="2887579"/>
            <a:ext cx="864191" cy="261492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26872" y="4774131"/>
            <a:ext cx="10134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-Smad2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2035885" y="2579802"/>
            <a:ext cx="9621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L  E12 E13 </a:t>
            </a:r>
            <a:endParaRPr lang="en-US" sz="1400" b="1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96001" y="2887579"/>
            <a:ext cx="1002262" cy="2614924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5042506" y="4322364"/>
            <a:ext cx="101341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dirty="0" smtClean="0">
                <a:solidFill>
                  <a:prstClr val="black"/>
                </a:solidFill>
              </a:rPr>
              <a:t>P-Smad3</a:t>
            </a:r>
            <a:endParaRPr lang="en-US" dirty="0">
              <a:solidFill>
                <a:prstClr val="black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7127649" y="2579802"/>
            <a:ext cx="112402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US" sz="1200" b="1" dirty="0">
                <a:solidFill>
                  <a:prstClr val="black"/>
                </a:solidFill>
              </a:rPr>
              <a:t>L  </a:t>
            </a:r>
            <a:r>
              <a:rPr lang="en-US" sz="1200" b="1" dirty="0" smtClean="0">
                <a:solidFill>
                  <a:prstClr val="black"/>
                </a:solidFill>
              </a:rPr>
              <a:t>E11 E12 </a:t>
            </a:r>
            <a:r>
              <a:rPr lang="en-US" sz="1200" b="1" dirty="0">
                <a:solidFill>
                  <a:prstClr val="black"/>
                </a:solidFill>
              </a:rPr>
              <a:t>E13 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220026" y="2892155"/>
            <a:ext cx="939272" cy="26103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864926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885600" y="64472"/>
            <a:ext cx="5978769" cy="562338"/>
          </a:xfrm>
        </p:spPr>
        <p:txBody>
          <a:bodyPr>
            <a:normAutofit/>
          </a:bodyPr>
          <a:lstStyle/>
          <a:p>
            <a:r>
              <a:rPr lang="en-US" sz="2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catenin</a:t>
            </a:r>
            <a:r>
              <a:rPr lang="en-US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9-E13   1 to 2000 0.7sec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519530" y="1384593"/>
            <a:ext cx="4355455" cy="1668047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19530" y="5116130"/>
            <a:ext cx="4355455" cy="376219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95305" y="1393384"/>
            <a:ext cx="1316879" cy="1668047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999462" y="5095846"/>
            <a:ext cx="1239828" cy="472044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513222" y="3052640"/>
            <a:ext cx="4361763" cy="1399843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489251" y="5707982"/>
            <a:ext cx="4361763" cy="516774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995305" y="5701451"/>
            <a:ext cx="1243985" cy="519184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993820" y="3052640"/>
            <a:ext cx="1318364" cy="1210375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>
            <a:off x="1513222" y="1112532"/>
            <a:ext cx="66030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     N1   N2    N3     N1   N2    N3    N1    N2    N3     N1  N2  N3         N1   N2             L     N2   N3    N4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</a:t>
            </a:r>
          </a:p>
        </p:txBody>
      </p:sp>
      <p:cxnSp>
        <p:nvCxnSpPr>
          <p:cNvPr id="21" name="Straight Connector 20"/>
          <p:cNvCxnSpPr/>
          <p:nvPr/>
        </p:nvCxnSpPr>
        <p:spPr>
          <a:xfrm flipV="1">
            <a:off x="1847329" y="1080298"/>
            <a:ext cx="706316" cy="371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4357318" y="1090002"/>
            <a:ext cx="689472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3532522" y="1080298"/>
            <a:ext cx="766916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2641567" y="1078161"/>
            <a:ext cx="83139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6078541" y="1090837"/>
            <a:ext cx="1009004" cy="371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5300946" y="1083905"/>
            <a:ext cx="425047" cy="6097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2046557" y="800902"/>
            <a:ext cx="48010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9             E10            E11            E12            E13               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13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Straight Connector 34"/>
          <p:cNvCxnSpPr/>
          <p:nvPr/>
        </p:nvCxnSpPr>
        <p:spPr>
          <a:xfrm flipV="1">
            <a:off x="1702051" y="4779117"/>
            <a:ext cx="768587" cy="371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>
            <a:off x="4373807" y="4785752"/>
            <a:ext cx="81365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3472960" y="4779117"/>
            <a:ext cx="82647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>
            <a:off x="2553645" y="4779117"/>
            <a:ext cx="81380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 flipV="1">
            <a:off x="6078541" y="4782836"/>
            <a:ext cx="1160749" cy="8613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5313610" y="4785752"/>
            <a:ext cx="56137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1847329" y="4477975"/>
            <a:ext cx="58019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9                 E10             E11              E12          E13               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13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1581818" y="4816530"/>
            <a:ext cx="57305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1     N2    N3    N1     N2     N3     N1    N2    N3     N1    N2     N3     N1   N2            </a:t>
            </a:r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2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N3       N4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36D9CF4-D342-4BFF-AC89-80EC65016143}"/>
              </a:ext>
            </a:extLst>
          </p:cNvPr>
          <p:cNvSpPr txBox="1"/>
          <p:nvPr/>
        </p:nvSpPr>
        <p:spPr>
          <a:xfrm>
            <a:off x="1089344" y="1469947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AE54A97-B4BA-4894-A970-E068148D4583}"/>
              </a:ext>
            </a:extLst>
          </p:cNvPr>
          <p:cNvSpPr txBox="1"/>
          <p:nvPr/>
        </p:nvSpPr>
        <p:spPr>
          <a:xfrm>
            <a:off x="1089344" y="1647871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D5EA467-12CF-4B9E-803D-489BA014C4CA}"/>
              </a:ext>
            </a:extLst>
          </p:cNvPr>
          <p:cNvSpPr txBox="1"/>
          <p:nvPr/>
        </p:nvSpPr>
        <p:spPr>
          <a:xfrm>
            <a:off x="1089344" y="1964294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D86ABFB-EE6C-4964-8B40-051C8D9DA0FF}"/>
              </a:ext>
            </a:extLst>
          </p:cNvPr>
          <p:cNvSpPr txBox="1"/>
          <p:nvPr/>
        </p:nvSpPr>
        <p:spPr>
          <a:xfrm>
            <a:off x="1129256" y="2400943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B98DCDC-94F0-43E9-A133-DDDF63D41819}"/>
              </a:ext>
            </a:extLst>
          </p:cNvPr>
          <p:cNvSpPr txBox="1"/>
          <p:nvPr/>
        </p:nvSpPr>
        <p:spPr>
          <a:xfrm>
            <a:off x="724930" y="207705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4</a:t>
            </a:r>
            <a:endParaRPr lang="en-CA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13941D91-668E-4483-B4DD-23E3637E11F4}"/>
              </a:ext>
            </a:extLst>
          </p:cNvPr>
          <p:cNvSpPr txBox="1"/>
          <p:nvPr/>
        </p:nvSpPr>
        <p:spPr>
          <a:xfrm>
            <a:off x="1136196" y="292293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2390E877-ECE8-459D-8090-B268B01CF51D}"/>
              </a:ext>
            </a:extLst>
          </p:cNvPr>
          <p:cNvCxnSpPr>
            <a:cxnSpLocks/>
          </p:cNvCxnSpPr>
          <p:nvPr/>
        </p:nvCxnSpPr>
        <p:spPr>
          <a:xfrm>
            <a:off x="1017451" y="2241293"/>
            <a:ext cx="829878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3" name="Rectangle 2"/>
          <p:cNvSpPr/>
          <p:nvPr/>
        </p:nvSpPr>
        <p:spPr>
          <a:xfrm>
            <a:off x="22108" y="5150350"/>
            <a:ext cx="14911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catenin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94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CA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0" y="5701451"/>
            <a:ext cx="13115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ctin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42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CA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6B838194-27C9-404F-AB6C-0694590B45FE}"/>
              </a:ext>
            </a:extLst>
          </p:cNvPr>
          <p:cNvSpPr/>
          <p:nvPr/>
        </p:nvSpPr>
        <p:spPr>
          <a:xfrm>
            <a:off x="1521602" y="1387567"/>
            <a:ext cx="4353383" cy="3056714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6B838194-27C9-404F-AB6C-0694590B45FE}"/>
              </a:ext>
            </a:extLst>
          </p:cNvPr>
          <p:cNvSpPr/>
          <p:nvPr/>
        </p:nvSpPr>
        <p:spPr>
          <a:xfrm>
            <a:off x="5993821" y="1398613"/>
            <a:ext cx="1318364" cy="2864401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6B838194-27C9-404F-AB6C-0694590B45FE}"/>
              </a:ext>
            </a:extLst>
          </p:cNvPr>
          <p:cNvSpPr/>
          <p:nvPr/>
        </p:nvSpPr>
        <p:spPr>
          <a:xfrm>
            <a:off x="1521602" y="5707982"/>
            <a:ext cx="4336037" cy="503105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6B838194-27C9-404F-AB6C-0694590B45FE}"/>
              </a:ext>
            </a:extLst>
          </p:cNvPr>
          <p:cNvSpPr/>
          <p:nvPr/>
        </p:nvSpPr>
        <p:spPr>
          <a:xfrm>
            <a:off x="1521602" y="5137005"/>
            <a:ext cx="4353383" cy="377945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6B838194-27C9-404F-AB6C-0694590B45FE}"/>
              </a:ext>
            </a:extLst>
          </p:cNvPr>
          <p:cNvSpPr/>
          <p:nvPr/>
        </p:nvSpPr>
        <p:spPr>
          <a:xfrm>
            <a:off x="5993821" y="5090143"/>
            <a:ext cx="1245470" cy="477747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6B838194-27C9-404F-AB6C-0694590B45FE}"/>
              </a:ext>
            </a:extLst>
          </p:cNvPr>
          <p:cNvSpPr/>
          <p:nvPr/>
        </p:nvSpPr>
        <p:spPr>
          <a:xfrm>
            <a:off x="5993821" y="5707982"/>
            <a:ext cx="1245470" cy="510243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962777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826733" y="970"/>
            <a:ext cx="5985002" cy="811604"/>
          </a:xfrm>
        </p:spPr>
        <p:txBody>
          <a:bodyPr>
            <a:norm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H8 E9-E13    1 to 1000   10sec  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554579" y="1393554"/>
            <a:ext cx="3966514" cy="153855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54579" y="4719994"/>
            <a:ext cx="3966514" cy="35375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636123" y="4719994"/>
            <a:ext cx="1121000" cy="353758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636124" y="1393554"/>
            <a:ext cx="1140858" cy="1538552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554579" y="5193075"/>
            <a:ext cx="3966514" cy="584943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554579" y="2932106"/>
            <a:ext cx="3966514" cy="1051916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626568" y="5193076"/>
            <a:ext cx="1130556" cy="57011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636123" y="2932106"/>
            <a:ext cx="1121000" cy="948256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1626580" y="1083594"/>
            <a:ext cx="59298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     N1  N2  N3    N1  N2  N3    N1    N2    N3    N1  N2  N3       N1   N2         L     N2   N3    N4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</a:t>
            </a:r>
          </a:p>
        </p:txBody>
      </p:sp>
      <p:cxnSp>
        <p:nvCxnSpPr>
          <p:cNvPr id="15" name="Straight Connector 14"/>
          <p:cNvCxnSpPr/>
          <p:nvPr/>
        </p:nvCxnSpPr>
        <p:spPr>
          <a:xfrm>
            <a:off x="1960687" y="1083594"/>
            <a:ext cx="553916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4223241" y="1079875"/>
            <a:ext cx="65649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3364526" y="1079875"/>
            <a:ext cx="74148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2667003" y="1079875"/>
            <a:ext cx="612531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5989676" y="1079875"/>
            <a:ext cx="674896" cy="371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 flipV="1">
            <a:off x="5043356" y="1075479"/>
            <a:ext cx="477737" cy="631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2105965" y="753241"/>
            <a:ext cx="46215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9         E10           E11            E12          E13                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13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686219" y="4393017"/>
            <a:ext cx="57305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1  N2  N3    N1  N2  N3      N1    N2    N3    N1  N2  N3      N1     N2            </a:t>
            </a:r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2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N3    N4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</a:t>
            </a:r>
          </a:p>
        </p:txBody>
      </p:sp>
      <p:cxnSp>
        <p:nvCxnSpPr>
          <p:cNvPr id="29" name="Straight Connector 28"/>
          <p:cNvCxnSpPr/>
          <p:nvPr/>
        </p:nvCxnSpPr>
        <p:spPr>
          <a:xfrm>
            <a:off x="1761395" y="4370440"/>
            <a:ext cx="553916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>
            <a:off x="4147037" y="4366721"/>
            <a:ext cx="65649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>
            <a:off x="3235570" y="4366721"/>
            <a:ext cx="74148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>
            <a:off x="2467711" y="4366721"/>
            <a:ext cx="612531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>
            <a:off x="5732587" y="4370440"/>
            <a:ext cx="85285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 flipV="1">
            <a:off x="4906110" y="4362393"/>
            <a:ext cx="477737" cy="631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1906673" y="4040087"/>
            <a:ext cx="45766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9         E10           E11              E12        E13               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13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137526" y="5324242"/>
            <a:ext cx="13115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ctin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42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CA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164253" y="4765975"/>
            <a:ext cx="130195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H8  88KDa</a:t>
            </a:r>
            <a:endParaRPr lang="en-CA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6B838194-27C9-404F-AB6C-0694590B45FE}"/>
              </a:ext>
            </a:extLst>
          </p:cNvPr>
          <p:cNvSpPr/>
          <p:nvPr/>
        </p:nvSpPr>
        <p:spPr>
          <a:xfrm>
            <a:off x="1554579" y="1403576"/>
            <a:ext cx="3966514" cy="2580445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6B838194-27C9-404F-AB6C-0694590B45FE}"/>
              </a:ext>
            </a:extLst>
          </p:cNvPr>
          <p:cNvSpPr/>
          <p:nvPr/>
        </p:nvSpPr>
        <p:spPr>
          <a:xfrm>
            <a:off x="5626569" y="1377690"/>
            <a:ext cx="1150414" cy="2502672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6B838194-27C9-404F-AB6C-0694590B45FE}"/>
              </a:ext>
            </a:extLst>
          </p:cNvPr>
          <p:cNvSpPr/>
          <p:nvPr/>
        </p:nvSpPr>
        <p:spPr>
          <a:xfrm>
            <a:off x="5626567" y="4723823"/>
            <a:ext cx="1150415" cy="349929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6B838194-27C9-404F-AB6C-0694590B45FE}"/>
              </a:ext>
            </a:extLst>
          </p:cNvPr>
          <p:cNvSpPr/>
          <p:nvPr/>
        </p:nvSpPr>
        <p:spPr>
          <a:xfrm>
            <a:off x="1559454" y="4717825"/>
            <a:ext cx="3961639" cy="355927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6B838194-27C9-404F-AB6C-0694590B45FE}"/>
              </a:ext>
            </a:extLst>
          </p:cNvPr>
          <p:cNvSpPr/>
          <p:nvPr/>
        </p:nvSpPr>
        <p:spPr>
          <a:xfrm>
            <a:off x="1554579" y="5231423"/>
            <a:ext cx="3966514" cy="531763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6B838194-27C9-404F-AB6C-0694590B45FE}"/>
              </a:ext>
            </a:extLst>
          </p:cNvPr>
          <p:cNvSpPr/>
          <p:nvPr/>
        </p:nvSpPr>
        <p:spPr>
          <a:xfrm>
            <a:off x="5636123" y="5231423"/>
            <a:ext cx="1140859" cy="531763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936D9CF4-D342-4BFF-AC89-80EC65016143}"/>
              </a:ext>
            </a:extLst>
          </p:cNvPr>
          <p:cNvSpPr txBox="1"/>
          <p:nvPr/>
        </p:nvSpPr>
        <p:spPr>
          <a:xfrm>
            <a:off x="1124815" y="1365214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AE54A97-B4BA-4894-A970-E068148D4583}"/>
              </a:ext>
            </a:extLst>
          </p:cNvPr>
          <p:cNvSpPr txBox="1"/>
          <p:nvPr/>
        </p:nvSpPr>
        <p:spPr>
          <a:xfrm>
            <a:off x="1118211" y="1522396"/>
            <a:ext cx="4652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7D5EA467-12CF-4B9E-803D-489BA014C4CA}"/>
              </a:ext>
            </a:extLst>
          </p:cNvPr>
          <p:cNvSpPr txBox="1"/>
          <p:nvPr/>
        </p:nvSpPr>
        <p:spPr>
          <a:xfrm>
            <a:off x="1132728" y="1867743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3D86ABFB-EE6C-4964-8B40-051C8D9DA0FF}"/>
              </a:ext>
            </a:extLst>
          </p:cNvPr>
          <p:cNvSpPr txBox="1"/>
          <p:nvPr/>
        </p:nvSpPr>
        <p:spPr>
          <a:xfrm>
            <a:off x="1163287" y="228071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13941D91-668E-4483-B4DD-23E3637E11F4}"/>
              </a:ext>
            </a:extLst>
          </p:cNvPr>
          <p:cNvSpPr txBox="1"/>
          <p:nvPr/>
        </p:nvSpPr>
        <p:spPr>
          <a:xfrm>
            <a:off x="1172641" y="283038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ABF26565-E489-47A1-8D02-AB3362210020}"/>
              </a:ext>
            </a:extLst>
          </p:cNvPr>
          <p:cNvSpPr txBox="1"/>
          <p:nvPr/>
        </p:nvSpPr>
        <p:spPr>
          <a:xfrm>
            <a:off x="539682" y="1960076"/>
            <a:ext cx="4154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8</a:t>
            </a:r>
            <a:endParaRPr lang="en-CA" sz="14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64D24622-474D-4E80-BB6A-A1A1BDF82DA6}"/>
              </a:ext>
            </a:extLst>
          </p:cNvPr>
          <p:cNvCxnSpPr>
            <a:cxnSpLocks/>
          </p:cNvCxnSpPr>
          <p:nvPr/>
        </p:nvCxnSpPr>
        <p:spPr>
          <a:xfrm flipH="1">
            <a:off x="917735" y="2121911"/>
            <a:ext cx="829657" cy="0"/>
          </a:xfrm>
          <a:prstGeom prst="line">
            <a:avLst/>
          </a:prstGeom>
          <a:ln w="28575"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749084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BE68FE-210B-426C-803A-D86D644DE2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2623" y="29308"/>
            <a:ext cx="10515600" cy="633659"/>
          </a:xfrm>
        </p:spPr>
        <p:txBody>
          <a:bodyPr>
            <a:normAutofit/>
          </a:bodyPr>
          <a:lstStyle/>
          <a:p>
            <a:pPr algn="ctr"/>
            <a:r>
              <a:rPr 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C3 I/II     1 to 3000     2 Sec</a:t>
            </a:r>
            <a:endParaRPr lang="en-CA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C2561F16-698E-4483-B6B9-5141AEE0F52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534637" y="2432418"/>
            <a:ext cx="3959555" cy="1686183"/>
          </a:xfr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6B95CBC0-E51A-4DEB-8D38-7275EC6BD9D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49828" y="4899329"/>
            <a:ext cx="3959555" cy="583728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87BC5CCB-99D4-41BA-A0D2-13218735986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06295" y="2478982"/>
            <a:ext cx="1030999" cy="1625658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2D4640D5-CB4F-45F4-AF7F-D0B6FD0B444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606295" y="4899329"/>
            <a:ext cx="896889" cy="579885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EB8C6C5A-0755-460B-9BEB-39C89F4605F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606449" y="1441140"/>
            <a:ext cx="1030845" cy="948846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B7343CFE-461B-41C8-98F7-0D57AD1029A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606295" y="5692848"/>
            <a:ext cx="882165" cy="443234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468FC148-5EB5-4844-B1F2-B5243A030B2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557188" y="5723071"/>
            <a:ext cx="3959555" cy="443234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196165DE-80A2-41AA-9818-6F0F03CC9E7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549829" y="1374943"/>
            <a:ext cx="3959555" cy="1056965"/>
          </a:xfrm>
          <a:prstGeom prst="rect">
            <a:avLst/>
          </a:prstGeom>
        </p:spPr>
      </p:pic>
      <p:sp>
        <p:nvSpPr>
          <p:cNvPr id="21" name="Rectangle 20">
            <a:extLst>
              <a:ext uri="{FF2B5EF4-FFF2-40B4-BE49-F238E27FC236}">
                <a16:creationId xmlns:a16="http://schemas.microsoft.com/office/drawing/2014/main" id="{6413D8C4-B3CF-47AC-8302-49DCB498F502}"/>
              </a:ext>
            </a:extLst>
          </p:cNvPr>
          <p:cNvSpPr/>
          <p:nvPr/>
        </p:nvSpPr>
        <p:spPr>
          <a:xfrm>
            <a:off x="1549827" y="1374943"/>
            <a:ext cx="3959555" cy="2752749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D3DCB704-074C-4CC2-A01E-5A7F23A555E2}"/>
              </a:ext>
            </a:extLst>
          </p:cNvPr>
          <p:cNvSpPr/>
          <p:nvPr/>
        </p:nvSpPr>
        <p:spPr>
          <a:xfrm>
            <a:off x="5606295" y="1441140"/>
            <a:ext cx="1030999" cy="2686552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038FDC05-FD3D-4E0E-BBF9-9779EC5187F2}"/>
              </a:ext>
            </a:extLst>
          </p:cNvPr>
          <p:cNvSpPr/>
          <p:nvPr/>
        </p:nvSpPr>
        <p:spPr>
          <a:xfrm>
            <a:off x="1549827" y="4899329"/>
            <a:ext cx="3959555" cy="579885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6BC3ECF4-8A3E-4F23-B9A3-7245EBB009C0}"/>
              </a:ext>
            </a:extLst>
          </p:cNvPr>
          <p:cNvSpPr/>
          <p:nvPr/>
        </p:nvSpPr>
        <p:spPr>
          <a:xfrm>
            <a:off x="1549826" y="5723071"/>
            <a:ext cx="3959555" cy="413011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1EC1558B-7087-457D-85A2-C087C08FE61E}"/>
              </a:ext>
            </a:extLst>
          </p:cNvPr>
          <p:cNvSpPr/>
          <p:nvPr/>
        </p:nvSpPr>
        <p:spPr>
          <a:xfrm>
            <a:off x="5606295" y="4914173"/>
            <a:ext cx="882166" cy="579885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E8006E27-7777-4FCE-A643-481D8B18056B}"/>
              </a:ext>
            </a:extLst>
          </p:cNvPr>
          <p:cNvSpPr/>
          <p:nvPr/>
        </p:nvSpPr>
        <p:spPr>
          <a:xfrm>
            <a:off x="5606295" y="5670966"/>
            <a:ext cx="896889" cy="443235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14695D8-73EF-4153-A65E-AD0995D82D0D}"/>
              </a:ext>
            </a:extLst>
          </p:cNvPr>
          <p:cNvSpPr txBox="1"/>
          <p:nvPr/>
        </p:nvSpPr>
        <p:spPr>
          <a:xfrm>
            <a:off x="1205679" y="1948203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439B00A-4DA3-45FE-AF84-57337552E9AC}"/>
              </a:ext>
            </a:extLst>
          </p:cNvPr>
          <p:cNvSpPr txBox="1"/>
          <p:nvPr/>
        </p:nvSpPr>
        <p:spPr>
          <a:xfrm>
            <a:off x="1211196" y="1738412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9D0A18B-ED01-46C8-BB5D-0ACA96E0BBA4}"/>
              </a:ext>
            </a:extLst>
          </p:cNvPr>
          <p:cNvSpPr txBox="1"/>
          <p:nvPr/>
        </p:nvSpPr>
        <p:spPr>
          <a:xfrm>
            <a:off x="1213910" y="2689656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F6CBDC7-BF9B-4182-AD2F-F1877769D6A9}"/>
              </a:ext>
            </a:extLst>
          </p:cNvPr>
          <p:cNvSpPr txBox="1"/>
          <p:nvPr/>
        </p:nvSpPr>
        <p:spPr>
          <a:xfrm>
            <a:off x="1213910" y="3181715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03C85D7-A1EA-49C5-BF89-B90D727E4EAE}"/>
              </a:ext>
            </a:extLst>
          </p:cNvPr>
          <p:cNvSpPr txBox="1"/>
          <p:nvPr/>
        </p:nvSpPr>
        <p:spPr>
          <a:xfrm>
            <a:off x="1205679" y="241007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BE47070F-F4F5-42F8-955A-07D7FF6E3F0B}"/>
              </a:ext>
            </a:extLst>
          </p:cNvPr>
          <p:cNvCxnSpPr>
            <a:cxnSpLocks/>
          </p:cNvCxnSpPr>
          <p:nvPr/>
        </p:nvCxnSpPr>
        <p:spPr>
          <a:xfrm>
            <a:off x="945775" y="3214655"/>
            <a:ext cx="829878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991578B0-CA06-4E77-8CA4-D8DA08DB1E09}"/>
              </a:ext>
            </a:extLst>
          </p:cNvPr>
          <p:cNvCxnSpPr>
            <a:cxnSpLocks/>
          </p:cNvCxnSpPr>
          <p:nvPr/>
        </p:nvCxnSpPr>
        <p:spPr>
          <a:xfrm>
            <a:off x="945775" y="3429000"/>
            <a:ext cx="829878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B848810B-C0C9-431E-906D-80B10A7270B9}"/>
              </a:ext>
            </a:extLst>
          </p:cNvPr>
          <p:cNvSpPr txBox="1"/>
          <p:nvPr/>
        </p:nvSpPr>
        <p:spPr>
          <a:xfrm>
            <a:off x="1505538" y="1112532"/>
            <a:ext cx="58657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     N1   N2    N3     N1   N2    N3    N1 N2 N3    N1 N 2  N3     N1   N2             L    N3    N4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583C8AF4-6D4E-4537-A4A7-0103E9280D98}"/>
              </a:ext>
            </a:extLst>
          </p:cNvPr>
          <p:cNvCxnSpPr/>
          <p:nvPr/>
        </p:nvCxnSpPr>
        <p:spPr>
          <a:xfrm flipV="1">
            <a:off x="1808909" y="1080298"/>
            <a:ext cx="706316" cy="371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838B9A29-863A-415F-8773-FA3061089837}"/>
              </a:ext>
            </a:extLst>
          </p:cNvPr>
          <p:cNvCxnSpPr/>
          <p:nvPr/>
        </p:nvCxnSpPr>
        <p:spPr>
          <a:xfrm>
            <a:off x="4104218" y="1086953"/>
            <a:ext cx="689472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48716AB1-B763-400A-8DA8-1A792E5BD330}"/>
              </a:ext>
            </a:extLst>
          </p:cNvPr>
          <p:cNvCxnSpPr>
            <a:cxnSpLocks/>
          </p:cNvCxnSpPr>
          <p:nvPr/>
        </p:nvCxnSpPr>
        <p:spPr>
          <a:xfrm flipV="1">
            <a:off x="3494102" y="1078161"/>
            <a:ext cx="524646" cy="2137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405E3CAF-E6EC-4CB7-BA4A-1B221CB098EC}"/>
              </a:ext>
            </a:extLst>
          </p:cNvPr>
          <p:cNvCxnSpPr/>
          <p:nvPr/>
        </p:nvCxnSpPr>
        <p:spPr>
          <a:xfrm>
            <a:off x="2603147" y="1078161"/>
            <a:ext cx="83139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0C4C8020-20AF-49A1-99BB-D3AAE799F605}"/>
              </a:ext>
            </a:extLst>
          </p:cNvPr>
          <p:cNvCxnSpPr>
            <a:cxnSpLocks/>
          </p:cNvCxnSpPr>
          <p:nvPr/>
        </p:nvCxnSpPr>
        <p:spPr>
          <a:xfrm flipV="1">
            <a:off x="5710423" y="1084868"/>
            <a:ext cx="746725" cy="6687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1F2BA9F5-E2D9-4512-A0F2-7881C84E569D}"/>
              </a:ext>
            </a:extLst>
          </p:cNvPr>
          <p:cNvCxnSpPr/>
          <p:nvPr/>
        </p:nvCxnSpPr>
        <p:spPr>
          <a:xfrm>
            <a:off x="4916745" y="1068199"/>
            <a:ext cx="425047" cy="6097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18A7083A-57D6-44D8-92A6-4FAF29D7CABB}"/>
              </a:ext>
            </a:extLst>
          </p:cNvPr>
          <p:cNvSpPr txBox="1"/>
          <p:nvPr/>
        </p:nvSpPr>
        <p:spPr>
          <a:xfrm>
            <a:off x="1972157" y="747885"/>
            <a:ext cx="43971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9             E10            E11         E12        E13             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13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08A03772-F1F5-48A5-B891-68FBB871DD60}"/>
              </a:ext>
            </a:extLst>
          </p:cNvPr>
          <p:cNvSpPr txBox="1"/>
          <p:nvPr/>
        </p:nvSpPr>
        <p:spPr>
          <a:xfrm>
            <a:off x="1657938" y="4522948"/>
            <a:ext cx="54425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1   N2    N3     N1   N2   N3    N1 N2 N3     N1 N 2  N3       N1   N2               N3   N4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</a:t>
            </a: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C2F63D94-1420-4CCF-81AF-172550E8E9B7}"/>
              </a:ext>
            </a:extLst>
          </p:cNvPr>
          <p:cNvCxnSpPr/>
          <p:nvPr/>
        </p:nvCxnSpPr>
        <p:spPr>
          <a:xfrm flipV="1">
            <a:off x="1775653" y="4504972"/>
            <a:ext cx="706316" cy="371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9A560ECB-9144-4B27-BA2C-0C8ADD4AD07E}"/>
              </a:ext>
            </a:extLst>
          </p:cNvPr>
          <p:cNvCxnSpPr/>
          <p:nvPr/>
        </p:nvCxnSpPr>
        <p:spPr>
          <a:xfrm>
            <a:off x="4093656" y="4496192"/>
            <a:ext cx="689472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B0031DBB-7880-4393-A8BE-5B96765D4D8B}"/>
              </a:ext>
            </a:extLst>
          </p:cNvPr>
          <p:cNvCxnSpPr>
            <a:cxnSpLocks/>
          </p:cNvCxnSpPr>
          <p:nvPr/>
        </p:nvCxnSpPr>
        <p:spPr>
          <a:xfrm flipV="1">
            <a:off x="3385427" y="4495284"/>
            <a:ext cx="633321" cy="221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4A83093F-55DD-4EBD-BF18-83D58D3A35AF}"/>
              </a:ext>
            </a:extLst>
          </p:cNvPr>
          <p:cNvCxnSpPr>
            <a:cxnSpLocks/>
          </p:cNvCxnSpPr>
          <p:nvPr/>
        </p:nvCxnSpPr>
        <p:spPr>
          <a:xfrm flipV="1">
            <a:off x="2603146" y="4501971"/>
            <a:ext cx="685619" cy="2098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3A2E2B22-E729-4890-B58A-6713A36D6953}"/>
              </a:ext>
            </a:extLst>
          </p:cNvPr>
          <p:cNvCxnSpPr>
            <a:cxnSpLocks/>
          </p:cNvCxnSpPr>
          <p:nvPr/>
        </p:nvCxnSpPr>
        <p:spPr>
          <a:xfrm flipV="1">
            <a:off x="5730158" y="4503239"/>
            <a:ext cx="507315" cy="1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A87863ED-839E-4A7C-BBEC-367A27DFB060}"/>
              </a:ext>
            </a:extLst>
          </p:cNvPr>
          <p:cNvCxnSpPr>
            <a:cxnSpLocks/>
          </p:cNvCxnSpPr>
          <p:nvPr/>
        </p:nvCxnSpPr>
        <p:spPr>
          <a:xfrm>
            <a:off x="4916745" y="4492520"/>
            <a:ext cx="422731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C4AB3EF5-8149-4078-9366-1561C613CFB9}"/>
              </a:ext>
            </a:extLst>
          </p:cNvPr>
          <p:cNvSpPr txBox="1"/>
          <p:nvPr/>
        </p:nvSpPr>
        <p:spPr>
          <a:xfrm>
            <a:off x="1907513" y="4204022"/>
            <a:ext cx="43971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9             E10           E11         E12        E13             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13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1EC6A7B4-E190-4553-B396-9D5E8AF7D3F5}"/>
              </a:ext>
            </a:extLst>
          </p:cNvPr>
          <p:cNvCxnSpPr>
            <a:cxnSpLocks/>
          </p:cNvCxnSpPr>
          <p:nvPr/>
        </p:nvCxnSpPr>
        <p:spPr>
          <a:xfrm flipH="1">
            <a:off x="1374145" y="5046966"/>
            <a:ext cx="178319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9773C6B6-0EA4-4FAC-A025-5F0936083F6B}"/>
              </a:ext>
            </a:extLst>
          </p:cNvPr>
          <p:cNvCxnSpPr>
            <a:cxnSpLocks/>
          </p:cNvCxnSpPr>
          <p:nvPr/>
        </p:nvCxnSpPr>
        <p:spPr>
          <a:xfrm flipH="1">
            <a:off x="1383187" y="5357653"/>
            <a:ext cx="169279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7A726D95-ACE2-48A4-85A2-A32637A14919}"/>
              </a:ext>
            </a:extLst>
          </p:cNvPr>
          <p:cNvSpPr txBox="1"/>
          <p:nvPr/>
        </p:nvSpPr>
        <p:spPr>
          <a:xfrm>
            <a:off x="50476" y="4870863"/>
            <a:ext cx="207366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C3 I       16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CA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C69DC610-3AC6-430C-990B-5CAE69F47238}"/>
              </a:ext>
            </a:extLst>
          </p:cNvPr>
          <p:cNvSpPr txBox="1"/>
          <p:nvPr/>
        </p:nvSpPr>
        <p:spPr>
          <a:xfrm>
            <a:off x="31935" y="5175038"/>
            <a:ext cx="145506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C3 II      14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CA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56C86F64-C8EC-4A34-9A20-BA890E5E9A58}"/>
              </a:ext>
            </a:extLst>
          </p:cNvPr>
          <p:cNvSpPr txBox="1"/>
          <p:nvPr/>
        </p:nvSpPr>
        <p:spPr>
          <a:xfrm>
            <a:off x="47129" y="5723071"/>
            <a:ext cx="149710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ctin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42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CA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79A98DD8-7C1A-4FD1-9198-C9D25C412E88}"/>
              </a:ext>
            </a:extLst>
          </p:cNvPr>
          <p:cNvSpPr txBox="1"/>
          <p:nvPr/>
        </p:nvSpPr>
        <p:spPr>
          <a:xfrm>
            <a:off x="545259" y="3060766"/>
            <a:ext cx="44546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6</a:t>
            </a:r>
            <a:endParaRPr lang="en-CA" sz="14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2929C072-FBAD-470F-BCE2-6FAA1EC6A376}"/>
              </a:ext>
            </a:extLst>
          </p:cNvPr>
          <p:cNvSpPr txBox="1"/>
          <p:nvPr/>
        </p:nvSpPr>
        <p:spPr>
          <a:xfrm>
            <a:off x="536735" y="3272296"/>
            <a:ext cx="44546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  <a:endParaRPr lang="en-CA" sz="14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8719064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0D7289-6FCD-4A2F-BE24-FDE4E71B20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39256" y="-19925"/>
            <a:ext cx="10515600" cy="580549"/>
          </a:xfrm>
        </p:spPr>
        <p:txBody>
          <a:bodyPr>
            <a:normAutofit/>
          </a:bodyPr>
          <a:lstStyle/>
          <a:p>
            <a:pPr algn="ctr"/>
            <a:r>
              <a:rPr 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2    1 to 3000     60Sec</a:t>
            </a:r>
            <a:endParaRPr lang="en-CA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5AF90797-C102-4254-8F98-91A140D7462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414866" y="4583894"/>
            <a:ext cx="4182191" cy="319351"/>
          </a:xfr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2BA67430-765E-4467-95A3-CAEE7543DBF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07507" y="1290918"/>
            <a:ext cx="4186794" cy="109881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673FB6B-D367-41C4-8D79-2D5CDA159E1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23665" y="1290918"/>
            <a:ext cx="1270600" cy="1034508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F8CC0D2A-D402-4CB7-A8F2-2672EC6D3B0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725118" y="4583893"/>
            <a:ext cx="931766" cy="338109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D13B0CBF-F9A8-4376-8C55-26D9DBBE181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523665" y="2489124"/>
            <a:ext cx="1245970" cy="1146859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50D3CD32-F685-4DE1-9EA5-91EF6865770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107507" y="2519587"/>
            <a:ext cx="4182191" cy="1116396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88229A00-657A-4649-BB84-B47AE3B8DC9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725118" y="5008588"/>
            <a:ext cx="931767" cy="468156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733ED61D-9A3E-4E2C-B1B7-024EA59B2AC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414866" y="5008588"/>
            <a:ext cx="4182191" cy="468156"/>
          </a:xfrm>
          <a:prstGeom prst="rect">
            <a:avLst/>
          </a:prstGeom>
        </p:spPr>
      </p:pic>
      <p:sp>
        <p:nvSpPr>
          <p:cNvPr id="16" name="Rectangle 15">
            <a:extLst>
              <a:ext uri="{FF2B5EF4-FFF2-40B4-BE49-F238E27FC236}">
                <a16:creationId xmlns:a16="http://schemas.microsoft.com/office/drawing/2014/main" id="{CFA1AA6B-F71E-4FCF-A3E4-CCB4F5CA9201}"/>
              </a:ext>
            </a:extLst>
          </p:cNvPr>
          <p:cNvSpPr/>
          <p:nvPr/>
        </p:nvSpPr>
        <p:spPr>
          <a:xfrm>
            <a:off x="1107506" y="1295359"/>
            <a:ext cx="4182191" cy="1094375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4D41FFD4-3A2A-460F-9111-D28478CD55A5}"/>
              </a:ext>
            </a:extLst>
          </p:cNvPr>
          <p:cNvSpPr/>
          <p:nvPr/>
        </p:nvSpPr>
        <p:spPr>
          <a:xfrm>
            <a:off x="1414866" y="4583893"/>
            <a:ext cx="4182191" cy="319351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1631547E-B0A1-460A-B80D-3988C4F70282}"/>
              </a:ext>
            </a:extLst>
          </p:cNvPr>
          <p:cNvSpPr/>
          <p:nvPr/>
        </p:nvSpPr>
        <p:spPr>
          <a:xfrm>
            <a:off x="1414865" y="5008587"/>
            <a:ext cx="4182191" cy="468156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67211E78-5612-4620-B48D-74C4FA4803F0}"/>
              </a:ext>
            </a:extLst>
          </p:cNvPr>
          <p:cNvSpPr/>
          <p:nvPr/>
        </p:nvSpPr>
        <p:spPr>
          <a:xfrm>
            <a:off x="5725119" y="4583892"/>
            <a:ext cx="931766" cy="319351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7931646A-856C-42A3-90B5-CE89BA4BB7CE}"/>
              </a:ext>
            </a:extLst>
          </p:cNvPr>
          <p:cNvSpPr/>
          <p:nvPr/>
        </p:nvSpPr>
        <p:spPr>
          <a:xfrm>
            <a:off x="5725118" y="5027347"/>
            <a:ext cx="931766" cy="449396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435C16FD-5433-44CA-ABB6-0F372529ABDA}"/>
              </a:ext>
            </a:extLst>
          </p:cNvPr>
          <p:cNvSpPr/>
          <p:nvPr/>
        </p:nvSpPr>
        <p:spPr>
          <a:xfrm>
            <a:off x="5519061" y="1290917"/>
            <a:ext cx="1245970" cy="1034508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6D7E7DED-C3A4-4E0F-919C-6B14EA0C9142}"/>
              </a:ext>
            </a:extLst>
          </p:cNvPr>
          <p:cNvSpPr/>
          <p:nvPr/>
        </p:nvSpPr>
        <p:spPr>
          <a:xfrm>
            <a:off x="5535980" y="2503853"/>
            <a:ext cx="1245970" cy="1132130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146A531B-3BD7-4C39-8E7D-61B55FD9D6A1}"/>
              </a:ext>
            </a:extLst>
          </p:cNvPr>
          <p:cNvSpPr/>
          <p:nvPr/>
        </p:nvSpPr>
        <p:spPr>
          <a:xfrm>
            <a:off x="1095192" y="2530597"/>
            <a:ext cx="4182191" cy="1094375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D2E90F6-25E4-4A53-9DB9-D116D23E395A}"/>
              </a:ext>
            </a:extLst>
          </p:cNvPr>
          <p:cNvSpPr txBox="1"/>
          <p:nvPr/>
        </p:nvSpPr>
        <p:spPr>
          <a:xfrm>
            <a:off x="777389" y="1433973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C0C659D-F76C-4555-A08B-3B00CCE8B588}"/>
              </a:ext>
            </a:extLst>
          </p:cNvPr>
          <p:cNvSpPr txBox="1"/>
          <p:nvPr/>
        </p:nvSpPr>
        <p:spPr>
          <a:xfrm>
            <a:off x="324153" y="149555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2</a:t>
            </a:r>
            <a:endParaRPr lang="en-CA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502E181-2977-48CA-A075-D5C3E3B1908F}"/>
              </a:ext>
            </a:extLst>
          </p:cNvPr>
          <p:cNvSpPr txBox="1"/>
          <p:nvPr/>
        </p:nvSpPr>
        <p:spPr>
          <a:xfrm>
            <a:off x="777389" y="163405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BB84F0BB-D456-42E3-8101-CAAE8927AEE2}"/>
              </a:ext>
            </a:extLst>
          </p:cNvPr>
          <p:cNvCxnSpPr>
            <a:cxnSpLocks/>
          </p:cNvCxnSpPr>
          <p:nvPr/>
        </p:nvCxnSpPr>
        <p:spPr>
          <a:xfrm>
            <a:off x="598084" y="1644298"/>
            <a:ext cx="829878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CBB2796A-805D-4B61-9929-214C7A45CBCC}"/>
              </a:ext>
            </a:extLst>
          </p:cNvPr>
          <p:cNvSpPr txBox="1"/>
          <p:nvPr/>
        </p:nvSpPr>
        <p:spPr>
          <a:xfrm>
            <a:off x="1533762" y="4295882"/>
            <a:ext cx="56348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1   N2    N3    N1   N2   N3      N1   N2    N3    N1    N 2   N3   N1   N2                  N3   N4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3AEC0C1D-AAF1-4FDA-986F-CB955D177AB2}"/>
              </a:ext>
            </a:extLst>
          </p:cNvPr>
          <p:cNvCxnSpPr/>
          <p:nvPr/>
        </p:nvCxnSpPr>
        <p:spPr>
          <a:xfrm flipV="1">
            <a:off x="1606604" y="4290303"/>
            <a:ext cx="706316" cy="371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2FBA6CD3-5042-41A2-AC34-65FE3D671B68}"/>
              </a:ext>
            </a:extLst>
          </p:cNvPr>
          <p:cNvCxnSpPr>
            <a:cxnSpLocks/>
          </p:cNvCxnSpPr>
          <p:nvPr/>
        </p:nvCxnSpPr>
        <p:spPr>
          <a:xfrm flipV="1">
            <a:off x="4109024" y="4284869"/>
            <a:ext cx="754969" cy="7293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7A31B5ED-012B-4E1B-9CBF-2E61AD4FF0C7}"/>
              </a:ext>
            </a:extLst>
          </p:cNvPr>
          <p:cNvCxnSpPr>
            <a:cxnSpLocks/>
          </p:cNvCxnSpPr>
          <p:nvPr/>
        </p:nvCxnSpPr>
        <p:spPr>
          <a:xfrm flipV="1">
            <a:off x="3256259" y="4284869"/>
            <a:ext cx="779158" cy="894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DCA223D3-1C69-4C6A-9F00-B4A94F0B66D8}"/>
              </a:ext>
            </a:extLst>
          </p:cNvPr>
          <p:cNvCxnSpPr>
            <a:cxnSpLocks/>
          </p:cNvCxnSpPr>
          <p:nvPr/>
        </p:nvCxnSpPr>
        <p:spPr>
          <a:xfrm flipV="1">
            <a:off x="2441780" y="4287425"/>
            <a:ext cx="685619" cy="2098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5FDB7523-2737-42B4-B04F-290BB94CB6D8}"/>
              </a:ext>
            </a:extLst>
          </p:cNvPr>
          <p:cNvCxnSpPr>
            <a:cxnSpLocks/>
          </p:cNvCxnSpPr>
          <p:nvPr/>
        </p:nvCxnSpPr>
        <p:spPr>
          <a:xfrm flipV="1">
            <a:off x="5864344" y="4292558"/>
            <a:ext cx="507315" cy="1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F45D3387-F798-463C-B2D1-F6CD9CB4A5C2}"/>
              </a:ext>
            </a:extLst>
          </p:cNvPr>
          <p:cNvCxnSpPr>
            <a:cxnSpLocks/>
          </p:cNvCxnSpPr>
          <p:nvPr/>
        </p:nvCxnSpPr>
        <p:spPr>
          <a:xfrm>
            <a:off x="4939796" y="4284869"/>
            <a:ext cx="422731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2BDE76D4-21C8-4EED-9547-D81F55C73DAC}"/>
              </a:ext>
            </a:extLst>
          </p:cNvPr>
          <p:cNvSpPr txBox="1"/>
          <p:nvPr/>
        </p:nvSpPr>
        <p:spPr>
          <a:xfrm>
            <a:off x="1698899" y="3984385"/>
            <a:ext cx="47561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9              E10             E11             E12        E13               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13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451E9B6-2F31-42FA-8C27-9A82C20492CE}"/>
              </a:ext>
            </a:extLst>
          </p:cNvPr>
          <p:cNvSpPr txBox="1"/>
          <p:nvPr/>
        </p:nvSpPr>
        <p:spPr>
          <a:xfrm>
            <a:off x="775375" y="311617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89934637-25C4-4087-B1B5-2E6DD1BAE683}"/>
              </a:ext>
            </a:extLst>
          </p:cNvPr>
          <p:cNvSpPr txBox="1"/>
          <p:nvPr/>
        </p:nvSpPr>
        <p:spPr>
          <a:xfrm>
            <a:off x="780892" y="2906380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2CFE9C1E-0AF5-47F9-9FEB-F4B1AC346B26}"/>
              </a:ext>
            </a:extLst>
          </p:cNvPr>
          <p:cNvSpPr txBox="1"/>
          <p:nvPr/>
        </p:nvSpPr>
        <p:spPr>
          <a:xfrm>
            <a:off x="1144390" y="997272"/>
            <a:ext cx="63177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    N1   N2    N3     N1   N2    N3   N1   N2  N3    N1   N 2  N3      N1   N2                      L    N3    N4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</a:t>
            </a: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A2CFB7F0-62CF-4957-AC83-6067D72776D4}"/>
              </a:ext>
            </a:extLst>
          </p:cNvPr>
          <p:cNvCxnSpPr/>
          <p:nvPr/>
        </p:nvCxnSpPr>
        <p:spPr>
          <a:xfrm flipV="1">
            <a:off x="1441023" y="972465"/>
            <a:ext cx="706316" cy="371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4450F1FB-934E-45BA-A76A-A62DE4AE51C7}"/>
              </a:ext>
            </a:extLst>
          </p:cNvPr>
          <p:cNvCxnSpPr/>
          <p:nvPr/>
        </p:nvCxnSpPr>
        <p:spPr>
          <a:xfrm>
            <a:off x="3867161" y="966897"/>
            <a:ext cx="689472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12E2E712-7E3C-44A1-81F8-21CE5C3CCEF8}"/>
              </a:ext>
            </a:extLst>
          </p:cNvPr>
          <p:cNvCxnSpPr>
            <a:cxnSpLocks/>
          </p:cNvCxnSpPr>
          <p:nvPr/>
        </p:nvCxnSpPr>
        <p:spPr>
          <a:xfrm flipV="1">
            <a:off x="3106580" y="974324"/>
            <a:ext cx="663046" cy="746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7E6F1CCA-90EF-4DDE-B130-71622D4ACBA9}"/>
              </a:ext>
            </a:extLst>
          </p:cNvPr>
          <p:cNvCxnSpPr/>
          <p:nvPr/>
        </p:nvCxnSpPr>
        <p:spPr>
          <a:xfrm>
            <a:off x="2211263" y="977962"/>
            <a:ext cx="83139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DF1231A8-D471-445C-898F-F1CADBE17691}"/>
              </a:ext>
            </a:extLst>
          </p:cNvPr>
          <p:cNvCxnSpPr>
            <a:cxnSpLocks/>
          </p:cNvCxnSpPr>
          <p:nvPr/>
        </p:nvCxnSpPr>
        <p:spPr>
          <a:xfrm>
            <a:off x="6008110" y="968349"/>
            <a:ext cx="507298" cy="1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463460DD-9C85-448B-9EFD-011E95648AD6}"/>
              </a:ext>
            </a:extLst>
          </p:cNvPr>
          <p:cNvCxnSpPr/>
          <p:nvPr/>
        </p:nvCxnSpPr>
        <p:spPr>
          <a:xfrm>
            <a:off x="4663748" y="960197"/>
            <a:ext cx="425047" cy="6097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EBB8FD61-4765-4620-BEB2-CB259139AC28}"/>
              </a:ext>
            </a:extLst>
          </p:cNvPr>
          <p:cNvSpPr txBox="1"/>
          <p:nvPr/>
        </p:nvSpPr>
        <p:spPr>
          <a:xfrm>
            <a:off x="1652402" y="642473"/>
            <a:ext cx="48908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9             E10            E11         E12        E13                        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13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08C9E65F-1D53-40D9-A7D5-90F04F332804}"/>
              </a:ext>
            </a:extLst>
          </p:cNvPr>
          <p:cNvSpPr txBox="1"/>
          <p:nvPr/>
        </p:nvSpPr>
        <p:spPr>
          <a:xfrm>
            <a:off x="85143" y="4598080"/>
            <a:ext cx="19951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2     62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CA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DDA25A46-3A1A-4A9D-BBDF-5BEE311A9C60}"/>
              </a:ext>
            </a:extLst>
          </p:cNvPr>
          <p:cNvSpPr txBox="1"/>
          <p:nvPr/>
        </p:nvSpPr>
        <p:spPr>
          <a:xfrm>
            <a:off x="47739" y="5098156"/>
            <a:ext cx="135481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ctin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42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CA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904605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170F39-55C9-4028-979F-52EBF9B0A5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38307" y="80817"/>
            <a:ext cx="10515600" cy="664536"/>
          </a:xfrm>
        </p:spPr>
        <p:txBody>
          <a:bodyPr>
            <a:normAutofit/>
          </a:bodyPr>
          <a:lstStyle/>
          <a:p>
            <a:pPr algn="ctr"/>
            <a:r>
              <a:rPr 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-cadherin (CDH2)  1 to 500    5Sec  </a:t>
            </a:r>
            <a:endParaRPr lang="en-CA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47E86D8F-9D97-4EFC-AC59-82A15DFA3FA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483018" y="1501437"/>
            <a:ext cx="4123234" cy="1577169"/>
          </a:xfr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C3F9EE3-CF47-4DBD-81D2-FC2D1E14FA4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04315" y="1609013"/>
            <a:ext cx="1361247" cy="1577169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D00EBDA-62A2-47C2-9CBD-964D6D37825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83018" y="5717988"/>
            <a:ext cx="4123234" cy="558937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93E018DC-434C-4143-8926-B4DF692DB8D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83018" y="3055911"/>
            <a:ext cx="4123234" cy="1148461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F09C9028-EEDC-4630-A591-68D672A5975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735160" y="5717988"/>
            <a:ext cx="1078264" cy="558937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380F9540-DDAC-414D-B169-928EB9D6E5F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804315" y="3186182"/>
            <a:ext cx="1382032" cy="558938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AAD51F8A-BF6E-4B43-BE74-9816DA33DB4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483018" y="5214626"/>
            <a:ext cx="4123234" cy="268033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D6E9C97A-1C51-4346-BF68-C092F398C01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735160" y="5214625"/>
            <a:ext cx="1078264" cy="365313"/>
          </a:xfrm>
          <a:prstGeom prst="rect">
            <a:avLst/>
          </a:prstGeom>
        </p:spPr>
      </p:pic>
      <p:sp>
        <p:nvSpPr>
          <p:cNvPr id="24" name="Rectangle 23">
            <a:extLst>
              <a:ext uri="{FF2B5EF4-FFF2-40B4-BE49-F238E27FC236}">
                <a16:creationId xmlns:a16="http://schemas.microsoft.com/office/drawing/2014/main" id="{15F337D7-C93B-4F05-9B32-D23BFB9AAB94}"/>
              </a:ext>
            </a:extLst>
          </p:cNvPr>
          <p:cNvSpPr/>
          <p:nvPr/>
        </p:nvSpPr>
        <p:spPr>
          <a:xfrm>
            <a:off x="1505547" y="1501437"/>
            <a:ext cx="4100706" cy="2702935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5A9E104F-3DC4-484D-AEFC-BA96035D446C}"/>
              </a:ext>
            </a:extLst>
          </p:cNvPr>
          <p:cNvSpPr/>
          <p:nvPr/>
        </p:nvSpPr>
        <p:spPr>
          <a:xfrm>
            <a:off x="1505548" y="5195985"/>
            <a:ext cx="4123234" cy="281641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FF4F9FD7-D49D-46C0-B1EC-693C116AFA97}"/>
              </a:ext>
            </a:extLst>
          </p:cNvPr>
          <p:cNvSpPr/>
          <p:nvPr/>
        </p:nvSpPr>
        <p:spPr>
          <a:xfrm>
            <a:off x="5804316" y="1609013"/>
            <a:ext cx="1382032" cy="2136107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F5A13E23-B208-4B4E-9A43-BEEEA9985415}"/>
              </a:ext>
            </a:extLst>
          </p:cNvPr>
          <p:cNvSpPr/>
          <p:nvPr/>
        </p:nvSpPr>
        <p:spPr>
          <a:xfrm>
            <a:off x="1505547" y="5712955"/>
            <a:ext cx="4123234" cy="558937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76A46741-29A6-4ECC-9ABB-B21633BD3DE5}"/>
              </a:ext>
            </a:extLst>
          </p:cNvPr>
          <p:cNvSpPr/>
          <p:nvPr/>
        </p:nvSpPr>
        <p:spPr>
          <a:xfrm>
            <a:off x="5757689" y="5712955"/>
            <a:ext cx="1055735" cy="558937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5325F738-5504-443B-8D81-AA99766E1882}"/>
              </a:ext>
            </a:extLst>
          </p:cNvPr>
          <p:cNvSpPr/>
          <p:nvPr/>
        </p:nvSpPr>
        <p:spPr>
          <a:xfrm>
            <a:off x="5735159" y="5214625"/>
            <a:ext cx="1055735" cy="365313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9743F95-8F2D-4B93-AC9C-5A336FFE87BA}"/>
              </a:ext>
            </a:extLst>
          </p:cNvPr>
          <p:cNvSpPr txBox="1"/>
          <p:nvPr/>
        </p:nvSpPr>
        <p:spPr>
          <a:xfrm>
            <a:off x="1505339" y="1144064"/>
            <a:ext cx="58352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     N1   N2    N3     N1   N2    N3    N1    N2    N3     N1  N2  N3   N1   N2             L     N3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N4              </a:t>
            </a: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ACE9D9FB-DE92-4B4B-96D0-7E4BC2CC905C}"/>
              </a:ext>
            </a:extLst>
          </p:cNvPr>
          <p:cNvCxnSpPr/>
          <p:nvPr/>
        </p:nvCxnSpPr>
        <p:spPr>
          <a:xfrm flipV="1">
            <a:off x="1839446" y="1111830"/>
            <a:ext cx="706316" cy="371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FB7AC00F-E6C2-4A10-8980-AF85BC95F5AA}"/>
              </a:ext>
            </a:extLst>
          </p:cNvPr>
          <p:cNvCxnSpPr/>
          <p:nvPr/>
        </p:nvCxnSpPr>
        <p:spPr>
          <a:xfrm>
            <a:off x="4349435" y="1121534"/>
            <a:ext cx="689472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F3FFF585-D0D5-470C-A18E-3AA65BB3D84C}"/>
              </a:ext>
            </a:extLst>
          </p:cNvPr>
          <p:cNvCxnSpPr/>
          <p:nvPr/>
        </p:nvCxnSpPr>
        <p:spPr>
          <a:xfrm>
            <a:off x="3524639" y="1111830"/>
            <a:ext cx="766916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FA9B4CFD-E3F1-410B-8560-68FE51C201E3}"/>
              </a:ext>
            </a:extLst>
          </p:cNvPr>
          <p:cNvCxnSpPr/>
          <p:nvPr/>
        </p:nvCxnSpPr>
        <p:spPr>
          <a:xfrm>
            <a:off x="2633684" y="1109693"/>
            <a:ext cx="83139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1F8D3C85-14ED-4C3F-8D6B-4B6902AB5F38}"/>
              </a:ext>
            </a:extLst>
          </p:cNvPr>
          <p:cNvCxnSpPr>
            <a:cxnSpLocks/>
          </p:cNvCxnSpPr>
          <p:nvPr/>
        </p:nvCxnSpPr>
        <p:spPr>
          <a:xfrm flipV="1">
            <a:off x="6070658" y="1119991"/>
            <a:ext cx="689472" cy="2378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BC457D00-0585-4F27-A1DF-F0ECE0BF0EDE}"/>
              </a:ext>
            </a:extLst>
          </p:cNvPr>
          <p:cNvCxnSpPr/>
          <p:nvPr/>
        </p:nvCxnSpPr>
        <p:spPr>
          <a:xfrm>
            <a:off x="5111754" y="1115437"/>
            <a:ext cx="425047" cy="6097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526B257A-9296-4513-B127-D83DF8B26BF6}"/>
              </a:ext>
            </a:extLst>
          </p:cNvPr>
          <p:cNvSpPr txBox="1"/>
          <p:nvPr/>
        </p:nvSpPr>
        <p:spPr>
          <a:xfrm>
            <a:off x="2038674" y="769370"/>
            <a:ext cx="48010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9             E10            E11            E12       E13                 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13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C38F52A9-0615-438D-B588-68E1CB0145F4}"/>
              </a:ext>
            </a:extLst>
          </p:cNvPr>
          <p:cNvCxnSpPr/>
          <p:nvPr/>
        </p:nvCxnSpPr>
        <p:spPr>
          <a:xfrm flipV="1">
            <a:off x="1575927" y="4841972"/>
            <a:ext cx="768587" cy="371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C7DB4494-AAD5-4039-944C-D6A6656A8AAA}"/>
              </a:ext>
            </a:extLst>
          </p:cNvPr>
          <p:cNvCxnSpPr/>
          <p:nvPr/>
        </p:nvCxnSpPr>
        <p:spPr>
          <a:xfrm>
            <a:off x="4114886" y="4841972"/>
            <a:ext cx="81365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2240AFD9-1699-4945-A6E4-CF2A1572B109}"/>
              </a:ext>
            </a:extLst>
          </p:cNvPr>
          <p:cNvCxnSpPr/>
          <p:nvPr/>
        </p:nvCxnSpPr>
        <p:spPr>
          <a:xfrm>
            <a:off x="3272165" y="4841972"/>
            <a:ext cx="82647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DE665A79-A356-4709-8D56-6C8E1812D2B4}"/>
              </a:ext>
            </a:extLst>
          </p:cNvPr>
          <p:cNvCxnSpPr/>
          <p:nvPr/>
        </p:nvCxnSpPr>
        <p:spPr>
          <a:xfrm>
            <a:off x="2435403" y="4841972"/>
            <a:ext cx="81380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C58CE12C-2AC3-43AA-AAB0-1995750CFB57}"/>
              </a:ext>
            </a:extLst>
          </p:cNvPr>
          <p:cNvCxnSpPr>
            <a:cxnSpLocks/>
          </p:cNvCxnSpPr>
          <p:nvPr/>
        </p:nvCxnSpPr>
        <p:spPr>
          <a:xfrm>
            <a:off x="5835019" y="4837099"/>
            <a:ext cx="723436" cy="4873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AC960F54-CC8D-4459-8652-9995C886AD3C}"/>
              </a:ext>
            </a:extLst>
          </p:cNvPr>
          <p:cNvCxnSpPr/>
          <p:nvPr/>
        </p:nvCxnSpPr>
        <p:spPr>
          <a:xfrm>
            <a:off x="4975426" y="4841972"/>
            <a:ext cx="56137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910B480A-9F32-4C66-93C7-BDAD63E6FDE9}"/>
              </a:ext>
            </a:extLst>
          </p:cNvPr>
          <p:cNvSpPr txBox="1"/>
          <p:nvPr/>
        </p:nvSpPr>
        <p:spPr>
          <a:xfrm>
            <a:off x="1681791" y="4529322"/>
            <a:ext cx="58019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9                 E10             E11           E12          E13             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13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209612A6-7698-44D7-9B01-64AD7DC772C8}"/>
              </a:ext>
            </a:extLst>
          </p:cNvPr>
          <p:cNvSpPr txBox="1"/>
          <p:nvPr/>
        </p:nvSpPr>
        <p:spPr>
          <a:xfrm>
            <a:off x="1490276" y="4880479"/>
            <a:ext cx="57305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1     N2    N3    N1     N2     N3   N1    N2    N3    N1    N2   N3     N1   N2                  N3       N4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A8B0738B-F6F7-411F-A886-83FD38144818}"/>
              </a:ext>
            </a:extLst>
          </p:cNvPr>
          <p:cNvSpPr txBox="1"/>
          <p:nvPr/>
        </p:nvSpPr>
        <p:spPr>
          <a:xfrm>
            <a:off x="0" y="5728615"/>
            <a:ext cx="176770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ctin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42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CA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DDCDB808-33F9-45E6-95B4-630A4564B155}"/>
              </a:ext>
            </a:extLst>
          </p:cNvPr>
          <p:cNvSpPr txBox="1"/>
          <p:nvPr/>
        </p:nvSpPr>
        <p:spPr>
          <a:xfrm>
            <a:off x="0" y="5206794"/>
            <a:ext cx="179135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H2   130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CA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B4382B8C-E4EA-45E1-B87D-24B7E80D91D0}"/>
              </a:ext>
            </a:extLst>
          </p:cNvPr>
          <p:cNvSpPr txBox="1"/>
          <p:nvPr/>
        </p:nvSpPr>
        <p:spPr>
          <a:xfrm>
            <a:off x="1089344" y="1469947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07D7D47-0837-4004-8379-788B79B83FF3}"/>
              </a:ext>
            </a:extLst>
          </p:cNvPr>
          <p:cNvSpPr txBox="1"/>
          <p:nvPr/>
        </p:nvSpPr>
        <p:spPr>
          <a:xfrm>
            <a:off x="1089344" y="1647871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559E116D-C2A7-4333-B59A-A6C2D7CAF2F8}"/>
              </a:ext>
            </a:extLst>
          </p:cNvPr>
          <p:cNvSpPr txBox="1"/>
          <p:nvPr/>
        </p:nvSpPr>
        <p:spPr>
          <a:xfrm>
            <a:off x="1067519" y="2083799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C1EB4A03-DDF8-4BE7-ACEC-8B3BFDACD47E}"/>
              </a:ext>
            </a:extLst>
          </p:cNvPr>
          <p:cNvSpPr txBox="1"/>
          <p:nvPr/>
        </p:nvSpPr>
        <p:spPr>
          <a:xfrm>
            <a:off x="1123678" y="2442702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3B36BB2E-09AC-4634-9755-AD9664C2D3C3}"/>
              </a:ext>
            </a:extLst>
          </p:cNvPr>
          <p:cNvSpPr txBox="1"/>
          <p:nvPr/>
        </p:nvSpPr>
        <p:spPr>
          <a:xfrm>
            <a:off x="570421" y="1858424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  <a:endParaRPr lang="en-CA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64C03F74-9B5B-419E-AA5F-146AECF68321}"/>
              </a:ext>
            </a:extLst>
          </p:cNvPr>
          <p:cNvSpPr txBox="1"/>
          <p:nvPr/>
        </p:nvSpPr>
        <p:spPr>
          <a:xfrm>
            <a:off x="1123678" y="3015510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915E7065-532B-4AA6-A6CD-4377B548BAFD}"/>
              </a:ext>
            </a:extLst>
          </p:cNvPr>
          <p:cNvCxnSpPr>
            <a:cxnSpLocks/>
          </p:cNvCxnSpPr>
          <p:nvPr/>
        </p:nvCxnSpPr>
        <p:spPr>
          <a:xfrm>
            <a:off x="985919" y="1996924"/>
            <a:ext cx="829878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474955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8E3B05-B757-415D-A60E-ECDD380894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443088" y="0"/>
            <a:ext cx="5040086" cy="810532"/>
          </a:xfrm>
        </p:spPr>
        <p:txBody>
          <a:bodyPr/>
          <a:lstStyle/>
          <a:p>
            <a:r>
              <a:rPr lang="en-US" sz="28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cam</a:t>
            </a:r>
            <a:r>
              <a:rPr kumimoji="0" lang="en-US" sz="2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 E9-E13    1 to 500   10sec </a:t>
            </a:r>
            <a:endParaRPr lang="en-CA" dirty="0"/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4B8C4C2E-93D5-4E31-9E82-83A88D72CC2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422166" y="1308784"/>
            <a:ext cx="4063284" cy="2059823"/>
          </a:xfr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C23C588-EF64-43DF-9F6B-FC19AECF3EA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11444" y="5067753"/>
            <a:ext cx="4063284" cy="449042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43C90B37-1E65-46D4-A7BF-9F4BBABA772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22166" y="5789784"/>
            <a:ext cx="4063284" cy="518938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A638827A-36E4-46FE-AA2F-F3B5B248DA8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11446" y="3362550"/>
            <a:ext cx="4063284" cy="899089"/>
          </a:xfrm>
          <a:prstGeom prst="rect">
            <a:avLst/>
          </a:prstGeom>
        </p:spPr>
      </p:pic>
      <p:sp>
        <p:nvSpPr>
          <p:cNvPr id="22" name="Rectangle 21">
            <a:extLst>
              <a:ext uri="{FF2B5EF4-FFF2-40B4-BE49-F238E27FC236}">
                <a16:creationId xmlns:a16="http://schemas.microsoft.com/office/drawing/2014/main" id="{04B5DE82-4879-4CEC-824D-52B975E4A988}"/>
              </a:ext>
            </a:extLst>
          </p:cNvPr>
          <p:cNvSpPr/>
          <p:nvPr/>
        </p:nvSpPr>
        <p:spPr>
          <a:xfrm>
            <a:off x="1411443" y="1302727"/>
            <a:ext cx="4063283" cy="2958912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909E8313-6F30-409E-8BF0-AF7AA9831E5A}"/>
              </a:ext>
            </a:extLst>
          </p:cNvPr>
          <p:cNvSpPr/>
          <p:nvPr/>
        </p:nvSpPr>
        <p:spPr>
          <a:xfrm>
            <a:off x="1411445" y="5078151"/>
            <a:ext cx="4063283" cy="428248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54297038-C657-4F82-855A-56AD97DA6691}"/>
              </a:ext>
            </a:extLst>
          </p:cNvPr>
          <p:cNvSpPr/>
          <p:nvPr/>
        </p:nvSpPr>
        <p:spPr>
          <a:xfrm>
            <a:off x="5574582" y="1281758"/>
            <a:ext cx="1668815" cy="3147819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381DAA1B-296B-41F7-AEEB-3FFC59F93209}"/>
              </a:ext>
            </a:extLst>
          </p:cNvPr>
          <p:cNvSpPr/>
          <p:nvPr/>
        </p:nvSpPr>
        <p:spPr>
          <a:xfrm>
            <a:off x="1411444" y="5752718"/>
            <a:ext cx="4063283" cy="428248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3F8B7B1-EF3D-4F7C-A0E5-F6B73A04C41B}"/>
              </a:ext>
            </a:extLst>
          </p:cNvPr>
          <p:cNvSpPr txBox="1"/>
          <p:nvPr/>
        </p:nvSpPr>
        <p:spPr>
          <a:xfrm>
            <a:off x="1488267" y="1023909"/>
            <a:ext cx="79169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       N1     N2    N3    N1      N2     N3    N1    N2    N3     N1    N2     N3          N1       N2       N3       N4                  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4270CB3-A49C-41B3-A541-2F658F703FE5}"/>
              </a:ext>
            </a:extLst>
          </p:cNvPr>
          <p:cNvSpPr txBox="1"/>
          <p:nvPr/>
        </p:nvSpPr>
        <p:spPr>
          <a:xfrm>
            <a:off x="1903718" y="634338"/>
            <a:ext cx="709478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E9         E10           E11        E12                 E13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E7EFCF1D-12C5-4E6F-89BD-2D281E05995A}"/>
              </a:ext>
            </a:extLst>
          </p:cNvPr>
          <p:cNvCxnSpPr>
            <a:cxnSpLocks/>
          </p:cNvCxnSpPr>
          <p:nvPr/>
        </p:nvCxnSpPr>
        <p:spPr>
          <a:xfrm>
            <a:off x="1903718" y="1003670"/>
            <a:ext cx="716537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0F060374-D91F-46BC-AF0C-3F44971D346C}"/>
              </a:ext>
            </a:extLst>
          </p:cNvPr>
          <p:cNvCxnSpPr>
            <a:cxnSpLocks/>
          </p:cNvCxnSpPr>
          <p:nvPr/>
        </p:nvCxnSpPr>
        <p:spPr>
          <a:xfrm>
            <a:off x="2752142" y="1003670"/>
            <a:ext cx="790197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9F9D4700-24F7-4EFF-8576-D92BE415F665}"/>
              </a:ext>
            </a:extLst>
          </p:cNvPr>
          <p:cNvCxnSpPr>
            <a:cxnSpLocks/>
          </p:cNvCxnSpPr>
          <p:nvPr/>
        </p:nvCxnSpPr>
        <p:spPr>
          <a:xfrm>
            <a:off x="3688314" y="999451"/>
            <a:ext cx="790197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F57D0CC1-1F61-4D26-9C02-A98ED3E75A54}"/>
              </a:ext>
            </a:extLst>
          </p:cNvPr>
          <p:cNvCxnSpPr>
            <a:cxnSpLocks/>
          </p:cNvCxnSpPr>
          <p:nvPr/>
        </p:nvCxnSpPr>
        <p:spPr>
          <a:xfrm>
            <a:off x="4586065" y="999451"/>
            <a:ext cx="790197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99703DFE-CB1A-4B7A-8965-7412A95F09ED}"/>
              </a:ext>
            </a:extLst>
          </p:cNvPr>
          <p:cNvCxnSpPr>
            <a:cxnSpLocks/>
          </p:cNvCxnSpPr>
          <p:nvPr/>
        </p:nvCxnSpPr>
        <p:spPr>
          <a:xfrm>
            <a:off x="5585302" y="991469"/>
            <a:ext cx="146895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38706210-4B3A-4722-81EF-921C65B20EFB}"/>
              </a:ext>
            </a:extLst>
          </p:cNvPr>
          <p:cNvSpPr txBox="1"/>
          <p:nvPr/>
        </p:nvSpPr>
        <p:spPr>
          <a:xfrm>
            <a:off x="-1280" y="5805541"/>
            <a:ext cx="134598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ctin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42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CA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CB83F9DE-6299-44B3-AA17-CC0B98870FA9}"/>
              </a:ext>
            </a:extLst>
          </p:cNvPr>
          <p:cNvSpPr txBox="1"/>
          <p:nvPr/>
        </p:nvSpPr>
        <p:spPr>
          <a:xfrm>
            <a:off x="0" y="5173091"/>
            <a:ext cx="140071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cam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180KDa</a:t>
            </a:r>
            <a:endParaRPr lang="en-CA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4C72DA1D-455A-460B-8A75-A28038BD00BF}"/>
              </a:ext>
            </a:extLst>
          </p:cNvPr>
          <p:cNvSpPr txBox="1"/>
          <p:nvPr/>
        </p:nvSpPr>
        <p:spPr>
          <a:xfrm>
            <a:off x="995941" y="1498181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CC67B35-9875-4CE4-B399-0774589E8017}"/>
              </a:ext>
            </a:extLst>
          </p:cNvPr>
          <p:cNvSpPr txBox="1"/>
          <p:nvPr/>
        </p:nvSpPr>
        <p:spPr>
          <a:xfrm>
            <a:off x="985221" y="1754283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572970A8-0C23-4E3B-8B29-AFEAD6747F04}"/>
              </a:ext>
            </a:extLst>
          </p:cNvPr>
          <p:cNvSpPr txBox="1"/>
          <p:nvPr/>
        </p:nvSpPr>
        <p:spPr>
          <a:xfrm>
            <a:off x="1006668" y="2078752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CF833AE3-DB6A-4155-AEE2-3479C8A8F40A}"/>
              </a:ext>
            </a:extLst>
          </p:cNvPr>
          <p:cNvSpPr txBox="1"/>
          <p:nvPr/>
        </p:nvSpPr>
        <p:spPr>
          <a:xfrm>
            <a:off x="1062165" y="253274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9C2EC85-E756-4E5C-8578-492788682050}"/>
              </a:ext>
            </a:extLst>
          </p:cNvPr>
          <p:cNvSpPr txBox="1"/>
          <p:nvPr/>
        </p:nvSpPr>
        <p:spPr>
          <a:xfrm>
            <a:off x="1062165" y="3312395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0B8BEF2F-31AF-40A8-B8C8-610EBAF5A5CF}"/>
              </a:ext>
            </a:extLst>
          </p:cNvPr>
          <p:cNvCxnSpPr>
            <a:cxnSpLocks/>
          </p:cNvCxnSpPr>
          <p:nvPr/>
        </p:nvCxnSpPr>
        <p:spPr>
          <a:xfrm flipH="1">
            <a:off x="842559" y="1754283"/>
            <a:ext cx="829657" cy="0"/>
          </a:xfrm>
          <a:prstGeom prst="line">
            <a:avLst/>
          </a:prstGeom>
          <a:ln w="28575"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8D92A3AC-3330-4B9A-A270-AD31469CC708}"/>
              </a:ext>
            </a:extLst>
          </p:cNvPr>
          <p:cNvSpPr txBox="1"/>
          <p:nvPr/>
        </p:nvSpPr>
        <p:spPr>
          <a:xfrm>
            <a:off x="320832" y="1576104"/>
            <a:ext cx="87213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80</a:t>
            </a:r>
            <a:endParaRPr lang="en-CA" sz="14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DE5C7FE-0FD0-4B04-8432-74E650BCD9DF}"/>
              </a:ext>
            </a:extLst>
          </p:cNvPr>
          <p:cNvSpPr txBox="1"/>
          <p:nvPr/>
        </p:nvSpPr>
        <p:spPr>
          <a:xfrm>
            <a:off x="1433199" y="4780105"/>
            <a:ext cx="79169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1     N2    N3         N1      N2     N3        N1    N2    N3     N1    N2     N3           N1    N2   N3   N4                  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CB1870C8-FEC5-4A8E-A764-40F4E44EDF18}"/>
              </a:ext>
            </a:extLst>
          </p:cNvPr>
          <p:cNvSpPr txBox="1"/>
          <p:nvPr/>
        </p:nvSpPr>
        <p:spPr>
          <a:xfrm>
            <a:off x="1848650" y="4390534"/>
            <a:ext cx="709478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E9         E10           E11        E12              E13</a:t>
            </a:r>
          </a:p>
        </p:txBody>
      </p: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84F4A076-F6C0-470D-8827-C01403CC8499}"/>
              </a:ext>
            </a:extLst>
          </p:cNvPr>
          <p:cNvCxnSpPr>
            <a:cxnSpLocks/>
          </p:cNvCxnSpPr>
          <p:nvPr/>
        </p:nvCxnSpPr>
        <p:spPr>
          <a:xfrm>
            <a:off x="1848650" y="4759866"/>
            <a:ext cx="716537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DD5A6A4E-0BEF-4CB8-A0AA-BE0DCF81852E}"/>
              </a:ext>
            </a:extLst>
          </p:cNvPr>
          <p:cNvCxnSpPr>
            <a:cxnSpLocks/>
          </p:cNvCxnSpPr>
          <p:nvPr/>
        </p:nvCxnSpPr>
        <p:spPr>
          <a:xfrm>
            <a:off x="2697074" y="4759866"/>
            <a:ext cx="790197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7C970506-CCAD-43CC-AED2-83FA50EBF037}"/>
              </a:ext>
            </a:extLst>
          </p:cNvPr>
          <p:cNvCxnSpPr>
            <a:cxnSpLocks/>
          </p:cNvCxnSpPr>
          <p:nvPr/>
        </p:nvCxnSpPr>
        <p:spPr>
          <a:xfrm>
            <a:off x="3633246" y="4755647"/>
            <a:ext cx="790197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580A1483-3660-46D8-99AF-9F9F3F23DCC9}"/>
              </a:ext>
            </a:extLst>
          </p:cNvPr>
          <p:cNvCxnSpPr>
            <a:cxnSpLocks/>
          </p:cNvCxnSpPr>
          <p:nvPr/>
        </p:nvCxnSpPr>
        <p:spPr>
          <a:xfrm>
            <a:off x="4530997" y="4755647"/>
            <a:ext cx="790197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42E66836-4F54-4D00-90FD-578828BB821B}"/>
              </a:ext>
            </a:extLst>
          </p:cNvPr>
          <p:cNvCxnSpPr>
            <a:cxnSpLocks/>
          </p:cNvCxnSpPr>
          <p:nvPr/>
        </p:nvCxnSpPr>
        <p:spPr>
          <a:xfrm>
            <a:off x="5574582" y="4755647"/>
            <a:ext cx="1052721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8" name="Picture 7">
            <a:extLst>
              <a:ext uri="{FF2B5EF4-FFF2-40B4-BE49-F238E27FC236}">
                <a16:creationId xmlns:a16="http://schemas.microsoft.com/office/drawing/2014/main" id="{8D3219DB-DE5C-4870-AB24-4171B4EE78F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608406" y="1309582"/>
            <a:ext cx="1606371" cy="2059025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732AE585-32ED-4766-A6E8-EA10A002C2B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616528" y="5704724"/>
            <a:ext cx="1828571" cy="698586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BC63C122-839B-4C02-8AC6-F05FDB8D39F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606613" y="3374650"/>
            <a:ext cx="1606371" cy="105493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6D8EAB7E-BDF2-4878-A19D-E37F76FB4E1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606613" y="5085934"/>
            <a:ext cx="1838486" cy="394934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D16134F5-A6D9-40D8-BA50-C403217EF44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606613" y="5041266"/>
            <a:ext cx="1838486" cy="475529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343B5360-08AD-4126-9BEF-39D02ACD662E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615699" y="5699960"/>
            <a:ext cx="1838486" cy="6985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8824033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8</TotalTime>
  <Words>512</Words>
  <Application>Microsoft Office PowerPoint</Application>
  <PresentationFormat>Widescreen</PresentationFormat>
  <Paragraphs>99</Paragraphs>
  <Slides>8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1_Office Theme</vt:lpstr>
      <vt:lpstr>Smad 2/3  E9-E13    1 to 1000   7sec </vt:lpstr>
      <vt:lpstr>P-Smad2 &amp; P-Smad3/ Only E12-E13</vt:lpstr>
      <vt:lpstr>Bcatenin E9-E13   1 to 2000 0.7sec</vt:lpstr>
      <vt:lpstr>CDH8 E9-E13    1 to 1000   10sec  </vt:lpstr>
      <vt:lpstr>LC3 I/II     1 to 3000     2 Sec</vt:lpstr>
      <vt:lpstr>P62    1 to 3000     60Sec</vt:lpstr>
      <vt:lpstr>N-cadherin (CDH2)  1 to 500    5Sec  </vt:lpstr>
      <vt:lpstr>Ncam E9-E13    1 to 500   10sec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Ncam E9-E13    1 to 500   10sec</dc:title>
  <dc:creator>Azadeh Dalvand</dc:creator>
  <cp:lastModifiedBy>Saeid Ghavami</cp:lastModifiedBy>
  <cp:revision>5</cp:revision>
  <dcterms:created xsi:type="dcterms:W3CDTF">2021-03-21T20:14:39Z</dcterms:created>
  <dcterms:modified xsi:type="dcterms:W3CDTF">2022-08-23T11:17:32Z</dcterms:modified>
</cp:coreProperties>
</file>